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AB718F-6E76-41EB-BB7D-65A772996CFA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0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AFB413D-4F89-4857-945A-65E6F1A4C6C5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2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Response to both isolates display induction of genes involved in SA signaling and biosynthesis pathway and repression of genes involved in JA/Ethylene signaling pathwa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However, eH-response could display a stronger induction of SA-related genes. On the opposite, e2-response display a specific induction of genes involved in JA biosynthesi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It should b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855F49-80F8-4959-B06B-6DB7AD3978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2B7C92-ED2E-4E2D-8C50-B1EB6ABA44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7AF785-7328-4F7E-97A7-A219F70336B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0BB217-BC12-4B80-8781-E4A0AA35FCB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AC7469-0DE2-453F-A7C4-55D25E9A87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EDEF8-3DB2-4262-853C-DDE8353AB6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03ECDB-1C82-4D72-9AE1-A71C00C856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9B49AF-D50C-4040-8257-9B20B175BC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96C81D-6AD5-4C53-A019-14FAD30EAD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6687DC-1300-4EF1-A4CD-F15F85D15B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98BFA5-314E-4D95-95AB-A7B5C6CF96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9F9E02-9673-4219-A7FB-4E90568055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3C0CDF-390B-4E7C-85F0-5A296DF145DF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110"/>
          <p:cNvSpPr/>
          <p:nvPr/>
        </p:nvSpPr>
        <p:spPr>
          <a:xfrm>
            <a:off x="200160" y="5477040"/>
            <a:ext cx="8743680" cy="84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. S3 - Schematic representation of transcriptional regulations of genes involved in jasmonic acid and salicylic acid signalling pathways: contrasted responses at 7 dpi between plants from the Bur-0 ecotype infected with eH or e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isolates.  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Adapted from Zarate 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et al.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Plant Physiology 2007, Brownfield 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et al.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2008 and available data from the NASCArray website (references 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NASCARRAYS-52, NASCARRAYS-454 and NASCARRAYS-174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6"/>
          <p:cNvGrpSpPr/>
          <p:nvPr/>
        </p:nvGrpSpPr>
        <p:grpSpPr>
          <a:xfrm>
            <a:off x="684360" y="44280"/>
            <a:ext cx="7848000" cy="5452920"/>
            <a:chOff x="684360" y="44280"/>
            <a:chExt cx="7848000" cy="5452920"/>
          </a:xfrm>
        </p:grpSpPr>
        <p:sp>
          <p:nvSpPr>
            <p:cNvPr id="50" name="Rectangle 7"/>
            <p:cNvSpPr/>
            <p:nvPr/>
          </p:nvSpPr>
          <p:spPr>
            <a:xfrm>
              <a:off x="6614280" y="130320"/>
              <a:ext cx="146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8"/>
            <p:cNvSpPr/>
            <p:nvPr/>
          </p:nvSpPr>
          <p:spPr>
            <a:xfrm>
              <a:off x="6784920" y="15840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–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9"/>
            <p:cNvSpPr/>
            <p:nvPr/>
          </p:nvSpPr>
          <p:spPr>
            <a:xfrm>
              <a:off x="6873480" y="130320"/>
              <a:ext cx="386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specifi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10"/>
            <p:cNvSpPr/>
            <p:nvPr/>
          </p:nvSpPr>
          <p:spPr>
            <a:xfrm>
              <a:off x="7309080" y="130320"/>
              <a:ext cx="1350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or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11"/>
            <p:cNvSpPr/>
            <p:nvPr/>
          </p:nvSpPr>
          <p:spPr>
            <a:xfrm>
              <a:off x="7437960" y="130320"/>
              <a:ext cx="506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nhance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12"/>
            <p:cNvSpPr/>
            <p:nvPr/>
          </p:nvSpPr>
          <p:spPr>
            <a:xfrm>
              <a:off x="7979760" y="130320"/>
              <a:ext cx="46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induction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13"/>
            <p:cNvSpPr/>
            <p:nvPr/>
          </p:nvSpPr>
          <p:spPr>
            <a:xfrm>
              <a:off x="6612120" y="311760"/>
              <a:ext cx="410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Induce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14"/>
            <p:cNvSpPr/>
            <p:nvPr/>
          </p:nvSpPr>
          <p:spPr>
            <a:xfrm>
              <a:off x="7077600" y="311760"/>
              <a:ext cx="15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by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15"/>
            <p:cNvSpPr/>
            <p:nvPr/>
          </p:nvSpPr>
          <p:spPr>
            <a:xfrm>
              <a:off x="7228080" y="31176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bot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16"/>
            <p:cNvSpPr/>
            <p:nvPr/>
          </p:nvSpPr>
          <p:spPr>
            <a:xfrm>
              <a:off x="7463520" y="311760"/>
              <a:ext cx="357480" cy="15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r>
                <a:rPr b="0" lang="en-US" sz="9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and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17"/>
            <p:cNvSpPr/>
            <p:nvPr/>
          </p:nvSpPr>
          <p:spPr>
            <a:xfrm>
              <a:off x="7865280" y="311760"/>
              <a:ext cx="146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18"/>
            <p:cNvSpPr/>
            <p:nvPr/>
          </p:nvSpPr>
          <p:spPr>
            <a:xfrm>
              <a:off x="6611400" y="520200"/>
              <a:ext cx="556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Represse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19"/>
            <p:cNvSpPr/>
            <p:nvPr/>
          </p:nvSpPr>
          <p:spPr>
            <a:xfrm>
              <a:off x="7218720" y="520200"/>
              <a:ext cx="15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by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20"/>
            <p:cNvSpPr/>
            <p:nvPr/>
          </p:nvSpPr>
          <p:spPr>
            <a:xfrm>
              <a:off x="7361280" y="52020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bot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21"/>
            <p:cNvSpPr/>
            <p:nvPr/>
          </p:nvSpPr>
          <p:spPr>
            <a:xfrm>
              <a:off x="7605720" y="520200"/>
              <a:ext cx="357480" cy="15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r>
                <a:rPr b="0" lang="en-US" sz="9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and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22"/>
            <p:cNvSpPr/>
            <p:nvPr/>
          </p:nvSpPr>
          <p:spPr>
            <a:xfrm>
              <a:off x="8006400" y="520200"/>
              <a:ext cx="146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23"/>
            <p:cNvSpPr/>
            <p:nvPr/>
          </p:nvSpPr>
          <p:spPr>
            <a:xfrm>
              <a:off x="1998000" y="1195200"/>
              <a:ext cx="939240" cy="2642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24"/>
            <p:cNvSpPr/>
            <p:nvPr/>
          </p:nvSpPr>
          <p:spPr>
            <a:xfrm>
              <a:off x="2315160" y="1247040"/>
              <a:ext cx="399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AD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25"/>
            <p:cNvSpPr/>
            <p:nvPr/>
          </p:nvSpPr>
          <p:spPr>
            <a:xfrm>
              <a:off x="1998000" y="1494000"/>
              <a:ext cx="939240" cy="264600"/>
            </a:xfrm>
            <a:prstGeom prst="rect">
              <a:avLst/>
            </a:prstGeom>
            <a:solidFill>
              <a:srgbClr val="ff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26"/>
            <p:cNvSpPr/>
            <p:nvPr/>
          </p:nvSpPr>
          <p:spPr>
            <a:xfrm>
              <a:off x="2315160" y="1544760"/>
              <a:ext cx="399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EDS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27"/>
            <p:cNvSpPr/>
            <p:nvPr/>
          </p:nvSpPr>
          <p:spPr>
            <a:xfrm>
              <a:off x="1998000" y="2134800"/>
              <a:ext cx="939240" cy="2642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28"/>
            <p:cNvSpPr/>
            <p:nvPr/>
          </p:nvSpPr>
          <p:spPr>
            <a:xfrm>
              <a:off x="2343600" y="2184840"/>
              <a:ext cx="3405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ICS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29"/>
            <p:cNvSpPr/>
            <p:nvPr/>
          </p:nvSpPr>
          <p:spPr>
            <a:xfrm>
              <a:off x="2315160" y="2498040"/>
              <a:ext cx="399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EDS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30"/>
            <p:cNvSpPr/>
            <p:nvPr/>
          </p:nvSpPr>
          <p:spPr>
            <a:xfrm>
              <a:off x="2377440" y="3000960"/>
              <a:ext cx="20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31"/>
            <p:cNvSpPr/>
            <p:nvPr/>
          </p:nvSpPr>
          <p:spPr>
            <a:xfrm>
              <a:off x="1560240" y="3438000"/>
              <a:ext cx="407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PR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32"/>
            <p:cNvSpPr/>
            <p:nvPr/>
          </p:nvSpPr>
          <p:spPr>
            <a:xfrm>
              <a:off x="997200" y="3890520"/>
              <a:ext cx="939240" cy="264600"/>
            </a:xfrm>
            <a:prstGeom prst="rect">
              <a:avLst/>
            </a:prstGeom>
            <a:solidFill>
              <a:srgbClr val="ff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33"/>
            <p:cNvSpPr/>
            <p:nvPr/>
          </p:nvSpPr>
          <p:spPr>
            <a:xfrm>
              <a:off x="1257840" y="3940560"/>
              <a:ext cx="52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RK7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34"/>
            <p:cNvSpPr/>
            <p:nvPr/>
          </p:nvSpPr>
          <p:spPr>
            <a:xfrm>
              <a:off x="1563120" y="4442040"/>
              <a:ext cx="399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GA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35"/>
            <p:cNvSpPr/>
            <p:nvPr/>
          </p:nvSpPr>
          <p:spPr>
            <a:xfrm>
              <a:off x="2425680" y="4607640"/>
              <a:ext cx="2980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R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36"/>
            <p:cNvSpPr/>
            <p:nvPr/>
          </p:nvSpPr>
          <p:spPr>
            <a:xfrm>
              <a:off x="2062440" y="4794120"/>
              <a:ext cx="939240" cy="2642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37"/>
            <p:cNvSpPr/>
            <p:nvPr/>
          </p:nvSpPr>
          <p:spPr>
            <a:xfrm>
              <a:off x="2425680" y="4844160"/>
              <a:ext cx="2980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R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38"/>
            <p:cNvSpPr/>
            <p:nvPr/>
          </p:nvSpPr>
          <p:spPr>
            <a:xfrm>
              <a:off x="2062440" y="5044680"/>
              <a:ext cx="939240" cy="2660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39"/>
            <p:cNvSpPr/>
            <p:nvPr/>
          </p:nvSpPr>
          <p:spPr>
            <a:xfrm>
              <a:off x="2383920" y="5096520"/>
              <a:ext cx="392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BGL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40"/>
            <p:cNvSpPr/>
            <p:nvPr/>
          </p:nvSpPr>
          <p:spPr>
            <a:xfrm>
              <a:off x="4567680" y="1195200"/>
              <a:ext cx="939240" cy="2642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41"/>
            <p:cNvSpPr/>
            <p:nvPr/>
          </p:nvSpPr>
          <p:spPr>
            <a:xfrm>
              <a:off x="4883040" y="1247040"/>
              <a:ext cx="399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EV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42"/>
            <p:cNvSpPr/>
            <p:nvPr/>
          </p:nvSpPr>
          <p:spPr>
            <a:xfrm>
              <a:off x="4794480" y="1683720"/>
              <a:ext cx="195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E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6" name="Group 45"/>
            <p:cNvGrpSpPr/>
            <p:nvPr/>
          </p:nvGrpSpPr>
          <p:grpSpPr>
            <a:xfrm>
              <a:off x="5195520" y="1633680"/>
              <a:ext cx="938880" cy="272160"/>
              <a:chOff x="5195520" y="1633680"/>
              <a:chExt cx="938880" cy="272160"/>
            </a:xfrm>
          </p:grpSpPr>
          <p:sp>
            <p:nvSpPr>
              <p:cNvPr id="87" name="Rectangle 43"/>
              <p:cNvSpPr/>
              <p:nvPr/>
            </p:nvSpPr>
            <p:spPr>
              <a:xfrm>
                <a:off x="5195520" y="1633680"/>
                <a:ext cx="938880" cy="27216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Rectangle 44"/>
              <p:cNvSpPr/>
              <p:nvPr/>
            </p:nvSpPr>
            <p:spPr>
              <a:xfrm>
                <a:off x="5195520" y="1633680"/>
                <a:ext cx="938880" cy="272160"/>
              </a:xfrm>
              <a:prstGeom prst="rect">
                <a:avLst/>
              </a:prstGeom>
              <a:noFill/>
              <a:ln cap="rnd"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9" name="Rectangle 46"/>
            <p:cNvSpPr/>
            <p:nvPr/>
          </p:nvSpPr>
          <p:spPr>
            <a:xfrm>
              <a:off x="5434200" y="1688400"/>
              <a:ext cx="561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FAD 3/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47"/>
            <p:cNvSpPr/>
            <p:nvPr/>
          </p:nvSpPr>
          <p:spPr>
            <a:xfrm>
              <a:off x="4396320" y="2249280"/>
              <a:ext cx="832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ETR1/ERS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48"/>
            <p:cNvSpPr/>
            <p:nvPr/>
          </p:nvSpPr>
          <p:spPr>
            <a:xfrm>
              <a:off x="5739120" y="2249280"/>
              <a:ext cx="178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J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49"/>
            <p:cNvSpPr/>
            <p:nvPr/>
          </p:nvSpPr>
          <p:spPr>
            <a:xfrm>
              <a:off x="4665600" y="2748960"/>
              <a:ext cx="398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TR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50"/>
            <p:cNvSpPr/>
            <p:nvPr/>
          </p:nvSpPr>
          <p:spPr>
            <a:xfrm>
              <a:off x="5814720" y="2812680"/>
              <a:ext cx="357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OI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51"/>
            <p:cNvSpPr/>
            <p:nvPr/>
          </p:nvSpPr>
          <p:spPr>
            <a:xfrm>
              <a:off x="6072480" y="3137040"/>
              <a:ext cx="563760" cy="2660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52"/>
            <p:cNvSpPr/>
            <p:nvPr/>
          </p:nvSpPr>
          <p:spPr>
            <a:xfrm>
              <a:off x="6213960" y="3187080"/>
              <a:ext cx="374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JAR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53"/>
            <p:cNvSpPr/>
            <p:nvPr/>
          </p:nvSpPr>
          <p:spPr>
            <a:xfrm>
              <a:off x="4817880" y="3187080"/>
              <a:ext cx="3405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EIN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54"/>
            <p:cNvSpPr/>
            <p:nvPr/>
          </p:nvSpPr>
          <p:spPr>
            <a:xfrm>
              <a:off x="4692600" y="3564720"/>
              <a:ext cx="3405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EIN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55"/>
            <p:cNvSpPr/>
            <p:nvPr/>
          </p:nvSpPr>
          <p:spPr>
            <a:xfrm>
              <a:off x="5295960" y="3627000"/>
              <a:ext cx="390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ERF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56"/>
            <p:cNvSpPr/>
            <p:nvPr/>
          </p:nvSpPr>
          <p:spPr>
            <a:xfrm>
              <a:off x="6033600" y="3627000"/>
              <a:ext cx="425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hi2.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57"/>
            <p:cNvSpPr/>
            <p:nvPr/>
          </p:nvSpPr>
          <p:spPr>
            <a:xfrm>
              <a:off x="5300280" y="4129920"/>
              <a:ext cx="518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DF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58"/>
            <p:cNvSpPr/>
            <p:nvPr/>
          </p:nvSpPr>
          <p:spPr>
            <a:xfrm>
              <a:off x="6233760" y="3940560"/>
              <a:ext cx="392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VSP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Freeform 59"/>
            <p:cNvSpPr/>
            <p:nvPr/>
          </p:nvSpPr>
          <p:spPr>
            <a:xfrm>
              <a:off x="4882320" y="1439640"/>
              <a:ext cx="131040" cy="194040"/>
            </a:xfrm>
            <a:custGeom>
              <a:avLst/>
              <a:gdLst>
                <a:gd name="textAreaLeft" fmla="*/ 0 w 131040"/>
                <a:gd name="textAreaRight" fmla="*/ 131400 w 131040"/>
                <a:gd name="textAreaTop" fmla="*/ 0 h 194040"/>
                <a:gd name="textAreaBottom" fmla="*/ 194400 h 194040"/>
              </a:gdLst>
              <a:ahLst/>
              <a:rect l="textAreaLeft" t="textAreaTop" r="textAreaRight" b="textAreaBottom"/>
              <a:pathLst>
                <a:path w="796" h="1171">
                  <a:moveTo>
                    <a:pt x="786" y="56"/>
                  </a:moveTo>
                  <a:lnTo>
                    <a:pt x="213" y="912"/>
                  </a:lnTo>
                  <a:cubicBezTo>
                    <a:pt x="203" y="928"/>
                    <a:pt x="182" y="932"/>
                    <a:pt x="167" y="921"/>
                  </a:cubicBezTo>
                  <a:cubicBezTo>
                    <a:pt x="152" y="911"/>
                    <a:pt x="148" y="891"/>
                    <a:pt x="158" y="875"/>
                  </a:cubicBezTo>
                  <a:lnTo>
                    <a:pt x="731" y="19"/>
                  </a:lnTo>
                  <a:cubicBezTo>
                    <a:pt x="741" y="4"/>
                    <a:pt x="762" y="0"/>
                    <a:pt x="777" y="10"/>
                  </a:cubicBezTo>
                  <a:cubicBezTo>
                    <a:pt x="792" y="20"/>
                    <a:pt x="796" y="41"/>
                    <a:pt x="786" y="56"/>
                  </a:cubicBezTo>
                  <a:close/>
                  <a:moveTo>
                    <a:pt x="389" y="950"/>
                  </a:moveTo>
                  <a:lnTo>
                    <a:pt x="0" y="1171"/>
                  </a:lnTo>
                  <a:lnTo>
                    <a:pt x="56" y="727"/>
                  </a:lnTo>
                  <a:lnTo>
                    <a:pt x="389" y="950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Freeform 60"/>
            <p:cNvSpPr/>
            <p:nvPr/>
          </p:nvSpPr>
          <p:spPr>
            <a:xfrm>
              <a:off x="5189400" y="1439640"/>
              <a:ext cx="256680" cy="194040"/>
            </a:xfrm>
            <a:custGeom>
              <a:avLst/>
              <a:gdLst>
                <a:gd name="textAreaLeft" fmla="*/ 0 w 256680"/>
                <a:gd name="textAreaRight" fmla="*/ 257040 w 256680"/>
                <a:gd name="textAreaTop" fmla="*/ 0 h 194040"/>
                <a:gd name="textAreaBottom" fmla="*/ 194400 h 194040"/>
              </a:gdLst>
              <a:ahLst/>
              <a:rect l="textAreaLeft" t="textAreaTop" r="textAreaRight" b="textAreaBottom"/>
              <a:pathLst>
                <a:path w="1546" h="1171">
                  <a:moveTo>
                    <a:pt x="58" y="11"/>
                  </a:moveTo>
                  <a:lnTo>
                    <a:pt x="1300" y="944"/>
                  </a:lnTo>
                  <a:cubicBezTo>
                    <a:pt x="1314" y="955"/>
                    <a:pt x="1317" y="976"/>
                    <a:pt x="1306" y="991"/>
                  </a:cubicBezTo>
                  <a:cubicBezTo>
                    <a:pt x="1295" y="1005"/>
                    <a:pt x="1274" y="1008"/>
                    <a:pt x="1260" y="997"/>
                  </a:cubicBezTo>
                  <a:lnTo>
                    <a:pt x="18" y="64"/>
                  </a:lnTo>
                  <a:cubicBezTo>
                    <a:pt x="3" y="53"/>
                    <a:pt x="0" y="32"/>
                    <a:pt x="11" y="17"/>
                  </a:cubicBezTo>
                  <a:cubicBezTo>
                    <a:pt x="22" y="3"/>
                    <a:pt x="43" y="0"/>
                    <a:pt x="58" y="11"/>
                  </a:cubicBezTo>
                  <a:close/>
                  <a:moveTo>
                    <a:pt x="1346" y="771"/>
                  </a:moveTo>
                  <a:lnTo>
                    <a:pt x="1546" y="1171"/>
                  </a:lnTo>
                  <a:lnTo>
                    <a:pt x="1106" y="1090"/>
                  </a:lnTo>
                  <a:lnTo>
                    <a:pt x="1346" y="771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61"/>
            <p:cNvSpPr/>
            <p:nvPr/>
          </p:nvSpPr>
          <p:spPr>
            <a:xfrm>
              <a:off x="5690520" y="1920240"/>
              <a:ext cx="82800" cy="255240"/>
            </a:xfrm>
            <a:custGeom>
              <a:avLst/>
              <a:gdLst>
                <a:gd name="textAreaLeft" fmla="*/ 0 w 82800"/>
                <a:gd name="textAreaRight" fmla="*/ 83160 w 82800"/>
                <a:gd name="textAreaTop" fmla="*/ 0 h 255240"/>
                <a:gd name="textAreaBottom" fmla="*/ 255600 h 255240"/>
              </a:gdLst>
              <a:ahLst/>
              <a:rect l="textAreaLeft" t="textAreaTop" r="textAreaRight" b="textAreaBottom"/>
              <a:pathLst>
                <a:path w="509" h="1545">
                  <a:moveTo>
                    <a:pt x="69" y="28"/>
                  </a:moveTo>
                  <a:lnTo>
                    <a:pt x="363" y="1213"/>
                  </a:lnTo>
                  <a:cubicBezTo>
                    <a:pt x="368" y="1231"/>
                    <a:pt x="357" y="1249"/>
                    <a:pt x="339" y="1254"/>
                  </a:cubicBezTo>
                  <a:cubicBezTo>
                    <a:pt x="321" y="1258"/>
                    <a:pt x="303" y="1247"/>
                    <a:pt x="299" y="1229"/>
                  </a:cubicBezTo>
                  <a:lnTo>
                    <a:pt x="4" y="45"/>
                  </a:lnTo>
                  <a:cubicBezTo>
                    <a:pt x="0" y="27"/>
                    <a:pt x="11" y="9"/>
                    <a:pt x="28" y="4"/>
                  </a:cubicBezTo>
                  <a:cubicBezTo>
                    <a:pt x="46" y="0"/>
                    <a:pt x="64" y="11"/>
                    <a:pt x="69" y="28"/>
                  </a:cubicBezTo>
                  <a:close/>
                  <a:moveTo>
                    <a:pt x="509" y="1108"/>
                  </a:moveTo>
                  <a:lnTo>
                    <a:pt x="411" y="1545"/>
                  </a:lnTo>
                  <a:lnTo>
                    <a:pt x="121" y="1205"/>
                  </a:lnTo>
                  <a:lnTo>
                    <a:pt x="509" y="1108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Freeform 62"/>
            <p:cNvSpPr/>
            <p:nvPr/>
          </p:nvSpPr>
          <p:spPr>
            <a:xfrm>
              <a:off x="4849560" y="1879560"/>
              <a:ext cx="65520" cy="255240"/>
            </a:xfrm>
            <a:custGeom>
              <a:avLst/>
              <a:gdLst>
                <a:gd name="textAreaLeft" fmla="*/ 0 w 65520"/>
                <a:gd name="textAreaRight" fmla="*/ 65880 w 65520"/>
                <a:gd name="textAreaTop" fmla="*/ 0 h 255240"/>
                <a:gd name="textAreaBottom" fmla="*/ 255600 h 255240"/>
              </a:gdLst>
              <a:ahLst/>
              <a:rect l="textAreaLeft" t="textAreaTop" r="textAreaRight" b="textAreaBottom"/>
              <a:pathLst>
                <a:path w="400" h="1542">
                  <a:moveTo>
                    <a:pt x="233" y="33"/>
                  </a:moveTo>
                  <a:lnTo>
                    <a:pt x="233" y="1208"/>
                  </a:lnTo>
                  <a:cubicBezTo>
                    <a:pt x="233" y="1227"/>
                    <a:pt x="219" y="1242"/>
                    <a:pt x="200" y="1242"/>
                  </a:cubicBezTo>
                  <a:cubicBezTo>
                    <a:pt x="182" y="1242"/>
                    <a:pt x="167" y="1227"/>
                    <a:pt x="167" y="1208"/>
                  </a:cubicBezTo>
                  <a:lnTo>
                    <a:pt x="167" y="33"/>
                  </a:lnTo>
                  <a:cubicBezTo>
                    <a:pt x="167" y="15"/>
                    <a:pt x="182" y="0"/>
                    <a:pt x="200" y="0"/>
                  </a:cubicBezTo>
                  <a:cubicBezTo>
                    <a:pt x="219" y="0"/>
                    <a:pt x="233" y="15"/>
                    <a:pt x="233" y="33"/>
                  </a:cubicBezTo>
                  <a:close/>
                  <a:moveTo>
                    <a:pt x="400" y="1142"/>
                  </a:moveTo>
                  <a:lnTo>
                    <a:pt x="200" y="1542"/>
                  </a:lnTo>
                  <a:lnTo>
                    <a:pt x="0" y="1142"/>
                  </a:lnTo>
                  <a:lnTo>
                    <a:pt x="400" y="1142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Freeform 63"/>
            <p:cNvSpPr/>
            <p:nvPr/>
          </p:nvSpPr>
          <p:spPr>
            <a:xfrm>
              <a:off x="5789160" y="2504520"/>
              <a:ext cx="65520" cy="255240"/>
            </a:xfrm>
            <a:custGeom>
              <a:avLst/>
              <a:gdLst>
                <a:gd name="textAreaLeft" fmla="*/ 0 w 65520"/>
                <a:gd name="textAreaRight" fmla="*/ 65880 w 65520"/>
                <a:gd name="textAreaTop" fmla="*/ 0 h 255240"/>
                <a:gd name="textAreaBottom" fmla="*/ 255600 h 255240"/>
              </a:gdLst>
              <a:ahLst/>
              <a:rect l="textAreaLeft" t="textAreaTop" r="textAreaRight" b="textAreaBottom"/>
              <a:pathLst>
                <a:path w="400" h="1542">
                  <a:moveTo>
                    <a:pt x="233" y="33"/>
                  </a:moveTo>
                  <a:lnTo>
                    <a:pt x="233" y="1208"/>
                  </a:lnTo>
                  <a:cubicBezTo>
                    <a:pt x="233" y="1227"/>
                    <a:pt x="218" y="1242"/>
                    <a:pt x="200" y="1242"/>
                  </a:cubicBezTo>
                  <a:cubicBezTo>
                    <a:pt x="181" y="1242"/>
                    <a:pt x="166" y="1227"/>
                    <a:pt x="166" y="1208"/>
                  </a:cubicBezTo>
                  <a:lnTo>
                    <a:pt x="166" y="33"/>
                  </a:lnTo>
                  <a:cubicBezTo>
                    <a:pt x="166" y="15"/>
                    <a:pt x="181" y="0"/>
                    <a:pt x="200" y="0"/>
                  </a:cubicBezTo>
                  <a:cubicBezTo>
                    <a:pt x="218" y="0"/>
                    <a:pt x="233" y="15"/>
                    <a:pt x="233" y="33"/>
                  </a:cubicBezTo>
                  <a:close/>
                  <a:moveTo>
                    <a:pt x="400" y="1142"/>
                  </a:moveTo>
                  <a:lnTo>
                    <a:pt x="200" y="1542"/>
                  </a:lnTo>
                  <a:lnTo>
                    <a:pt x="0" y="1142"/>
                  </a:lnTo>
                  <a:lnTo>
                    <a:pt x="400" y="1142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64"/>
            <p:cNvSpPr/>
            <p:nvPr/>
          </p:nvSpPr>
          <p:spPr>
            <a:xfrm>
              <a:off x="4819680" y="2448000"/>
              <a:ext cx="1440" cy="187560"/>
            </a:xfrm>
            <a:prstGeom prst="line">
              <a:avLst/>
            </a:prstGeom>
            <a:ln cap="rnd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65"/>
            <p:cNvSpPr/>
            <p:nvPr/>
          </p:nvSpPr>
          <p:spPr>
            <a:xfrm>
              <a:off x="4757040" y="2635920"/>
              <a:ext cx="125280" cy="1440"/>
            </a:xfrm>
            <a:prstGeom prst="line">
              <a:avLst/>
            </a:prstGeom>
            <a:ln cap="rnd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66"/>
            <p:cNvSpPr/>
            <p:nvPr/>
          </p:nvSpPr>
          <p:spPr>
            <a:xfrm>
              <a:off x="4819680" y="2448000"/>
              <a:ext cx="1440" cy="187560"/>
            </a:xfrm>
            <a:prstGeom prst="line">
              <a:avLst/>
            </a:prstGeom>
            <a:ln cap="rnd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67"/>
            <p:cNvSpPr/>
            <p:nvPr/>
          </p:nvSpPr>
          <p:spPr>
            <a:xfrm>
              <a:off x="4757040" y="2635920"/>
              <a:ext cx="125280" cy="1440"/>
            </a:xfrm>
            <a:prstGeom prst="line">
              <a:avLst/>
            </a:prstGeom>
            <a:ln cap="rnd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68"/>
            <p:cNvSpPr/>
            <p:nvPr/>
          </p:nvSpPr>
          <p:spPr>
            <a:xfrm>
              <a:off x="4883760" y="2949120"/>
              <a:ext cx="1080" cy="187560"/>
            </a:xfrm>
            <a:prstGeom prst="line">
              <a:avLst/>
            </a:prstGeom>
            <a:ln cap="rnd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69"/>
            <p:cNvSpPr/>
            <p:nvPr/>
          </p:nvSpPr>
          <p:spPr>
            <a:xfrm>
              <a:off x="4819680" y="3137040"/>
              <a:ext cx="125280" cy="1440"/>
            </a:xfrm>
            <a:prstGeom prst="line">
              <a:avLst/>
            </a:prstGeom>
            <a:ln cap="rnd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70"/>
            <p:cNvSpPr/>
            <p:nvPr/>
          </p:nvSpPr>
          <p:spPr>
            <a:xfrm>
              <a:off x="4883760" y="2949120"/>
              <a:ext cx="1080" cy="187560"/>
            </a:xfrm>
            <a:prstGeom prst="line">
              <a:avLst/>
            </a:prstGeom>
            <a:ln cap="rnd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71"/>
            <p:cNvSpPr/>
            <p:nvPr/>
          </p:nvSpPr>
          <p:spPr>
            <a:xfrm>
              <a:off x="4819680" y="3137040"/>
              <a:ext cx="125280" cy="1440"/>
            </a:xfrm>
            <a:prstGeom prst="line">
              <a:avLst/>
            </a:prstGeom>
            <a:ln cap="rnd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Freeform 72"/>
            <p:cNvSpPr/>
            <p:nvPr/>
          </p:nvSpPr>
          <p:spPr>
            <a:xfrm>
              <a:off x="5124960" y="3381480"/>
              <a:ext cx="258480" cy="195480"/>
            </a:xfrm>
            <a:custGeom>
              <a:avLst/>
              <a:gdLst>
                <a:gd name="textAreaLeft" fmla="*/ 0 w 258480"/>
                <a:gd name="textAreaRight" fmla="*/ 258840 w 258480"/>
                <a:gd name="textAreaTop" fmla="*/ 0 h 195480"/>
                <a:gd name="textAreaBottom" fmla="*/ 195840 h 195480"/>
              </a:gdLst>
              <a:ahLst/>
              <a:rect l="textAreaLeft" t="textAreaTop" r="textAreaRight" b="textAreaBottom"/>
              <a:pathLst>
                <a:path w="1554" h="1180">
                  <a:moveTo>
                    <a:pt x="58" y="12"/>
                  </a:moveTo>
                  <a:lnTo>
                    <a:pt x="1308" y="953"/>
                  </a:lnTo>
                  <a:cubicBezTo>
                    <a:pt x="1323" y="964"/>
                    <a:pt x="1326" y="985"/>
                    <a:pt x="1314" y="999"/>
                  </a:cubicBezTo>
                  <a:cubicBezTo>
                    <a:pt x="1303" y="1014"/>
                    <a:pt x="1282" y="1017"/>
                    <a:pt x="1268" y="1006"/>
                  </a:cubicBezTo>
                  <a:lnTo>
                    <a:pt x="17" y="65"/>
                  </a:lnTo>
                  <a:cubicBezTo>
                    <a:pt x="3" y="54"/>
                    <a:pt x="0" y="33"/>
                    <a:pt x="11" y="18"/>
                  </a:cubicBezTo>
                  <a:cubicBezTo>
                    <a:pt x="22" y="3"/>
                    <a:pt x="43" y="0"/>
                    <a:pt x="58" y="12"/>
                  </a:cubicBezTo>
                  <a:close/>
                  <a:moveTo>
                    <a:pt x="1355" y="779"/>
                  </a:moveTo>
                  <a:lnTo>
                    <a:pt x="1554" y="1180"/>
                  </a:lnTo>
                  <a:lnTo>
                    <a:pt x="1114" y="1099"/>
                  </a:lnTo>
                  <a:lnTo>
                    <a:pt x="1355" y="779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Freeform 73"/>
            <p:cNvSpPr/>
            <p:nvPr/>
          </p:nvSpPr>
          <p:spPr>
            <a:xfrm>
              <a:off x="5571360" y="3070080"/>
              <a:ext cx="318960" cy="506880"/>
            </a:xfrm>
            <a:custGeom>
              <a:avLst/>
              <a:gdLst>
                <a:gd name="textAreaLeft" fmla="*/ 0 w 318960"/>
                <a:gd name="textAreaRight" fmla="*/ 319320 w 318960"/>
                <a:gd name="textAreaTop" fmla="*/ 0 h 506880"/>
                <a:gd name="textAreaBottom" fmla="*/ 507240 h 506880"/>
              </a:gdLst>
              <a:ahLst/>
              <a:rect l="textAreaLeft" t="textAreaTop" r="textAreaRight" b="textAreaBottom"/>
              <a:pathLst>
                <a:path w="1930" h="3063">
                  <a:moveTo>
                    <a:pt x="1920" y="55"/>
                  </a:moveTo>
                  <a:lnTo>
                    <a:pt x="205" y="2798"/>
                  </a:lnTo>
                  <a:cubicBezTo>
                    <a:pt x="196" y="2813"/>
                    <a:pt x="175" y="2818"/>
                    <a:pt x="160" y="2808"/>
                  </a:cubicBezTo>
                  <a:cubicBezTo>
                    <a:pt x="144" y="2799"/>
                    <a:pt x="139" y="2778"/>
                    <a:pt x="149" y="2763"/>
                  </a:cubicBezTo>
                  <a:lnTo>
                    <a:pt x="1864" y="20"/>
                  </a:lnTo>
                  <a:cubicBezTo>
                    <a:pt x="1874" y="5"/>
                    <a:pt x="1894" y="0"/>
                    <a:pt x="1910" y="10"/>
                  </a:cubicBezTo>
                  <a:cubicBezTo>
                    <a:pt x="1925" y="19"/>
                    <a:pt x="1930" y="40"/>
                    <a:pt x="1920" y="55"/>
                  </a:cubicBezTo>
                  <a:close/>
                  <a:moveTo>
                    <a:pt x="382" y="2830"/>
                  </a:moveTo>
                  <a:lnTo>
                    <a:pt x="0" y="3063"/>
                  </a:lnTo>
                  <a:lnTo>
                    <a:pt x="43" y="2618"/>
                  </a:lnTo>
                  <a:lnTo>
                    <a:pt x="382" y="2830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Freeform 74"/>
            <p:cNvSpPr/>
            <p:nvPr/>
          </p:nvSpPr>
          <p:spPr>
            <a:xfrm>
              <a:off x="5941080" y="3070080"/>
              <a:ext cx="201600" cy="506880"/>
            </a:xfrm>
            <a:custGeom>
              <a:avLst/>
              <a:gdLst>
                <a:gd name="textAreaLeft" fmla="*/ 0 w 201600"/>
                <a:gd name="textAreaRight" fmla="*/ 201960 w 201600"/>
                <a:gd name="textAreaTop" fmla="*/ 0 h 506880"/>
                <a:gd name="textAreaBottom" fmla="*/ 507240 h 506880"/>
              </a:gdLst>
              <a:ahLst/>
              <a:rect l="textAreaLeft" t="textAreaTop" r="textAreaRight" b="textAreaBottom"/>
              <a:pathLst>
                <a:path w="609" h="1531">
                  <a:moveTo>
                    <a:pt x="34" y="13"/>
                  </a:moveTo>
                  <a:lnTo>
                    <a:pt x="543" y="1369"/>
                  </a:lnTo>
                  <a:cubicBezTo>
                    <a:pt x="546" y="1378"/>
                    <a:pt x="541" y="1387"/>
                    <a:pt x="533" y="1391"/>
                  </a:cubicBezTo>
                  <a:cubicBezTo>
                    <a:pt x="524" y="1394"/>
                    <a:pt x="515" y="1390"/>
                    <a:pt x="511" y="1381"/>
                  </a:cubicBezTo>
                  <a:lnTo>
                    <a:pt x="3" y="24"/>
                  </a:lnTo>
                  <a:cubicBezTo>
                    <a:pt x="0" y="16"/>
                    <a:pt x="4" y="6"/>
                    <a:pt x="13" y="3"/>
                  </a:cubicBezTo>
                  <a:cubicBezTo>
                    <a:pt x="22" y="0"/>
                    <a:pt x="31" y="4"/>
                    <a:pt x="34" y="13"/>
                  </a:cubicBezTo>
                  <a:close/>
                  <a:moveTo>
                    <a:pt x="609" y="1309"/>
                  </a:moveTo>
                  <a:lnTo>
                    <a:pt x="585" y="1531"/>
                  </a:lnTo>
                  <a:lnTo>
                    <a:pt x="422" y="1379"/>
                  </a:lnTo>
                  <a:lnTo>
                    <a:pt x="609" y="1309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Freeform 75"/>
            <p:cNvSpPr/>
            <p:nvPr/>
          </p:nvSpPr>
          <p:spPr>
            <a:xfrm>
              <a:off x="5413320" y="3821400"/>
              <a:ext cx="65520" cy="255240"/>
            </a:xfrm>
            <a:custGeom>
              <a:avLst/>
              <a:gdLst>
                <a:gd name="textAreaLeft" fmla="*/ 0 w 65520"/>
                <a:gd name="textAreaRight" fmla="*/ 65880 w 65520"/>
                <a:gd name="textAreaTop" fmla="*/ 0 h 255240"/>
                <a:gd name="textAreaBottom" fmla="*/ 255600 h 255240"/>
              </a:gdLst>
              <a:ahLst/>
              <a:rect l="textAreaLeft" t="textAreaTop" r="textAreaRight" b="textAreaBottom"/>
              <a:pathLst>
                <a:path w="400" h="1541">
                  <a:moveTo>
                    <a:pt x="233" y="33"/>
                  </a:moveTo>
                  <a:lnTo>
                    <a:pt x="233" y="1208"/>
                  </a:lnTo>
                  <a:cubicBezTo>
                    <a:pt x="233" y="1227"/>
                    <a:pt x="219" y="1241"/>
                    <a:pt x="200" y="1241"/>
                  </a:cubicBezTo>
                  <a:cubicBezTo>
                    <a:pt x="182" y="1241"/>
                    <a:pt x="167" y="1227"/>
                    <a:pt x="167" y="1208"/>
                  </a:cubicBezTo>
                  <a:lnTo>
                    <a:pt x="167" y="33"/>
                  </a:lnTo>
                  <a:cubicBezTo>
                    <a:pt x="167" y="15"/>
                    <a:pt x="182" y="0"/>
                    <a:pt x="200" y="0"/>
                  </a:cubicBezTo>
                  <a:cubicBezTo>
                    <a:pt x="219" y="0"/>
                    <a:pt x="233" y="15"/>
                    <a:pt x="233" y="33"/>
                  </a:cubicBezTo>
                  <a:close/>
                  <a:moveTo>
                    <a:pt x="400" y="1141"/>
                  </a:moveTo>
                  <a:lnTo>
                    <a:pt x="200" y="1541"/>
                  </a:lnTo>
                  <a:lnTo>
                    <a:pt x="0" y="1141"/>
                  </a:lnTo>
                  <a:lnTo>
                    <a:pt x="400" y="1141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76"/>
            <p:cNvSpPr/>
            <p:nvPr/>
          </p:nvSpPr>
          <p:spPr>
            <a:xfrm>
              <a:off x="2265840" y="807120"/>
              <a:ext cx="502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ignal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Freeform 77"/>
            <p:cNvSpPr/>
            <p:nvPr/>
          </p:nvSpPr>
          <p:spPr>
            <a:xfrm>
              <a:off x="2405160" y="1000800"/>
              <a:ext cx="65880" cy="194040"/>
            </a:xfrm>
            <a:custGeom>
              <a:avLst/>
              <a:gdLst>
                <a:gd name="textAreaLeft" fmla="*/ 0 w 65880"/>
                <a:gd name="textAreaRight" fmla="*/ 66240 w 65880"/>
                <a:gd name="textAreaTop" fmla="*/ 0 h 194040"/>
                <a:gd name="textAreaBottom" fmla="*/ 194400 h 194040"/>
              </a:gdLst>
              <a:ahLst/>
              <a:rect l="textAreaLeft" t="textAreaTop" r="textAreaRight" b="textAreaBottom"/>
              <a:pathLst>
                <a:path w="800" h="2334">
                  <a:moveTo>
                    <a:pt x="467" y="67"/>
                  </a:moveTo>
                  <a:lnTo>
                    <a:pt x="467" y="1667"/>
                  </a:lnTo>
                  <a:cubicBezTo>
                    <a:pt x="467" y="1704"/>
                    <a:pt x="437" y="1734"/>
                    <a:pt x="400" y="1734"/>
                  </a:cubicBezTo>
                  <a:cubicBezTo>
                    <a:pt x="364" y="1734"/>
                    <a:pt x="334" y="1704"/>
                    <a:pt x="334" y="1667"/>
                  </a:cubicBezTo>
                  <a:lnTo>
                    <a:pt x="334" y="67"/>
                  </a:lnTo>
                  <a:cubicBezTo>
                    <a:pt x="334" y="30"/>
                    <a:pt x="364" y="0"/>
                    <a:pt x="400" y="0"/>
                  </a:cubicBezTo>
                  <a:cubicBezTo>
                    <a:pt x="437" y="0"/>
                    <a:pt x="467" y="30"/>
                    <a:pt x="467" y="67"/>
                  </a:cubicBezTo>
                  <a:close/>
                  <a:moveTo>
                    <a:pt x="800" y="1534"/>
                  </a:moveTo>
                  <a:lnTo>
                    <a:pt x="400" y="2334"/>
                  </a:lnTo>
                  <a:lnTo>
                    <a:pt x="0" y="1534"/>
                  </a:lnTo>
                  <a:lnTo>
                    <a:pt x="800" y="1534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Freeform 78"/>
            <p:cNvSpPr/>
            <p:nvPr/>
          </p:nvSpPr>
          <p:spPr>
            <a:xfrm>
              <a:off x="2405160" y="1815120"/>
              <a:ext cx="65880" cy="194040"/>
            </a:xfrm>
            <a:custGeom>
              <a:avLst/>
              <a:gdLst>
                <a:gd name="textAreaLeft" fmla="*/ 0 w 65880"/>
                <a:gd name="textAreaRight" fmla="*/ 66240 w 65880"/>
                <a:gd name="textAreaTop" fmla="*/ 0 h 194040"/>
                <a:gd name="textAreaBottom" fmla="*/ 194400 h 194040"/>
              </a:gdLst>
              <a:ahLst/>
              <a:rect l="textAreaLeft" t="textAreaTop" r="textAreaRight" b="textAreaBottom"/>
              <a:pathLst>
                <a:path w="800" h="2333">
                  <a:moveTo>
                    <a:pt x="467" y="67"/>
                  </a:moveTo>
                  <a:lnTo>
                    <a:pt x="467" y="1667"/>
                  </a:lnTo>
                  <a:cubicBezTo>
                    <a:pt x="467" y="1704"/>
                    <a:pt x="437" y="1733"/>
                    <a:pt x="400" y="1733"/>
                  </a:cubicBezTo>
                  <a:cubicBezTo>
                    <a:pt x="364" y="1733"/>
                    <a:pt x="334" y="1704"/>
                    <a:pt x="334" y="1667"/>
                  </a:cubicBezTo>
                  <a:lnTo>
                    <a:pt x="334" y="67"/>
                  </a:lnTo>
                  <a:cubicBezTo>
                    <a:pt x="334" y="30"/>
                    <a:pt x="364" y="0"/>
                    <a:pt x="400" y="0"/>
                  </a:cubicBezTo>
                  <a:cubicBezTo>
                    <a:pt x="437" y="0"/>
                    <a:pt x="467" y="30"/>
                    <a:pt x="467" y="67"/>
                  </a:cubicBezTo>
                  <a:close/>
                  <a:moveTo>
                    <a:pt x="800" y="1533"/>
                  </a:moveTo>
                  <a:lnTo>
                    <a:pt x="400" y="2333"/>
                  </a:lnTo>
                  <a:lnTo>
                    <a:pt x="0" y="1533"/>
                  </a:lnTo>
                  <a:lnTo>
                    <a:pt x="800" y="1533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Freeform 79"/>
            <p:cNvSpPr/>
            <p:nvPr/>
          </p:nvSpPr>
          <p:spPr>
            <a:xfrm>
              <a:off x="2405160" y="2692440"/>
              <a:ext cx="65880" cy="194040"/>
            </a:xfrm>
            <a:custGeom>
              <a:avLst/>
              <a:gdLst>
                <a:gd name="textAreaLeft" fmla="*/ 0 w 65880"/>
                <a:gd name="textAreaRight" fmla="*/ 66240 w 65880"/>
                <a:gd name="textAreaTop" fmla="*/ 0 h 194040"/>
                <a:gd name="textAreaBottom" fmla="*/ 194400 h 194040"/>
              </a:gdLst>
              <a:ahLst/>
              <a:rect l="textAreaLeft" t="textAreaTop" r="textAreaRight" b="textAreaBottom"/>
              <a:pathLst>
                <a:path w="400" h="1167">
                  <a:moveTo>
                    <a:pt x="234" y="34"/>
                  </a:moveTo>
                  <a:lnTo>
                    <a:pt x="234" y="834"/>
                  </a:lnTo>
                  <a:cubicBezTo>
                    <a:pt x="234" y="852"/>
                    <a:pt x="219" y="867"/>
                    <a:pt x="200" y="867"/>
                  </a:cubicBezTo>
                  <a:cubicBezTo>
                    <a:pt x="182" y="867"/>
                    <a:pt x="167" y="852"/>
                    <a:pt x="167" y="834"/>
                  </a:cubicBezTo>
                  <a:lnTo>
                    <a:pt x="167" y="34"/>
                  </a:lnTo>
                  <a:cubicBezTo>
                    <a:pt x="167" y="15"/>
                    <a:pt x="182" y="0"/>
                    <a:pt x="200" y="0"/>
                  </a:cubicBezTo>
                  <a:cubicBezTo>
                    <a:pt x="219" y="0"/>
                    <a:pt x="234" y="15"/>
                    <a:pt x="234" y="34"/>
                  </a:cubicBezTo>
                  <a:close/>
                  <a:moveTo>
                    <a:pt x="400" y="767"/>
                  </a:moveTo>
                  <a:lnTo>
                    <a:pt x="200" y="1167"/>
                  </a:lnTo>
                  <a:lnTo>
                    <a:pt x="0" y="767"/>
                  </a:lnTo>
                  <a:lnTo>
                    <a:pt x="400" y="767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Freeform 80"/>
            <p:cNvSpPr/>
            <p:nvPr/>
          </p:nvSpPr>
          <p:spPr>
            <a:xfrm>
              <a:off x="1794600" y="1593000"/>
              <a:ext cx="461880" cy="1495800"/>
            </a:xfrm>
            <a:custGeom>
              <a:avLst/>
              <a:gdLst>
                <a:gd name="textAreaLeft" fmla="*/ 0 w 461880"/>
                <a:gd name="textAreaRight" fmla="*/ 462240 w 461880"/>
                <a:gd name="textAreaTop" fmla="*/ 0 h 1495800"/>
                <a:gd name="textAreaBottom" fmla="*/ 1496160 h 1495800"/>
              </a:gdLst>
              <a:ahLst/>
              <a:rect l="textAreaLeft" t="textAreaTop" r="textAreaRight" b="textAreaBottom"/>
              <a:pathLst>
                <a:path w="2783" h="9017">
                  <a:moveTo>
                    <a:pt x="2750" y="9017"/>
                  </a:moveTo>
                  <a:lnTo>
                    <a:pt x="33" y="9017"/>
                  </a:lnTo>
                  <a:cubicBezTo>
                    <a:pt x="15" y="9017"/>
                    <a:pt x="0" y="9002"/>
                    <a:pt x="0" y="8983"/>
                  </a:cubicBezTo>
                  <a:lnTo>
                    <a:pt x="0" y="200"/>
                  </a:lnTo>
                  <a:cubicBezTo>
                    <a:pt x="0" y="182"/>
                    <a:pt x="15" y="167"/>
                    <a:pt x="33" y="167"/>
                  </a:cubicBezTo>
                  <a:lnTo>
                    <a:pt x="900" y="167"/>
                  </a:lnTo>
                  <a:cubicBezTo>
                    <a:pt x="919" y="167"/>
                    <a:pt x="933" y="182"/>
                    <a:pt x="933" y="200"/>
                  </a:cubicBezTo>
                  <a:cubicBezTo>
                    <a:pt x="933" y="219"/>
                    <a:pt x="919" y="233"/>
                    <a:pt x="900" y="233"/>
                  </a:cubicBezTo>
                  <a:lnTo>
                    <a:pt x="33" y="233"/>
                  </a:lnTo>
                  <a:lnTo>
                    <a:pt x="67" y="200"/>
                  </a:lnTo>
                  <a:lnTo>
                    <a:pt x="67" y="8983"/>
                  </a:lnTo>
                  <a:lnTo>
                    <a:pt x="33" y="8950"/>
                  </a:lnTo>
                  <a:lnTo>
                    <a:pt x="2750" y="8950"/>
                  </a:lnTo>
                  <a:cubicBezTo>
                    <a:pt x="2769" y="8950"/>
                    <a:pt x="2783" y="8965"/>
                    <a:pt x="2783" y="8983"/>
                  </a:cubicBezTo>
                  <a:cubicBezTo>
                    <a:pt x="2783" y="9002"/>
                    <a:pt x="2769" y="9017"/>
                    <a:pt x="2750" y="9017"/>
                  </a:cubicBezTo>
                  <a:close/>
                  <a:moveTo>
                    <a:pt x="833" y="0"/>
                  </a:moveTo>
                  <a:lnTo>
                    <a:pt x="1233" y="200"/>
                  </a:lnTo>
                  <a:lnTo>
                    <a:pt x="833" y="400"/>
                  </a:lnTo>
                  <a:lnTo>
                    <a:pt x="833" y="0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Freeform 81"/>
            <p:cNvSpPr/>
            <p:nvPr/>
          </p:nvSpPr>
          <p:spPr>
            <a:xfrm>
              <a:off x="1683360" y="3209040"/>
              <a:ext cx="760680" cy="178560"/>
            </a:xfrm>
            <a:custGeom>
              <a:avLst/>
              <a:gdLst>
                <a:gd name="textAreaLeft" fmla="*/ 0 w 760680"/>
                <a:gd name="textAreaRight" fmla="*/ 761040 w 760680"/>
                <a:gd name="textAreaTop" fmla="*/ 0 h 178560"/>
                <a:gd name="textAreaBottom" fmla="*/ 178920 h 178560"/>
              </a:gdLst>
              <a:ahLst/>
              <a:rect l="textAreaLeft" t="textAreaTop" r="textAreaRight" b="textAreaBottom"/>
              <a:pathLst>
                <a:path w="4584" h="1075">
                  <a:moveTo>
                    <a:pt x="4584" y="33"/>
                  </a:moveTo>
                  <a:lnTo>
                    <a:pt x="4584" y="550"/>
                  </a:lnTo>
                  <a:cubicBezTo>
                    <a:pt x="4584" y="569"/>
                    <a:pt x="4569" y="583"/>
                    <a:pt x="4550" y="583"/>
                  </a:cubicBezTo>
                  <a:lnTo>
                    <a:pt x="200" y="583"/>
                  </a:lnTo>
                  <a:lnTo>
                    <a:pt x="234" y="550"/>
                  </a:lnTo>
                  <a:lnTo>
                    <a:pt x="234" y="742"/>
                  </a:lnTo>
                  <a:cubicBezTo>
                    <a:pt x="234" y="760"/>
                    <a:pt x="219" y="775"/>
                    <a:pt x="200" y="775"/>
                  </a:cubicBezTo>
                  <a:cubicBezTo>
                    <a:pt x="182" y="775"/>
                    <a:pt x="167" y="760"/>
                    <a:pt x="167" y="742"/>
                  </a:cubicBezTo>
                  <a:lnTo>
                    <a:pt x="167" y="550"/>
                  </a:lnTo>
                  <a:cubicBezTo>
                    <a:pt x="167" y="532"/>
                    <a:pt x="182" y="517"/>
                    <a:pt x="200" y="517"/>
                  </a:cubicBezTo>
                  <a:lnTo>
                    <a:pt x="4550" y="517"/>
                  </a:lnTo>
                  <a:lnTo>
                    <a:pt x="4517" y="550"/>
                  </a:lnTo>
                  <a:lnTo>
                    <a:pt x="4517" y="33"/>
                  </a:lnTo>
                  <a:cubicBezTo>
                    <a:pt x="4517" y="15"/>
                    <a:pt x="4532" y="0"/>
                    <a:pt x="4550" y="0"/>
                  </a:cubicBezTo>
                  <a:cubicBezTo>
                    <a:pt x="4569" y="0"/>
                    <a:pt x="4584" y="15"/>
                    <a:pt x="4584" y="33"/>
                  </a:cubicBezTo>
                  <a:close/>
                  <a:moveTo>
                    <a:pt x="400" y="675"/>
                  </a:moveTo>
                  <a:lnTo>
                    <a:pt x="200" y="1075"/>
                  </a:lnTo>
                  <a:lnTo>
                    <a:pt x="0" y="675"/>
                  </a:lnTo>
                  <a:lnTo>
                    <a:pt x="400" y="675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Freeform 82"/>
            <p:cNvSpPr/>
            <p:nvPr/>
          </p:nvSpPr>
          <p:spPr>
            <a:xfrm>
              <a:off x="2405160" y="3258000"/>
              <a:ext cx="65880" cy="1071000"/>
            </a:xfrm>
            <a:custGeom>
              <a:avLst/>
              <a:gdLst>
                <a:gd name="textAreaLeft" fmla="*/ 0 w 65880"/>
                <a:gd name="textAreaRight" fmla="*/ 66240 w 65880"/>
                <a:gd name="textAreaTop" fmla="*/ 0 h 1071000"/>
                <a:gd name="textAreaBottom" fmla="*/ 1071360 h 1071000"/>
              </a:gdLst>
              <a:ahLst/>
              <a:rect l="textAreaLeft" t="textAreaTop" r="textAreaRight" b="textAreaBottom"/>
              <a:pathLst>
                <a:path w="400" h="6458">
                  <a:moveTo>
                    <a:pt x="234" y="33"/>
                  </a:moveTo>
                  <a:lnTo>
                    <a:pt x="234" y="6125"/>
                  </a:lnTo>
                  <a:cubicBezTo>
                    <a:pt x="234" y="6143"/>
                    <a:pt x="219" y="6158"/>
                    <a:pt x="200" y="6158"/>
                  </a:cubicBezTo>
                  <a:cubicBezTo>
                    <a:pt x="182" y="6158"/>
                    <a:pt x="167" y="6143"/>
                    <a:pt x="167" y="6125"/>
                  </a:cubicBezTo>
                  <a:lnTo>
                    <a:pt x="167" y="33"/>
                  </a:lnTo>
                  <a:cubicBezTo>
                    <a:pt x="167" y="15"/>
                    <a:pt x="182" y="0"/>
                    <a:pt x="200" y="0"/>
                  </a:cubicBezTo>
                  <a:cubicBezTo>
                    <a:pt x="219" y="0"/>
                    <a:pt x="234" y="15"/>
                    <a:pt x="234" y="33"/>
                  </a:cubicBezTo>
                  <a:close/>
                  <a:moveTo>
                    <a:pt x="400" y="6058"/>
                  </a:moveTo>
                  <a:lnTo>
                    <a:pt x="200" y="6458"/>
                  </a:lnTo>
                  <a:lnTo>
                    <a:pt x="0" y="6058"/>
                  </a:lnTo>
                  <a:lnTo>
                    <a:pt x="400" y="6058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Freeform 83"/>
            <p:cNvSpPr/>
            <p:nvPr/>
          </p:nvSpPr>
          <p:spPr>
            <a:xfrm>
              <a:off x="1803960" y="3632040"/>
              <a:ext cx="132840" cy="194040"/>
            </a:xfrm>
            <a:custGeom>
              <a:avLst/>
              <a:gdLst>
                <a:gd name="textAreaLeft" fmla="*/ 0 w 132840"/>
                <a:gd name="textAreaRight" fmla="*/ 133200 w 132840"/>
                <a:gd name="textAreaTop" fmla="*/ 0 h 194040"/>
                <a:gd name="textAreaBottom" fmla="*/ 194400 h 194040"/>
              </a:gdLst>
              <a:ahLst/>
              <a:rect l="textAreaLeft" t="textAreaTop" r="textAreaRight" b="textAreaBottom"/>
              <a:pathLst>
                <a:path w="796" h="1171">
                  <a:moveTo>
                    <a:pt x="66" y="19"/>
                  </a:moveTo>
                  <a:lnTo>
                    <a:pt x="639" y="876"/>
                  </a:lnTo>
                  <a:cubicBezTo>
                    <a:pt x="649" y="891"/>
                    <a:pt x="645" y="912"/>
                    <a:pt x="630" y="922"/>
                  </a:cubicBezTo>
                  <a:cubicBezTo>
                    <a:pt x="614" y="932"/>
                    <a:pt x="594" y="928"/>
                    <a:pt x="583" y="913"/>
                  </a:cubicBezTo>
                  <a:lnTo>
                    <a:pt x="10" y="56"/>
                  </a:lnTo>
                  <a:cubicBezTo>
                    <a:pt x="0" y="41"/>
                    <a:pt x="4" y="20"/>
                    <a:pt x="20" y="10"/>
                  </a:cubicBezTo>
                  <a:cubicBezTo>
                    <a:pt x="35" y="0"/>
                    <a:pt x="56" y="4"/>
                    <a:pt x="66" y="19"/>
                  </a:cubicBezTo>
                  <a:close/>
                  <a:moveTo>
                    <a:pt x="740" y="727"/>
                  </a:moveTo>
                  <a:lnTo>
                    <a:pt x="796" y="1171"/>
                  </a:lnTo>
                  <a:lnTo>
                    <a:pt x="408" y="950"/>
                  </a:lnTo>
                  <a:lnTo>
                    <a:pt x="740" y="727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84"/>
            <p:cNvSpPr/>
            <p:nvPr/>
          </p:nvSpPr>
          <p:spPr>
            <a:xfrm>
              <a:off x="2043360" y="3937680"/>
              <a:ext cx="210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G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Freeform 85"/>
            <p:cNvSpPr/>
            <p:nvPr/>
          </p:nvSpPr>
          <p:spPr>
            <a:xfrm>
              <a:off x="2179440" y="4134600"/>
              <a:ext cx="139320" cy="319320"/>
            </a:xfrm>
            <a:custGeom>
              <a:avLst/>
              <a:gdLst>
                <a:gd name="textAreaLeft" fmla="*/ 0 w 139320"/>
                <a:gd name="textAreaRight" fmla="*/ 139680 w 139320"/>
                <a:gd name="textAreaTop" fmla="*/ 0 h 319320"/>
                <a:gd name="textAreaBottom" fmla="*/ 319680 h 319320"/>
              </a:gdLst>
              <a:ahLst/>
              <a:rect l="textAreaLeft" t="textAreaTop" r="textAreaRight" b="textAreaBottom"/>
              <a:pathLst>
                <a:path w="833" h="1929">
                  <a:moveTo>
                    <a:pt x="69" y="25"/>
                  </a:moveTo>
                  <a:lnTo>
                    <a:pt x="703" y="1608"/>
                  </a:lnTo>
                  <a:cubicBezTo>
                    <a:pt x="710" y="1625"/>
                    <a:pt x="702" y="1644"/>
                    <a:pt x="685" y="1651"/>
                  </a:cubicBezTo>
                  <a:cubicBezTo>
                    <a:pt x="667" y="1658"/>
                    <a:pt x="648" y="1650"/>
                    <a:pt x="641" y="1632"/>
                  </a:cubicBezTo>
                  <a:lnTo>
                    <a:pt x="7" y="50"/>
                  </a:lnTo>
                  <a:cubicBezTo>
                    <a:pt x="0" y="33"/>
                    <a:pt x="8" y="14"/>
                    <a:pt x="25" y="7"/>
                  </a:cubicBezTo>
                  <a:cubicBezTo>
                    <a:pt x="42" y="0"/>
                    <a:pt x="62" y="8"/>
                    <a:pt x="69" y="25"/>
                  </a:cubicBezTo>
                  <a:close/>
                  <a:moveTo>
                    <a:pt x="833" y="1484"/>
                  </a:moveTo>
                  <a:lnTo>
                    <a:pt x="796" y="1929"/>
                  </a:lnTo>
                  <a:lnTo>
                    <a:pt x="462" y="1633"/>
                  </a:lnTo>
                  <a:lnTo>
                    <a:pt x="833" y="1484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86"/>
            <p:cNvSpPr/>
            <p:nvPr/>
          </p:nvSpPr>
          <p:spPr>
            <a:xfrm>
              <a:off x="4836960" y="807120"/>
              <a:ext cx="502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ignal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Freeform 87"/>
            <p:cNvSpPr/>
            <p:nvPr/>
          </p:nvSpPr>
          <p:spPr>
            <a:xfrm>
              <a:off x="4974840" y="1000800"/>
              <a:ext cx="65520" cy="194040"/>
            </a:xfrm>
            <a:custGeom>
              <a:avLst/>
              <a:gdLst>
                <a:gd name="textAreaLeft" fmla="*/ 0 w 65520"/>
                <a:gd name="textAreaRight" fmla="*/ 65880 w 65520"/>
                <a:gd name="textAreaTop" fmla="*/ 0 h 194040"/>
                <a:gd name="textAreaBottom" fmla="*/ 194400 h 194040"/>
              </a:gdLst>
              <a:ahLst/>
              <a:rect l="textAreaLeft" t="textAreaTop" r="textAreaRight" b="textAreaBottom"/>
              <a:pathLst>
                <a:path w="400" h="1167">
                  <a:moveTo>
                    <a:pt x="234" y="34"/>
                  </a:moveTo>
                  <a:lnTo>
                    <a:pt x="234" y="834"/>
                  </a:lnTo>
                  <a:cubicBezTo>
                    <a:pt x="234" y="852"/>
                    <a:pt x="219" y="867"/>
                    <a:pt x="200" y="867"/>
                  </a:cubicBezTo>
                  <a:cubicBezTo>
                    <a:pt x="182" y="867"/>
                    <a:pt x="167" y="852"/>
                    <a:pt x="167" y="834"/>
                  </a:cubicBezTo>
                  <a:lnTo>
                    <a:pt x="167" y="34"/>
                  </a:lnTo>
                  <a:cubicBezTo>
                    <a:pt x="167" y="15"/>
                    <a:pt x="182" y="0"/>
                    <a:pt x="200" y="0"/>
                  </a:cubicBezTo>
                  <a:cubicBezTo>
                    <a:pt x="219" y="0"/>
                    <a:pt x="234" y="15"/>
                    <a:pt x="234" y="34"/>
                  </a:cubicBezTo>
                  <a:close/>
                  <a:moveTo>
                    <a:pt x="400" y="767"/>
                  </a:moveTo>
                  <a:lnTo>
                    <a:pt x="200" y="1167"/>
                  </a:lnTo>
                  <a:lnTo>
                    <a:pt x="0" y="767"/>
                  </a:lnTo>
                  <a:lnTo>
                    <a:pt x="400" y="767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88"/>
            <p:cNvSpPr/>
            <p:nvPr/>
          </p:nvSpPr>
          <p:spPr>
            <a:xfrm>
              <a:off x="684360" y="3075840"/>
              <a:ext cx="749880" cy="264600"/>
            </a:xfrm>
            <a:prstGeom prst="rect">
              <a:avLst/>
            </a:prstGeom>
            <a:solidFill>
              <a:srgbClr val="ff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89"/>
            <p:cNvSpPr/>
            <p:nvPr/>
          </p:nvSpPr>
          <p:spPr>
            <a:xfrm>
              <a:off x="815040" y="3126240"/>
              <a:ext cx="517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IMIN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90"/>
            <p:cNvSpPr/>
            <p:nvPr/>
          </p:nvSpPr>
          <p:spPr>
            <a:xfrm>
              <a:off x="684360" y="3387960"/>
              <a:ext cx="749880" cy="2642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91"/>
            <p:cNvSpPr/>
            <p:nvPr/>
          </p:nvSpPr>
          <p:spPr>
            <a:xfrm>
              <a:off x="815040" y="3438000"/>
              <a:ext cx="517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IMIN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Freeform 92"/>
            <p:cNvSpPr/>
            <p:nvPr/>
          </p:nvSpPr>
          <p:spPr>
            <a:xfrm>
              <a:off x="1373040" y="380880"/>
              <a:ext cx="2256480" cy="375480"/>
            </a:xfrm>
            <a:custGeom>
              <a:avLst/>
              <a:gdLst>
                <a:gd name="textAreaLeft" fmla="*/ 0 w 2256480"/>
                <a:gd name="textAreaRight" fmla="*/ 2256840 w 2256480"/>
                <a:gd name="textAreaTop" fmla="*/ 0 h 375480"/>
                <a:gd name="textAreaBottom" fmla="*/ 375840 h 375480"/>
              </a:gdLst>
              <a:ahLst/>
              <a:rect l="textAreaLeft" t="textAreaTop" r="textAreaRight" b="textAreaBottom"/>
              <a:pathLst>
                <a:path w="13609" h="2267">
                  <a:moveTo>
                    <a:pt x="378" y="0"/>
                  </a:moveTo>
                  <a:cubicBezTo>
                    <a:pt x="170" y="0"/>
                    <a:pt x="0" y="170"/>
                    <a:pt x="0" y="378"/>
                  </a:cubicBezTo>
                  <a:lnTo>
                    <a:pt x="0" y="1889"/>
                  </a:lnTo>
                  <a:cubicBezTo>
                    <a:pt x="0" y="2098"/>
                    <a:pt x="170" y="2267"/>
                    <a:pt x="378" y="2267"/>
                  </a:cubicBezTo>
                  <a:lnTo>
                    <a:pt x="13231" y="2267"/>
                  </a:lnTo>
                  <a:cubicBezTo>
                    <a:pt x="13440" y="2267"/>
                    <a:pt x="13609" y="2098"/>
                    <a:pt x="13609" y="1889"/>
                  </a:cubicBezTo>
                  <a:lnTo>
                    <a:pt x="13609" y="378"/>
                  </a:lnTo>
                  <a:cubicBezTo>
                    <a:pt x="13609" y="170"/>
                    <a:pt x="13440" y="0"/>
                    <a:pt x="13231" y="0"/>
                  </a:cubicBezTo>
                  <a:lnTo>
                    <a:pt x="378" y="0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93"/>
            <p:cNvSpPr/>
            <p:nvPr/>
          </p:nvSpPr>
          <p:spPr>
            <a:xfrm>
              <a:off x="1736640" y="440280"/>
              <a:ext cx="73836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Salicylic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94"/>
            <p:cNvSpPr/>
            <p:nvPr/>
          </p:nvSpPr>
          <p:spPr>
            <a:xfrm>
              <a:off x="2512080" y="440280"/>
              <a:ext cx="75672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pathwa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Freeform 95"/>
            <p:cNvSpPr/>
            <p:nvPr/>
          </p:nvSpPr>
          <p:spPr>
            <a:xfrm>
              <a:off x="3817440" y="380880"/>
              <a:ext cx="2254680" cy="375480"/>
            </a:xfrm>
            <a:custGeom>
              <a:avLst/>
              <a:gdLst>
                <a:gd name="textAreaLeft" fmla="*/ 0 w 2254680"/>
                <a:gd name="textAreaRight" fmla="*/ 2255040 w 2254680"/>
                <a:gd name="textAreaTop" fmla="*/ 0 h 375480"/>
                <a:gd name="textAreaBottom" fmla="*/ 375840 h 375480"/>
              </a:gdLst>
              <a:ahLst/>
              <a:rect l="textAreaLeft" t="textAreaTop" r="textAreaRight" b="textAreaBottom"/>
              <a:pathLst>
                <a:path w="6804" h="1134">
                  <a:moveTo>
                    <a:pt x="189" y="0"/>
                  </a:moveTo>
                  <a:cubicBezTo>
                    <a:pt x="84" y="0"/>
                    <a:pt x="0" y="85"/>
                    <a:pt x="0" y="189"/>
                  </a:cubicBezTo>
                  <a:lnTo>
                    <a:pt x="0" y="945"/>
                  </a:lnTo>
                  <a:cubicBezTo>
                    <a:pt x="0" y="1049"/>
                    <a:pt x="84" y="1134"/>
                    <a:pt x="189" y="1134"/>
                  </a:cubicBezTo>
                  <a:lnTo>
                    <a:pt x="6615" y="1134"/>
                  </a:lnTo>
                  <a:cubicBezTo>
                    <a:pt x="6719" y="1134"/>
                    <a:pt x="6804" y="1049"/>
                    <a:pt x="6804" y="945"/>
                  </a:cubicBezTo>
                  <a:lnTo>
                    <a:pt x="6804" y="189"/>
                  </a:lnTo>
                  <a:cubicBezTo>
                    <a:pt x="6804" y="85"/>
                    <a:pt x="6719" y="0"/>
                    <a:pt x="6615" y="0"/>
                  </a:cubicBezTo>
                  <a:lnTo>
                    <a:pt x="189" y="0"/>
                  </a:lnTo>
                  <a:close/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96"/>
            <p:cNvSpPr/>
            <p:nvPr/>
          </p:nvSpPr>
          <p:spPr>
            <a:xfrm>
              <a:off x="4126320" y="440280"/>
              <a:ext cx="2948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JA/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97"/>
            <p:cNvSpPr/>
            <p:nvPr/>
          </p:nvSpPr>
          <p:spPr>
            <a:xfrm>
              <a:off x="4417560" y="440280"/>
              <a:ext cx="7916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Ethylen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98"/>
            <p:cNvSpPr/>
            <p:nvPr/>
          </p:nvSpPr>
          <p:spPr>
            <a:xfrm>
              <a:off x="5235120" y="440280"/>
              <a:ext cx="75672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pathwa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Rectangle 99"/>
            <p:cNvSpPr/>
            <p:nvPr/>
          </p:nvSpPr>
          <p:spPr>
            <a:xfrm>
              <a:off x="7534080" y="2225880"/>
              <a:ext cx="2980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L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100"/>
            <p:cNvSpPr/>
            <p:nvPr/>
          </p:nvSpPr>
          <p:spPr>
            <a:xfrm>
              <a:off x="7262280" y="2631240"/>
              <a:ext cx="751680" cy="26424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101"/>
            <p:cNvSpPr/>
            <p:nvPr/>
          </p:nvSpPr>
          <p:spPr>
            <a:xfrm>
              <a:off x="7488000" y="2681280"/>
              <a:ext cx="392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Arial"/>
                </a:rPr>
                <a:t>LOX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102"/>
            <p:cNvSpPr/>
            <p:nvPr/>
          </p:nvSpPr>
          <p:spPr>
            <a:xfrm>
              <a:off x="7262280" y="3068280"/>
              <a:ext cx="751680" cy="26604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103"/>
            <p:cNvSpPr/>
            <p:nvPr/>
          </p:nvSpPr>
          <p:spPr>
            <a:xfrm>
              <a:off x="7521120" y="3118320"/>
              <a:ext cx="323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Arial"/>
                </a:rPr>
                <a:t>AO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104"/>
            <p:cNvSpPr/>
            <p:nvPr/>
          </p:nvSpPr>
          <p:spPr>
            <a:xfrm>
              <a:off x="7164360" y="3542760"/>
              <a:ext cx="416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OC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105"/>
            <p:cNvSpPr/>
            <p:nvPr/>
          </p:nvSpPr>
          <p:spPr>
            <a:xfrm>
              <a:off x="7790760" y="3542760"/>
              <a:ext cx="416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OC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106"/>
            <p:cNvSpPr/>
            <p:nvPr/>
          </p:nvSpPr>
          <p:spPr>
            <a:xfrm>
              <a:off x="7541640" y="4057920"/>
              <a:ext cx="416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OPR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107"/>
            <p:cNvSpPr/>
            <p:nvPr/>
          </p:nvSpPr>
          <p:spPr>
            <a:xfrm>
              <a:off x="7588440" y="4684320"/>
              <a:ext cx="178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J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Freeform 108"/>
            <p:cNvSpPr/>
            <p:nvPr/>
          </p:nvSpPr>
          <p:spPr>
            <a:xfrm>
              <a:off x="7605360" y="2437200"/>
              <a:ext cx="65520" cy="194040"/>
            </a:xfrm>
            <a:custGeom>
              <a:avLst/>
              <a:gdLst>
                <a:gd name="textAreaLeft" fmla="*/ 0 w 65520"/>
                <a:gd name="textAreaRight" fmla="*/ 65880 w 65520"/>
                <a:gd name="textAreaTop" fmla="*/ 0 h 194040"/>
                <a:gd name="textAreaBottom" fmla="*/ 194400 h 194040"/>
              </a:gdLst>
              <a:ahLst/>
              <a:rect l="textAreaLeft" t="textAreaTop" r="textAreaRight" b="textAreaBottom"/>
              <a:pathLst>
                <a:path w="200" h="583">
                  <a:moveTo>
                    <a:pt x="116" y="16"/>
                  </a:moveTo>
                  <a:lnTo>
                    <a:pt x="116" y="416"/>
                  </a:lnTo>
                  <a:cubicBezTo>
                    <a:pt x="116" y="426"/>
                    <a:pt x="109" y="433"/>
                    <a:pt x="100" y="433"/>
                  </a:cubicBezTo>
                  <a:cubicBezTo>
                    <a:pt x="91" y="433"/>
                    <a:pt x="83" y="426"/>
                    <a:pt x="83" y="416"/>
                  </a:cubicBezTo>
                  <a:lnTo>
                    <a:pt x="83" y="16"/>
                  </a:lnTo>
                  <a:cubicBezTo>
                    <a:pt x="83" y="7"/>
                    <a:pt x="91" y="0"/>
                    <a:pt x="100" y="0"/>
                  </a:cubicBezTo>
                  <a:cubicBezTo>
                    <a:pt x="109" y="0"/>
                    <a:pt x="116" y="7"/>
                    <a:pt x="116" y="16"/>
                  </a:cubicBezTo>
                  <a:close/>
                  <a:moveTo>
                    <a:pt x="200" y="383"/>
                  </a:moveTo>
                  <a:lnTo>
                    <a:pt x="100" y="583"/>
                  </a:lnTo>
                  <a:lnTo>
                    <a:pt x="0" y="383"/>
                  </a:lnTo>
                  <a:lnTo>
                    <a:pt x="200" y="383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Freeform 109"/>
            <p:cNvSpPr/>
            <p:nvPr/>
          </p:nvSpPr>
          <p:spPr>
            <a:xfrm>
              <a:off x="7605360" y="2875680"/>
              <a:ext cx="65520" cy="192240"/>
            </a:xfrm>
            <a:custGeom>
              <a:avLst/>
              <a:gdLst>
                <a:gd name="textAreaLeft" fmla="*/ 0 w 65520"/>
                <a:gd name="textAreaRight" fmla="*/ 65880 w 65520"/>
                <a:gd name="textAreaTop" fmla="*/ 0 h 192240"/>
                <a:gd name="textAreaBottom" fmla="*/ 192600 h 192240"/>
              </a:gdLst>
              <a:ahLst/>
              <a:rect l="textAreaLeft" t="textAreaTop" r="textAreaRight" b="textAreaBottom"/>
              <a:pathLst>
                <a:path w="200" h="584">
                  <a:moveTo>
                    <a:pt x="116" y="17"/>
                  </a:moveTo>
                  <a:lnTo>
                    <a:pt x="116" y="417"/>
                  </a:lnTo>
                  <a:cubicBezTo>
                    <a:pt x="116" y="426"/>
                    <a:pt x="109" y="434"/>
                    <a:pt x="100" y="434"/>
                  </a:cubicBezTo>
                  <a:cubicBezTo>
                    <a:pt x="91" y="434"/>
                    <a:pt x="83" y="426"/>
                    <a:pt x="83" y="417"/>
                  </a:cubicBezTo>
                  <a:lnTo>
                    <a:pt x="83" y="17"/>
                  </a:lnTo>
                  <a:cubicBezTo>
                    <a:pt x="83" y="8"/>
                    <a:pt x="91" y="0"/>
                    <a:pt x="100" y="0"/>
                  </a:cubicBezTo>
                  <a:cubicBezTo>
                    <a:pt x="109" y="0"/>
                    <a:pt x="116" y="8"/>
                    <a:pt x="116" y="17"/>
                  </a:cubicBezTo>
                  <a:close/>
                  <a:moveTo>
                    <a:pt x="200" y="384"/>
                  </a:moveTo>
                  <a:lnTo>
                    <a:pt x="100" y="584"/>
                  </a:lnTo>
                  <a:lnTo>
                    <a:pt x="0" y="384"/>
                  </a:lnTo>
                  <a:lnTo>
                    <a:pt x="200" y="384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Freeform 110"/>
            <p:cNvSpPr/>
            <p:nvPr/>
          </p:nvSpPr>
          <p:spPr>
            <a:xfrm>
              <a:off x="7605360" y="3314160"/>
              <a:ext cx="65520" cy="193680"/>
            </a:xfrm>
            <a:custGeom>
              <a:avLst/>
              <a:gdLst>
                <a:gd name="textAreaLeft" fmla="*/ 0 w 65520"/>
                <a:gd name="textAreaRight" fmla="*/ 65880 w 65520"/>
                <a:gd name="textAreaTop" fmla="*/ 0 h 193680"/>
                <a:gd name="textAreaBottom" fmla="*/ 194040 h 193680"/>
              </a:gdLst>
              <a:ahLst/>
              <a:rect l="textAreaLeft" t="textAreaTop" r="textAreaRight" b="textAreaBottom"/>
              <a:pathLst>
                <a:path w="200" h="584">
                  <a:moveTo>
                    <a:pt x="116" y="17"/>
                  </a:moveTo>
                  <a:lnTo>
                    <a:pt x="116" y="417"/>
                  </a:lnTo>
                  <a:cubicBezTo>
                    <a:pt x="116" y="426"/>
                    <a:pt x="109" y="434"/>
                    <a:pt x="100" y="434"/>
                  </a:cubicBezTo>
                  <a:cubicBezTo>
                    <a:pt x="91" y="434"/>
                    <a:pt x="83" y="426"/>
                    <a:pt x="83" y="417"/>
                  </a:cubicBezTo>
                  <a:lnTo>
                    <a:pt x="83" y="17"/>
                  </a:lnTo>
                  <a:cubicBezTo>
                    <a:pt x="83" y="8"/>
                    <a:pt x="91" y="0"/>
                    <a:pt x="100" y="0"/>
                  </a:cubicBezTo>
                  <a:cubicBezTo>
                    <a:pt x="109" y="0"/>
                    <a:pt x="116" y="8"/>
                    <a:pt x="116" y="17"/>
                  </a:cubicBezTo>
                  <a:close/>
                  <a:moveTo>
                    <a:pt x="200" y="384"/>
                  </a:moveTo>
                  <a:lnTo>
                    <a:pt x="100" y="584"/>
                  </a:lnTo>
                  <a:lnTo>
                    <a:pt x="0" y="384"/>
                  </a:lnTo>
                  <a:lnTo>
                    <a:pt x="200" y="384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Freeform 111"/>
            <p:cNvSpPr/>
            <p:nvPr/>
          </p:nvSpPr>
          <p:spPr>
            <a:xfrm>
              <a:off x="7605360" y="3752640"/>
              <a:ext cx="65520" cy="192600"/>
            </a:xfrm>
            <a:custGeom>
              <a:avLst/>
              <a:gdLst>
                <a:gd name="textAreaLeft" fmla="*/ 0 w 65520"/>
                <a:gd name="textAreaRight" fmla="*/ 65880 w 65520"/>
                <a:gd name="textAreaTop" fmla="*/ 0 h 192600"/>
                <a:gd name="textAreaBottom" fmla="*/ 192960 h 192600"/>
              </a:gdLst>
              <a:ahLst/>
              <a:rect l="textAreaLeft" t="textAreaTop" r="textAreaRight" b="textAreaBottom"/>
              <a:pathLst>
                <a:path w="200" h="584">
                  <a:moveTo>
                    <a:pt x="116" y="17"/>
                  </a:moveTo>
                  <a:lnTo>
                    <a:pt x="116" y="417"/>
                  </a:lnTo>
                  <a:cubicBezTo>
                    <a:pt x="116" y="426"/>
                    <a:pt x="109" y="434"/>
                    <a:pt x="100" y="434"/>
                  </a:cubicBezTo>
                  <a:cubicBezTo>
                    <a:pt x="91" y="434"/>
                    <a:pt x="83" y="426"/>
                    <a:pt x="83" y="417"/>
                  </a:cubicBezTo>
                  <a:lnTo>
                    <a:pt x="83" y="17"/>
                  </a:lnTo>
                  <a:cubicBezTo>
                    <a:pt x="83" y="8"/>
                    <a:pt x="91" y="0"/>
                    <a:pt x="100" y="0"/>
                  </a:cubicBezTo>
                  <a:cubicBezTo>
                    <a:pt x="109" y="0"/>
                    <a:pt x="116" y="8"/>
                    <a:pt x="116" y="17"/>
                  </a:cubicBezTo>
                  <a:close/>
                  <a:moveTo>
                    <a:pt x="200" y="384"/>
                  </a:moveTo>
                  <a:lnTo>
                    <a:pt x="100" y="584"/>
                  </a:lnTo>
                  <a:lnTo>
                    <a:pt x="0" y="384"/>
                  </a:lnTo>
                  <a:lnTo>
                    <a:pt x="200" y="384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112"/>
            <p:cNvSpPr/>
            <p:nvPr/>
          </p:nvSpPr>
          <p:spPr>
            <a:xfrm>
              <a:off x="7605360" y="4253760"/>
              <a:ext cx="65520" cy="257040"/>
            </a:xfrm>
            <a:custGeom>
              <a:avLst/>
              <a:gdLst>
                <a:gd name="textAreaLeft" fmla="*/ 0 w 65520"/>
                <a:gd name="textAreaRight" fmla="*/ 65880 w 6552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200" h="775">
                  <a:moveTo>
                    <a:pt x="116" y="16"/>
                  </a:moveTo>
                  <a:lnTo>
                    <a:pt x="116" y="608"/>
                  </a:lnTo>
                  <a:cubicBezTo>
                    <a:pt x="116" y="617"/>
                    <a:pt x="109" y="625"/>
                    <a:pt x="100" y="625"/>
                  </a:cubicBezTo>
                  <a:cubicBezTo>
                    <a:pt x="91" y="625"/>
                    <a:pt x="83" y="617"/>
                    <a:pt x="83" y="608"/>
                  </a:cubicBezTo>
                  <a:lnTo>
                    <a:pt x="83" y="16"/>
                  </a:lnTo>
                  <a:cubicBezTo>
                    <a:pt x="83" y="7"/>
                    <a:pt x="91" y="0"/>
                    <a:pt x="100" y="0"/>
                  </a:cubicBezTo>
                  <a:cubicBezTo>
                    <a:pt x="109" y="0"/>
                    <a:pt x="116" y="7"/>
                    <a:pt x="116" y="16"/>
                  </a:cubicBezTo>
                  <a:close/>
                  <a:moveTo>
                    <a:pt x="200" y="575"/>
                  </a:moveTo>
                  <a:lnTo>
                    <a:pt x="100" y="775"/>
                  </a:lnTo>
                  <a:lnTo>
                    <a:pt x="0" y="575"/>
                  </a:lnTo>
                  <a:lnTo>
                    <a:pt x="200" y="575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6" name="Group 115"/>
            <p:cNvGrpSpPr/>
            <p:nvPr/>
          </p:nvGrpSpPr>
          <p:grpSpPr>
            <a:xfrm>
              <a:off x="6260400" y="135000"/>
              <a:ext cx="187560" cy="120240"/>
              <a:chOff x="6260400" y="135000"/>
              <a:chExt cx="187560" cy="120240"/>
            </a:xfrm>
          </p:grpSpPr>
          <p:sp>
            <p:nvSpPr>
              <p:cNvPr id="157" name="Rectangle 113"/>
              <p:cNvSpPr/>
              <p:nvPr/>
            </p:nvSpPr>
            <p:spPr>
              <a:xfrm>
                <a:off x="6260400" y="135000"/>
                <a:ext cx="187560" cy="120240"/>
              </a:xfrm>
              <a:prstGeom prst="rect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Rectangle 114"/>
              <p:cNvSpPr/>
              <p:nvPr/>
            </p:nvSpPr>
            <p:spPr>
              <a:xfrm>
                <a:off x="6260400" y="135000"/>
                <a:ext cx="187560" cy="120240"/>
              </a:xfrm>
              <a:prstGeom prst="rect">
                <a:avLst/>
              </a:prstGeom>
              <a:noFill/>
              <a:ln cap="rnd"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9" name="Group 118"/>
            <p:cNvGrpSpPr/>
            <p:nvPr/>
          </p:nvGrpSpPr>
          <p:grpSpPr>
            <a:xfrm>
              <a:off x="6260400" y="316440"/>
              <a:ext cx="187560" cy="123480"/>
              <a:chOff x="6260400" y="316440"/>
              <a:chExt cx="187560" cy="123480"/>
            </a:xfrm>
          </p:grpSpPr>
          <p:sp>
            <p:nvSpPr>
              <p:cNvPr id="160" name="Rectangle 116"/>
              <p:cNvSpPr/>
              <p:nvPr/>
            </p:nvSpPr>
            <p:spPr>
              <a:xfrm>
                <a:off x="6260400" y="316440"/>
                <a:ext cx="187560" cy="122040"/>
              </a:xfrm>
              <a:prstGeom prst="rect">
                <a:avLst/>
              </a:prstGeom>
              <a:solidFill>
                <a:srgbClr val="ff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Rectangle 117"/>
              <p:cNvSpPr/>
              <p:nvPr/>
            </p:nvSpPr>
            <p:spPr>
              <a:xfrm>
                <a:off x="6260400" y="317880"/>
                <a:ext cx="187560" cy="122040"/>
              </a:xfrm>
              <a:prstGeom prst="rect">
                <a:avLst/>
              </a:prstGeom>
              <a:noFill/>
              <a:ln cap="rnd"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2" name="Rectangle 130"/>
            <p:cNvSpPr/>
            <p:nvPr/>
          </p:nvSpPr>
          <p:spPr>
            <a:xfrm>
              <a:off x="6197760" y="44280"/>
              <a:ext cx="2334600" cy="1160280"/>
            </a:xfrm>
            <a:prstGeom prst="rect">
              <a:avLst/>
            </a:prstGeom>
            <a:noFill/>
            <a:ln cap="rnd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3" name="Group 133"/>
            <p:cNvGrpSpPr/>
            <p:nvPr/>
          </p:nvGrpSpPr>
          <p:grpSpPr>
            <a:xfrm>
              <a:off x="6260400" y="524880"/>
              <a:ext cx="187560" cy="133920"/>
              <a:chOff x="6260400" y="524880"/>
              <a:chExt cx="187560" cy="133920"/>
            </a:xfrm>
          </p:grpSpPr>
          <p:sp>
            <p:nvSpPr>
              <p:cNvPr id="164" name="Rectangle 131"/>
              <p:cNvSpPr/>
              <p:nvPr/>
            </p:nvSpPr>
            <p:spPr>
              <a:xfrm>
                <a:off x="6260400" y="535680"/>
                <a:ext cx="187560" cy="123120"/>
              </a:xfrm>
              <a:prstGeom prst="rect">
                <a:avLst/>
              </a:prstGeom>
              <a:solidFill>
                <a:srgbClr val="99cc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Rectangle 132"/>
              <p:cNvSpPr/>
              <p:nvPr/>
            </p:nvSpPr>
            <p:spPr>
              <a:xfrm>
                <a:off x="6260400" y="524880"/>
                <a:ext cx="187560" cy="123120"/>
              </a:xfrm>
              <a:prstGeom prst="rect">
                <a:avLst/>
              </a:prstGeom>
              <a:noFill/>
              <a:ln cap="rnd"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6" name="Group 136"/>
            <p:cNvGrpSpPr/>
            <p:nvPr/>
          </p:nvGrpSpPr>
          <p:grpSpPr>
            <a:xfrm>
              <a:off x="6260400" y="769320"/>
              <a:ext cx="189360" cy="120240"/>
              <a:chOff x="6260400" y="769320"/>
              <a:chExt cx="189360" cy="120240"/>
            </a:xfrm>
          </p:grpSpPr>
          <p:sp>
            <p:nvSpPr>
              <p:cNvPr id="167" name="Rectangle 134"/>
              <p:cNvSpPr/>
              <p:nvPr/>
            </p:nvSpPr>
            <p:spPr>
              <a:xfrm>
                <a:off x="6260400" y="769320"/>
                <a:ext cx="189360" cy="12024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Rectangle 135"/>
              <p:cNvSpPr/>
              <p:nvPr/>
            </p:nvSpPr>
            <p:spPr>
              <a:xfrm>
                <a:off x="6260400" y="769320"/>
                <a:ext cx="189360" cy="120240"/>
              </a:xfrm>
              <a:prstGeom prst="rect">
                <a:avLst/>
              </a:prstGeom>
              <a:noFill/>
              <a:ln cap="rnd"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9" name="Rectangle 137"/>
            <p:cNvSpPr/>
            <p:nvPr/>
          </p:nvSpPr>
          <p:spPr>
            <a:xfrm>
              <a:off x="6615720" y="750600"/>
              <a:ext cx="146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138"/>
            <p:cNvSpPr/>
            <p:nvPr/>
          </p:nvSpPr>
          <p:spPr>
            <a:xfrm>
              <a:off x="6784200" y="750600"/>
              <a:ext cx="386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specifi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139"/>
            <p:cNvSpPr/>
            <p:nvPr/>
          </p:nvSpPr>
          <p:spPr>
            <a:xfrm>
              <a:off x="7160760" y="750600"/>
              <a:ext cx="1670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or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140"/>
            <p:cNvSpPr/>
            <p:nvPr/>
          </p:nvSpPr>
          <p:spPr>
            <a:xfrm>
              <a:off x="7336440" y="750600"/>
              <a:ext cx="506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nhance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141"/>
            <p:cNvSpPr/>
            <p:nvPr/>
          </p:nvSpPr>
          <p:spPr>
            <a:xfrm>
              <a:off x="7855920" y="750600"/>
              <a:ext cx="5385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repression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4" name="Group 149"/>
            <p:cNvGrpSpPr/>
            <p:nvPr/>
          </p:nvGrpSpPr>
          <p:grpSpPr>
            <a:xfrm>
              <a:off x="6260400" y="994680"/>
              <a:ext cx="193680" cy="127800"/>
              <a:chOff x="6260400" y="994680"/>
              <a:chExt cx="193680" cy="127800"/>
            </a:xfrm>
          </p:grpSpPr>
          <p:sp>
            <p:nvSpPr>
              <p:cNvPr id="175" name="Rectangle 147"/>
              <p:cNvSpPr/>
              <p:nvPr/>
            </p:nvSpPr>
            <p:spPr>
              <a:xfrm>
                <a:off x="6264720" y="1000440"/>
                <a:ext cx="189360" cy="122040"/>
              </a:xfrm>
              <a:prstGeom prst="rect">
                <a:avLst/>
              </a:prstGeom>
              <a:solidFill>
                <a:srgbClr val="33339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Rectangle 148"/>
              <p:cNvSpPr/>
              <p:nvPr/>
            </p:nvSpPr>
            <p:spPr>
              <a:xfrm>
                <a:off x="6260400" y="994680"/>
                <a:ext cx="189360" cy="122040"/>
              </a:xfrm>
              <a:prstGeom prst="rect">
                <a:avLst/>
              </a:prstGeom>
              <a:noFill/>
              <a:ln cap="rnd"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7" name="Rectangle 150"/>
            <p:cNvSpPr/>
            <p:nvPr/>
          </p:nvSpPr>
          <p:spPr>
            <a:xfrm>
              <a:off x="6615000" y="99936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2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Rectangle 151"/>
            <p:cNvSpPr/>
            <p:nvPr/>
          </p:nvSpPr>
          <p:spPr>
            <a:xfrm>
              <a:off x="6768000" y="99180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–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152"/>
            <p:cNvSpPr/>
            <p:nvPr/>
          </p:nvSpPr>
          <p:spPr>
            <a:xfrm>
              <a:off x="6856560" y="999360"/>
              <a:ext cx="386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specifi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Rectangle 153"/>
            <p:cNvSpPr/>
            <p:nvPr/>
          </p:nvSpPr>
          <p:spPr>
            <a:xfrm>
              <a:off x="7309080" y="999360"/>
              <a:ext cx="1350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or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154"/>
            <p:cNvSpPr/>
            <p:nvPr/>
          </p:nvSpPr>
          <p:spPr>
            <a:xfrm>
              <a:off x="7437960" y="999360"/>
              <a:ext cx="506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nhance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Rectangle 155"/>
            <p:cNvSpPr/>
            <p:nvPr/>
          </p:nvSpPr>
          <p:spPr>
            <a:xfrm>
              <a:off x="7982640" y="999360"/>
              <a:ext cx="49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induction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156"/>
            <p:cNvSpPr/>
            <p:nvPr/>
          </p:nvSpPr>
          <p:spPr>
            <a:xfrm>
              <a:off x="7875000" y="1417320"/>
              <a:ext cx="436680" cy="6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Freeform 162"/>
            <p:cNvSpPr/>
            <p:nvPr/>
          </p:nvSpPr>
          <p:spPr>
            <a:xfrm>
              <a:off x="6950880" y="1674720"/>
              <a:ext cx="1377720" cy="3384000"/>
            </a:xfrm>
            <a:custGeom>
              <a:avLst/>
              <a:gdLst>
                <a:gd name="textAreaLeft" fmla="*/ 0 w 1377720"/>
                <a:gd name="textAreaRight" fmla="*/ 1378080 w 1377720"/>
                <a:gd name="textAreaTop" fmla="*/ 0 h 3384000"/>
                <a:gd name="textAreaBottom" fmla="*/ 3384360 h 3384000"/>
              </a:gdLst>
              <a:ahLst/>
              <a:rect l="textAreaLeft" t="textAreaTop" r="textAreaRight" b="textAreaBottom"/>
              <a:pathLst>
                <a:path w="4158" h="10208">
                  <a:moveTo>
                    <a:pt x="693" y="0"/>
                  </a:moveTo>
                  <a:cubicBezTo>
                    <a:pt x="310" y="0"/>
                    <a:pt x="0" y="310"/>
                    <a:pt x="0" y="693"/>
                  </a:cubicBezTo>
                  <a:lnTo>
                    <a:pt x="0" y="9515"/>
                  </a:lnTo>
                  <a:cubicBezTo>
                    <a:pt x="0" y="9898"/>
                    <a:pt x="310" y="10208"/>
                    <a:pt x="693" y="10208"/>
                  </a:cubicBezTo>
                  <a:lnTo>
                    <a:pt x="3465" y="10208"/>
                  </a:lnTo>
                  <a:cubicBezTo>
                    <a:pt x="3848" y="10208"/>
                    <a:pt x="4158" y="9898"/>
                    <a:pt x="4158" y="9515"/>
                  </a:cubicBezTo>
                  <a:lnTo>
                    <a:pt x="4158" y="693"/>
                  </a:lnTo>
                  <a:cubicBezTo>
                    <a:pt x="4158" y="310"/>
                    <a:pt x="3848" y="0"/>
                    <a:pt x="3465" y="0"/>
                  </a:cubicBezTo>
                  <a:lnTo>
                    <a:pt x="693" y="0"/>
                  </a:lnTo>
                  <a:close/>
                </a:path>
              </a:pathLst>
            </a:custGeom>
            <a:noFill/>
            <a:ln cap="rnd"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163"/>
            <p:cNvSpPr/>
            <p:nvPr/>
          </p:nvSpPr>
          <p:spPr>
            <a:xfrm>
              <a:off x="7098840" y="1751400"/>
              <a:ext cx="2599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JA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164"/>
            <p:cNvSpPr/>
            <p:nvPr/>
          </p:nvSpPr>
          <p:spPr>
            <a:xfrm>
              <a:off x="7345080" y="1751400"/>
              <a:ext cx="9853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biosynthesi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166"/>
            <p:cNvSpPr/>
            <p:nvPr/>
          </p:nvSpPr>
          <p:spPr>
            <a:xfrm>
              <a:off x="3128760" y="3013560"/>
              <a:ext cx="1080" cy="250200"/>
            </a:xfrm>
            <a:prstGeom prst="line">
              <a:avLst/>
            </a:prstGeom>
            <a:ln cap="rnd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Line 168"/>
            <p:cNvSpPr/>
            <p:nvPr/>
          </p:nvSpPr>
          <p:spPr>
            <a:xfrm>
              <a:off x="3128760" y="3013560"/>
              <a:ext cx="1080" cy="250200"/>
            </a:xfrm>
            <a:prstGeom prst="line">
              <a:avLst/>
            </a:prstGeom>
            <a:ln cap="rnd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169"/>
            <p:cNvSpPr/>
            <p:nvPr/>
          </p:nvSpPr>
          <p:spPr>
            <a:xfrm>
              <a:off x="3502800" y="2825640"/>
              <a:ext cx="563400" cy="2642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170"/>
            <p:cNvSpPr/>
            <p:nvPr/>
          </p:nvSpPr>
          <p:spPr>
            <a:xfrm>
              <a:off x="3642840" y="2875680"/>
              <a:ext cx="374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JAR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171"/>
            <p:cNvSpPr/>
            <p:nvPr/>
          </p:nvSpPr>
          <p:spPr>
            <a:xfrm>
              <a:off x="3502800" y="3201480"/>
              <a:ext cx="563400" cy="2642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172"/>
            <p:cNvSpPr/>
            <p:nvPr/>
          </p:nvSpPr>
          <p:spPr>
            <a:xfrm>
              <a:off x="3662640" y="3251520"/>
              <a:ext cx="333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SI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173"/>
            <p:cNvSpPr/>
            <p:nvPr/>
          </p:nvSpPr>
          <p:spPr>
            <a:xfrm>
              <a:off x="3189600" y="3702600"/>
              <a:ext cx="751320" cy="264240"/>
            </a:xfrm>
            <a:prstGeom prst="rect">
              <a:avLst/>
            </a:prstGeom>
            <a:solidFill>
              <a:srgbClr val="ff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174"/>
            <p:cNvSpPr/>
            <p:nvPr/>
          </p:nvSpPr>
          <p:spPr>
            <a:xfrm>
              <a:off x="3354480" y="3752640"/>
              <a:ext cx="52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RK7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Line 176"/>
            <p:cNvSpPr/>
            <p:nvPr/>
          </p:nvSpPr>
          <p:spPr>
            <a:xfrm flipV="1">
              <a:off x="4254480" y="3744360"/>
              <a:ext cx="1440" cy="187560"/>
            </a:xfrm>
            <a:prstGeom prst="line">
              <a:avLst/>
            </a:prstGeom>
            <a:ln cap="rnd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Line 177"/>
            <p:cNvSpPr/>
            <p:nvPr/>
          </p:nvSpPr>
          <p:spPr>
            <a:xfrm>
              <a:off x="3941280" y="3832560"/>
              <a:ext cx="312840" cy="1440"/>
            </a:xfrm>
            <a:prstGeom prst="line">
              <a:avLst/>
            </a:prstGeom>
            <a:ln cap="rnd"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Freeform 179"/>
            <p:cNvSpPr/>
            <p:nvPr/>
          </p:nvSpPr>
          <p:spPr>
            <a:xfrm>
              <a:off x="2935800" y="2444760"/>
              <a:ext cx="1448280" cy="2139120"/>
            </a:xfrm>
            <a:custGeom>
              <a:avLst/>
              <a:gdLst>
                <a:gd name="textAreaLeft" fmla="*/ 0 w 1448280"/>
                <a:gd name="textAreaRight" fmla="*/ 1448640 w 1448280"/>
                <a:gd name="textAreaTop" fmla="*/ 0 h 2139120"/>
                <a:gd name="textAreaBottom" fmla="*/ 2139480 h 2139120"/>
              </a:gdLst>
              <a:ahLst/>
              <a:rect l="textAreaLeft" t="textAreaTop" r="textAreaRight" b="textAreaBottom"/>
              <a:pathLst>
                <a:path w="8742" h="12900">
                  <a:moveTo>
                    <a:pt x="7219" y="50"/>
                  </a:moveTo>
                  <a:lnTo>
                    <a:pt x="7069" y="50"/>
                  </a:lnTo>
                  <a:cubicBezTo>
                    <a:pt x="7055" y="50"/>
                    <a:pt x="7044" y="39"/>
                    <a:pt x="7044" y="25"/>
                  </a:cubicBezTo>
                  <a:cubicBezTo>
                    <a:pt x="7044" y="11"/>
                    <a:pt x="7055" y="0"/>
                    <a:pt x="7069" y="0"/>
                  </a:cubicBezTo>
                  <a:lnTo>
                    <a:pt x="7219" y="0"/>
                  </a:lnTo>
                  <a:cubicBezTo>
                    <a:pt x="7233" y="0"/>
                    <a:pt x="7244" y="11"/>
                    <a:pt x="7244" y="25"/>
                  </a:cubicBezTo>
                  <a:cubicBezTo>
                    <a:pt x="7244" y="39"/>
                    <a:pt x="7233" y="50"/>
                    <a:pt x="7219" y="50"/>
                  </a:cubicBezTo>
                  <a:close/>
                  <a:moveTo>
                    <a:pt x="6869" y="50"/>
                  </a:moveTo>
                  <a:lnTo>
                    <a:pt x="6719" y="50"/>
                  </a:lnTo>
                  <a:cubicBezTo>
                    <a:pt x="6705" y="50"/>
                    <a:pt x="6694" y="39"/>
                    <a:pt x="6694" y="25"/>
                  </a:cubicBezTo>
                  <a:cubicBezTo>
                    <a:pt x="6694" y="11"/>
                    <a:pt x="6705" y="0"/>
                    <a:pt x="6719" y="0"/>
                  </a:cubicBezTo>
                  <a:lnTo>
                    <a:pt x="6869" y="0"/>
                  </a:lnTo>
                  <a:cubicBezTo>
                    <a:pt x="6883" y="0"/>
                    <a:pt x="6894" y="11"/>
                    <a:pt x="6894" y="25"/>
                  </a:cubicBezTo>
                  <a:cubicBezTo>
                    <a:pt x="6894" y="39"/>
                    <a:pt x="6883" y="50"/>
                    <a:pt x="6869" y="50"/>
                  </a:cubicBezTo>
                  <a:close/>
                  <a:moveTo>
                    <a:pt x="6519" y="50"/>
                  </a:moveTo>
                  <a:lnTo>
                    <a:pt x="6369" y="50"/>
                  </a:lnTo>
                  <a:cubicBezTo>
                    <a:pt x="6355" y="50"/>
                    <a:pt x="6344" y="39"/>
                    <a:pt x="6344" y="25"/>
                  </a:cubicBezTo>
                  <a:cubicBezTo>
                    <a:pt x="6344" y="11"/>
                    <a:pt x="6355" y="0"/>
                    <a:pt x="6369" y="0"/>
                  </a:cubicBezTo>
                  <a:lnTo>
                    <a:pt x="6519" y="0"/>
                  </a:lnTo>
                  <a:cubicBezTo>
                    <a:pt x="6533" y="0"/>
                    <a:pt x="6544" y="11"/>
                    <a:pt x="6544" y="25"/>
                  </a:cubicBezTo>
                  <a:cubicBezTo>
                    <a:pt x="6544" y="39"/>
                    <a:pt x="6533" y="50"/>
                    <a:pt x="6519" y="50"/>
                  </a:cubicBezTo>
                  <a:close/>
                  <a:moveTo>
                    <a:pt x="6169" y="50"/>
                  </a:moveTo>
                  <a:lnTo>
                    <a:pt x="6019" y="50"/>
                  </a:lnTo>
                  <a:cubicBezTo>
                    <a:pt x="6005" y="50"/>
                    <a:pt x="5994" y="39"/>
                    <a:pt x="5994" y="25"/>
                  </a:cubicBezTo>
                  <a:cubicBezTo>
                    <a:pt x="5994" y="11"/>
                    <a:pt x="6005" y="0"/>
                    <a:pt x="6019" y="0"/>
                  </a:cubicBezTo>
                  <a:lnTo>
                    <a:pt x="6169" y="0"/>
                  </a:lnTo>
                  <a:cubicBezTo>
                    <a:pt x="6183" y="0"/>
                    <a:pt x="6194" y="11"/>
                    <a:pt x="6194" y="25"/>
                  </a:cubicBezTo>
                  <a:cubicBezTo>
                    <a:pt x="6194" y="39"/>
                    <a:pt x="6183" y="50"/>
                    <a:pt x="6169" y="50"/>
                  </a:cubicBezTo>
                  <a:close/>
                  <a:moveTo>
                    <a:pt x="5819" y="50"/>
                  </a:moveTo>
                  <a:lnTo>
                    <a:pt x="5669" y="50"/>
                  </a:lnTo>
                  <a:cubicBezTo>
                    <a:pt x="5655" y="50"/>
                    <a:pt x="5644" y="39"/>
                    <a:pt x="5644" y="25"/>
                  </a:cubicBezTo>
                  <a:cubicBezTo>
                    <a:pt x="5644" y="11"/>
                    <a:pt x="5655" y="0"/>
                    <a:pt x="5669" y="0"/>
                  </a:cubicBezTo>
                  <a:lnTo>
                    <a:pt x="5819" y="0"/>
                  </a:lnTo>
                  <a:cubicBezTo>
                    <a:pt x="5833" y="0"/>
                    <a:pt x="5844" y="11"/>
                    <a:pt x="5844" y="25"/>
                  </a:cubicBezTo>
                  <a:cubicBezTo>
                    <a:pt x="5844" y="39"/>
                    <a:pt x="5833" y="50"/>
                    <a:pt x="5819" y="50"/>
                  </a:cubicBezTo>
                  <a:close/>
                  <a:moveTo>
                    <a:pt x="5469" y="50"/>
                  </a:moveTo>
                  <a:lnTo>
                    <a:pt x="5319" y="50"/>
                  </a:lnTo>
                  <a:cubicBezTo>
                    <a:pt x="5305" y="50"/>
                    <a:pt x="5294" y="39"/>
                    <a:pt x="5294" y="25"/>
                  </a:cubicBezTo>
                  <a:cubicBezTo>
                    <a:pt x="5294" y="11"/>
                    <a:pt x="5305" y="0"/>
                    <a:pt x="5319" y="0"/>
                  </a:cubicBezTo>
                  <a:lnTo>
                    <a:pt x="5469" y="0"/>
                  </a:lnTo>
                  <a:cubicBezTo>
                    <a:pt x="5483" y="0"/>
                    <a:pt x="5494" y="11"/>
                    <a:pt x="5494" y="25"/>
                  </a:cubicBezTo>
                  <a:cubicBezTo>
                    <a:pt x="5494" y="39"/>
                    <a:pt x="5483" y="50"/>
                    <a:pt x="5469" y="50"/>
                  </a:cubicBezTo>
                  <a:close/>
                  <a:moveTo>
                    <a:pt x="5119" y="50"/>
                  </a:moveTo>
                  <a:lnTo>
                    <a:pt x="4969" y="50"/>
                  </a:lnTo>
                  <a:cubicBezTo>
                    <a:pt x="4955" y="50"/>
                    <a:pt x="4944" y="39"/>
                    <a:pt x="4944" y="25"/>
                  </a:cubicBezTo>
                  <a:cubicBezTo>
                    <a:pt x="4944" y="11"/>
                    <a:pt x="4955" y="0"/>
                    <a:pt x="4969" y="0"/>
                  </a:cubicBezTo>
                  <a:lnTo>
                    <a:pt x="5119" y="0"/>
                  </a:lnTo>
                  <a:cubicBezTo>
                    <a:pt x="5133" y="0"/>
                    <a:pt x="5144" y="11"/>
                    <a:pt x="5144" y="25"/>
                  </a:cubicBezTo>
                  <a:cubicBezTo>
                    <a:pt x="5144" y="39"/>
                    <a:pt x="5133" y="50"/>
                    <a:pt x="5119" y="50"/>
                  </a:cubicBezTo>
                  <a:close/>
                  <a:moveTo>
                    <a:pt x="4769" y="50"/>
                  </a:moveTo>
                  <a:lnTo>
                    <a:pt x="4619" y="50"/>
                  </a:lnTo>
                  <a:cubicBezTo>
                    <a:pt x="4605" y="50"/>
                    <a:pt x="4594" y="39"/>
                    <a:pt x="4594" y="25"/>
                  </a:cubicBezTo>
                  <a:cubicBezTo>
                    <a:pt x="4594" y="11"/>
                    <a:pt x="4605" y="0"/>
                    <a:pt x="4619" y="0"/>
                  </a:cubicBezTo>
                  <a:lnTo>
                    <a:pt x="4769" y="0"/>
                  </a:lnTo>
                  <a:cubicBezTo>
                    <a:pt x="4783" y="0"/>
                    <a:pt x="4794" y="11"/>
                    <a:pt x="4794" y="25"/>
                  </a:cubicBezTo>
                  <a:cubicBezTo>
                    <a:pt x="4794" y="39"/>
                    <a:pt x="4783" y="50"/>
                    <a:pt x="4769" y="50"/>
                  </a:cubicBezTo>
                  <a:close/>
                  <a:moveTo>
                    <a:pt x="4419" y="50"/>
                  </a:moveTo>
                  <a:lnTo>
                    <a:pt x="4269" y="50"/>
                  </a:lnTo>
                  <a:cubicBezTo>
                    <a:pt x="4255" y="50"/>
                    <a:pt x="4244" y="39"/>
                    <a:pt x="4244" y="25"/>
                  </a:cubicBezTo>
                  <a:cubicBezTo>
                    <a:pt x="4244" y="11"/>
                    <a:pt x="4255" y="0"/>
                    <a:pt x="4269" y="0"/>
                  </a:cubicBezTo>
                  <a:lnTo>
                    <a:pt x="4419" y="0"/>
                  </a:lnTo>
                  <a:cubicBezTo>
                    <a:pt x="4433" y="0"/>
                    <a:pt x="4444" y="11"/>
                    <a:pt x="4444" y="25"/>
                  </a:cubicBezTo>
                  <a:cubicBezTo>
                    <a:pt x="4444" y="39"/>
                    <a:pt x="4433" y="50"/>
                    <a:pt x="4419" y="50"/>
                  </a:cubicBezTo>
                  <a:close/>
                  <a:moveTo>
                    <a:pt x="4069" y="50"/>
                  </a:moveTo>
                  <a:lnTo>
                    <a:pt x="3919" y="50"/>
                  </a:lnTo>
                  <a:cubicBezTo>
                    <a:pt x="3905" y="50"/>
                    <a:pt x="3894" y="39"/>
                    <a:pt x="3894" y="25"/>
                  </a:cubicBezTo>
                  <a:cubicBezTo>
                    <a:pt x="3894" y="11"/>
                    <a:pt x="3905" y="0"/>
                    <a:pt x="3919" y="0"/>
                  </a:cubicBezTo>
                  <a:lnTo>
                    <a:pt x="4069" y="0"/>
                  </a:lnTo>
                  <a:cubicBezTo>
                    <a:pt x="4083" y="0"/>
                    <a:pt x="4094" y="11"/>
                    <a:pt x="4094" y="25"/>
                  </a:cubicBezTo>
                  <a:cubicBezTo>
                    <a:pt x="4094" y="39"/>
                    <a:pt x="4083" y="50"/>
                    <a:pt x="4069" y="50"/>
                  </a:cubicBezTo>
                  <a:close/>
                  <a:moveTo>
                    <a:pt x="3719" y="50"/>
                  </a:moveTo>
                  <a:lnTo>
                    <a:pt x="3569" y="50"/>
                  </a:lnTo>
                  <a:cubicBezTo>
                    <a:pt x="3555" y="50"/>
                    <a:pt x="3544" y="39"/>
                    <a:pt x="3544" y="25"/>
                  </a:cubicBezTo>
                  <a:cubicBezTo>
                    <a:pt x="3544" y="11"/>
                    <a:pt x="3555" y="0"/>
                    <a:pt x="3569" y="0"/>
                  </a:cubicBezTo>
                  <a:lnTo>
                    <a:pt x="3719" y="0"/>
                  </a:lnTo>
                  <a:cubicBezTo>
                    <a:pt x="3733" y="0"/>
                    <a:pt x="3744" y="11"/>
                    <a:pt x="3744" y="25"/>
                  </a:cubicBezTo>
                  <a:cubicBezTo>
                    <a:pt x="3744" y="39"/>
                    <a:pt x="3733" y="50"/>
                    <a:pt x="3719" y="50"/>
                  </a:cubicBezTo>
                  <a:close/>
                  <a:moveTo>
                    <a:pt x="3369" y="50"/>
                  </a:moveTo>
                  <a:lnTo>
                    <a:pt x="3219" y="50"/>
                  </a:lnTo>
                  <a:cubicBezTo>
                    <a:pt x="3205" y="50"/>
                    <a:pt x="3194" y="39"/>
                    <a:pt x="3194" y="25"/>
                  </a:cubicBezTo>
                  <a:cubicBezTo>
                    <a:pt x="3194" y="11"/>
                    <a:pt x="3205" y="0"/>
                    <a:pt x="3219" y="0"/>
                  </a:cubicBezTo>
                  <a:lnTo>
                    <a:pt x="3369" y="0"/>
                  </a:lnTo>
                  <a:cubicBezTo>
                    <a:pt x="3383" y="0"/>
                    <a:pt x="3394" y="11"/>
                    <a:pt x="3394" y="25"/>
                  </a:cubicBezTo>
                  <a:cubicBezTo>
                    <a:pt x="3394" y="39"/>
                    <a:pt x="3383" y="50"/>
                    <a:pt x="3369" y="50"/>
                  </a:cubicBezTo>
                  <a:close/>
                  <a:moveTo>
                    <a:pt x="3019" y="50"/>
                  </a:moveTo>
                  <a:lnTo>
                    <a:pt x="2869" y="50"/>
                  </a:lnTo>
                  <a:cubicBezTo>
                    <a:pt x="2855" y="50"/>
                    <a:pt x="2844" y="39"/>
                    <a:pt x="2844" y="25"/>
                  </a:cubicBezTo>
                  <a:cubicBezTo>
                    <a:pt x="2844" y="11"/>
                    <a:pt x="2855" y="0"/>
                    <a:pt x="2869" y="0"/>
                  </a:cubicBezTo>
                  <a:lnTo>
                    <a:pt x="3019" y="0"/>
                  </a:lnTo>
                  <a:cubicBezTo>
                    <a:pt x="3033" y="0"/>
                    <a:pt x="3044" y="11"/>
                    <a:pt x="3044" y="25"/>
                  </a:cubicBezTo>
                  <a:cubicBezTo>
                    <a:pt x="3044" y="39"/>
                    <a:pt x="3033" y="50"/>
                    <a:pt x="3019" y="50"/>
                  </a:cubicBezTo>
                  <a:close/>
                  <a:moveTo>
                    <a:pt x="2669" y="50"/>
                  </a:moveTo>
                  <a:lnTo>
                    <a:pt x="2519" y="50"/>
                  </a:lnTo>
                  <a:cubicBezTo>
                    <a:pt x="2505" y="50"/>
                    <a:pt x="2494" y="39"/>
                    <a:pt x="2494" y="25"/>
                  </a:cubicBezTo>
                  <a:cubicBezTo>
                    <a:pt x="2494" y="11"/>
                    <a:pt x="2505" y="0"/>
                    <a:pt x="2519" y="0"/>
                  </a:cubicBezTo>
                  <a:lnTo>
                    <a:pt x="2669" y="0"/>
                  </a:lnTo>
                  <a:cubicBezTo>
                    <a:pt x="2683" y="0"/>
                    <a:pt x="2694" y="11"/>
                    <a:pt x="2694" y="25"/>
                  </a:cubicBezTo>
                  <a:cubicBezTo>
                    <a:pt x="2694" y="39"/>
                    <a:pt x="2683" y="50"/>
                    <a:pt x="2669" y="50"/>
                  </a:cubicBezTo>
                  <a:close/>
                  <a:moveTo>
                    <a:pt x="2319" y="50"/>
                  </a:moveTo>
                  <a:lnTo>
                    <a:pt x="2169" y="50"/>
                  </a:lnTo>
                  <a:cubicBezTo>
                    <a:pt x="2155" y="50"/>
                    <a:pt x="2144" y="39"/>
                    <a:pt x="2144" y="25"/>
                  </a:cubicBezTo>
                  <a:cubicBezTo>
                    <a:pt x="2144" y="11"/>
                    <a:pt x="2155" y="0"/>
                    <a:pt x="2169" y="0"/>
                  </a:cubicBezTo>
                  <a:lnTo>
                    <a:pt x="2319" y="0"/>
                  </a:lnTo>
                  <a:cubicBezTo>
                    <a:pt x="2333" y="0"/>
                    <a:pt x="2344" y="11"/>
                    <a:pt x="2344" y="25"/>
                  </a:cubicBezTo>
                  <a:cubicBezTo>
                    <a:pt x="2344" y="39"/>
                    <a:pt x="2333" y="50"/>
                    <a:pt x="2319" y="50"/>
                  </a:cubicBezTo>
                  <a:close/>
                  <a:moveTo>
                    <a:pt x="1969" y="50"/>
                  </a:moveTo>
                  <a:lnTo>
                    <a:pt x="1819" y="50"/>
                  </a:lnTo>
                  <a:cubicBezTo>
                    <a:pt x="1805" y="50"/>
                    <a:pt x="1794" y="39"/>
                    <a:pt x="1794" y="25"/>
                  </a:cubicBezTo>
                  <a:cubicBezTo>
                    <a:pt x="1794" y="11"/>
                    <a:pt x="1805" y="0"/>
                    <a:pt x="1819" y="0"/>
                  </a:cubicBezTo>
                  <a:lnTo>
                    <a:pt x="1969" y="0"/>
                  </a:lnTo>
                  <a:cubicBezTo>
                    <a:pt x="1983" y="0"/>
                    <a:pt x="1994" y="11"/>
                    <a:pt x="1994" y="25"/>
                  </a:cubicBezTo>
                  <a:cubicBezTo>
                    <a:pt x="1994" y="39"/>
                    <a:pt x="1983" y="50"/>
                    <a:pt x="1969" y="50"/>
                  </a:cubicBezTo>
                  <a:close/>
                  <a:moveTo>
                    <a:pt x="1619" y="50"/>
                  </a:moveTo>
                  <a:lnTo>
                    <a:pt x="1474" y="50"/>
                  </a:lnTo>
                  <a:lnTo>
                    <a:pt x="1470" y="50"/>
                  </a:lnTo>
                  <a:cubicBezTo>
                    <a:pt x="1456" y="50"/>
                    <a:pt x="1444" y="40"/>
                    <a:pt x="1444" y="26"/>
                  </a:cubicBezTo>
                  <a:cubicBezTo>
                    <a:pt x="1444" y="12"/>
                    <a:pt x="1454" y="0"/>
                    <a:pt x="1468" y="0"/>
                  </a:cubicBezTo>
                  <a:lnTo>
                    <a:pt x="1474" y="0"/>
                  </a:lnTo>
                  <a:lnTo>
                    <a:pt x="1619" y="0"/>
                  </a:lnTo>
                  <a:cubicBezTo>
                    <a:pt x="1633" y="0"/>
                    <a:pt x="1644" y="11"/>
                    <a:pt x="1644" y="25"/>
                  </a:cubicBezTo>
                  <a:cubicBezTo>
                    <a:pt x="1644" y="39"/>
                    <a:pt x="1633" y="50"/>
                    <a:pt x="1619" y="50"/>
                  </a:cubicBezTo>
                  <a:close/>
                  <a:moveTo>
                    <a:pt x="1273" y="64"/>
                  </a:moveTo>
                  <a:lnTo>
                    <a:pt x="1257" y="66"/>
                  </a:lnTo>
                  <a:lnTo>
                    <a:pt x="1187" y="79"/>
                  </a:lnTo>
                  <a:lnTo>
                    <a:pt x="1128" y="93"/>
                  </a:lnTo>
                  <a:cubicBezTo>
                    <a:pt x="1115" y="96"/>
                    <a:pt x="1101" y="87"/>
                    <a:pt x="1098" y="74"/>
                  </a:cubicBezTo>
                  <a:cubicBezTo>
                    <a:pt x="1095" y="60"/>
                    <a:pt x="1103" y="47"/>
                    <a:pt x="1117" y="44"/>
                  </a:cubicBezTo>
                  <a:lnTo>
                    <a:pt x="1178" y="30"/>
                  </a:lnTo>
                  <a:lnTo>
                    <a:pt x="1251" y="17"/>
                  </a:lnTo>
                  <a:lnTo>
                    <a:pt x="1267" y="15"/>
                  </a:lnTo>
                  <a:cubicBezTo>
                    <a:pt x="1280" y="13"/>
                    <a:pt x="1293" y="23"/>
                    <a:pt x="1294" y="36"/>
                  </a:cubicBezTo>
                  <a:cubicBezTo>
                    <a:pt x="1296" y="50"/>
                    <a:pt x="1286" y="63"/>
                    <a:pt x="1273" y="64"/>
                  </a:cubicBezTo>
                  <a:close/>
                  <a:moveTo>
                    <a:pt x="942" y="154"/>
                  </a:moveTo>
                  <a:lnTo>
                    <a:pt x="920" y="162"/>
                  </a:lnTo>
                  <a:lnTo>
                    <a:pt x="857" y="191"/>
                  </a:lnTo>
                  <a:lnTo>
                    <a:pt x="808" y="216"/>
                  </a:lnTo>
                  <a:cubicBezTo>
                    <a:pt x="796" y="222"/>
                    <a:pt x="781" y="217"/>
                    <a:pt x="774" y="205"/>
                  </a:cubicBezTo>
                  <a:cubicBezTo>
                    <a:pt x="768" y="193"/>
                    <a:pt x="773" y="178"/>
                    <a:pt x="785" y="171"/>
                  </a:cubicBezTo>
                  <a:lnTo>
                    <a:pt x="836" y="145"/>
                  </a:lnTo>
                  <a:lnTo>
                    <a:pt x="901" y="116"/>
                  </a:lnTo>
                  <a:lnTo>
                    <a:pt x="923" y="107"/>
                  </a:lnTo>
                  <a:cubicBezTo>
                    <a:pt x="936" y="102"/>
                    <a:pt x="951" y="108"/>
                    <a:pt x="956" y="121"/>
                  </a:cubicBezTo>
                  <a:cubicBezTo>
                    <a:pt x="961" y="134"/>
                    <a:pt x="955" y="148"/>
                    <a:pt x="942" y="154"/>
                  </a:cubicBezTo>
                  <a:close/>
                  <a:moveTo>
                    <a:pt x="643" y="320"/>
                  </a:moveTo>
                  <a:lnTo>
                    <a:pt x="568" y="376"/>
                  </a:lnTo>
                  <a:lnTo>
                    <a:pt x="528" y="413"/>
                  </a:lnTo>
                  <a:cubicBezTo>
                    <a:pt x="518" y="422"/>
                    <a:pt x="502" y="421"/>
                    <a:pt x="492" y="411"/>
                  </a:cubicBezTo>
                  <a:cubicBezTo>
                    <a:pt x="483" y="401"/>
                    <a:pt x="484" y="385"/>
                    <a:pt x="494" y="376"/>
                  </a:cubicBezTo>
                  <a:lnTo>
                    <a:pt x="538" y="336"/>
                  </a:lnTo>
                  <a:lnTo>
                    <a:pt x="613" y="280"/>
                  </a:lnTo>
                  <a:cubicBezTo>
                    <a:pt x="624" y="272"/>
                    <a:pt x="639" y="274"/>
                    <a:pt x="648" y="285"/>
                  </a:cubicBezTo>
                  <a:cubicBezTo>
                    <a:pt x="656" y="296"/>
                    <a:pt x="654" y="312"/>
                    <a:pt x="643" y="320"/>
                  </a:cubicBezTo>
                  <a:close/>
                  <a:moveTo>
                    <a:pt x="389" y="553"/>
                  </a:moveTo>
                  <a:lnTo>
                    <a:pt x="375" y="569"/>
                  </a:lnTo>
                  <a:lnTo>
                    <a:pt x="299" y="670"/>
                  </a:lnTo>
                  <a:cubicBezTo>
                    <a:pt x="291" y="681"/>
                    <a:pt x="275" y="683"/>
                    <a:pt x="264" y="675"/>
                  </a:cubicBezTo>
                  <a:cubicBezTo>
                    <a:pt x="253" y="667"/>
                    <a:pt x="251" y="651"/>
                    <a:pt x="259" y="640"/>
                  </a:cubicBezTo>
                  <a:lnTo>
                    <a:pt x="338" y="535"/>
                  </a:lnTo>
                  <a:lnTo>
                    <a:pt x="352" y="519"/>
                  </a:lnTo>
                  <a:cubicBezTo>
                    <a:pt x="362" y="509"/>
                    <a:pt x="377" y="509"/>
                    <a:pt x="388" y="518"/>
                  </a:cubicBezTo>
                  <a:cubicBezTo>
                    <a:pt x="398" y="527"/>
                    <a:pt x="398" y="543"/>
                    <a:pt x="389" y="553"/>
                  </a:cubicBezTo>
                  <a:close/>
                  <a:moveTo>
                    <a:pt x="200" y="839"/>
                  </a:moveTo>
                  <a:lnTo>
                    <a:pt x="191" y="857"/>
                  </a:lnTo>
                  <a:lnTo>
                    <a:pt x="162" y="920"/>
                  </a:lnTo>
                  <a:lnTo>
                    <a:pt x="141" y="974"/>
                  </a:lnTo>
                  <a:cubicBezTo>
                    <a:pt x="136" y="987"/>
                    <a:pt x="121" y="993"/>
                    <a:pt x="109" y="988"/>
                  </a:cubicBezTo>
                  <a:cubicBezTo>
                    <a:pt x="96" y="983"/>
                    <a:pt x="89" y="968"/>
                    <a:pt x="94" y="955"/>
                  </a:cubicBezTo>
                  <a:lnTo>
                    <a:pt x="117" y="899"/>
                  </a:lnTo>
                  <a:lnTo>
                    <a:pt x="146" y="834"/>
                  </a:lnTo>
                  <a:lnTo>
                    <a:pt x="156" y="816"/>
                  </a:lnTo>
                  <a:cubicBezTo>
                    <a:pt x="162" y="804"/>
                    <a:pt x="177" y="799"/>
                    <a:pt x="189" y="805"/>
                  </a:cubicBezTo>
                  <a:cubicBezTo>
                    <a:pt x="201" y="811"/>
                    <a:pt x="206" y="826"/>
                    <a:pt x="200" y="839"/>
                  </a:cubicBezTo>
                  <a:close/>
                  <a:moveTo>
                    <a:pt x="85" y="1162"/>
                  </a:moveTo>
                  <a:lnTo>
                    <a:pt x="79" y="1187"/>
                  </a:lnTo>
                  <a:lnTo>
                    <a:pt x="67" y="1257"/>
                  </a:lnTo>
                  <a:lnTo>
                    <a:pt x="60" y="1307"/>
                  </a:lnTo>
                  <a:cubicBezTo>
                    <a:pt x="59" y="1321"/>
                    <a:pt x="46" y="1330"/>
                    <a:pt x="33" y="1329"/>
                  </a:cubicBezTo>
                  <a:cubicBezTo>
                    <a:pt x="19" y="1327"/>
                    <a:pt x="9" y="1315"/>
                    <a:pt x="11" y="1301"/>
                  </a:cubicBezTo>
                  <a:lnTo>
                    <a:pt x="17" y="1248"/>
                  </a:lnTo>
                  <a:lnTo>
                    <a:pt x="31" y="1176"/>
                  </a:lnTo>
                  <a:lnTo>
                    <a:pt x="36" y="1151"/>
                  </a:lnTo>
                  <a:cubicBezTo>
                    <a:pt x="39" y="1137"/>
                    <a:pt x="53" y="1129"/>
                    <a:pt x="66" y="1132"/>
                  </a:cubicBezTo>
                  <a:cubicBezTo>
                    <a:pt x="80" y="1135"/>
                    <a:pt x="88" y="1148"/>
                    <a:pt x="85" y="1162"/>
                  </a:cubicBezTo>
                  <a:close/>
                  <a:moveTo>
                    <a:pt x="50" y="1504"/>
                  </a:moveTo>
                  <a:lnTo>
                    <a:pt x="50" y="1654"/>
                  </a:lnTo>
                  <a:cubicBezTo>
                    <a:pt x="50" y="1667"/>
                    <a:pt x="39" y="1679"/>
                    <a:pt x="25" y="1679"/>
                  </a:cubicBezTo>
                  <a:cubicBezTo>
                    <a:pt x="12" y="1679"/>
                    <a:pt x="0" y="1667"/>
                    <a:pt x="0" y="1654"/>
                  </a:cubicBezTo>
                  <a:lnTo>
                    <a:pt x="0" y="1504"/>
                  </a:lnTo>
                  <a:cubicBezTo>
                    <a:pt x="0" y="1490"/>
                    <a:pt x="12" y="1479"/>
                    <a:pt x="25" y="1479"/>
                  </a:cubicBezTo>
                  <a:cubicBezTo>
                    <a:pt x="39" y="1479"/>
                    <a:pt x="50" y="1490"/>
                    <a:pt x="50" y="1504"/>
                  </a:cubicBezTo>
                  <a:close/>
                  <a:moveTo>
                    <a:pt x="50" y="1854"/>
                  </a:moveTo>
                  <a:lnTo>
                    <a:pt x="50" y="2004"/>
                  </a:lnTo>
                  <a:cubicBezTo>
                    <a:pt x="50" y="2017"/>
                    <a:pt x="39" y="2029"/>
                    <a:pt x="25" y="2029"/>
                  </a:cubicBezTo>
                  <a:cubicBezTo>
                    <a:pt x="12" y="2029"/>
                    <a:pt x="0" y="2017"/>
                    <a:pt x="0" y="2004"/>
                  </a:cubicBezTo>
                  <a:lnTo>
                    <a:pt x="0" y="1854"/>
                  </a:lnTo>
                  <a:cubicBezTo>
                    <a:pt x="0" y="1840"/>
                    <a:pt x="12" y="1829"/>
                    <a:pt x="25" y="1829"/>
                  </a:cubicBezTo>
                  <a:cubicBezTo>
                    <a:pt x="39" y="1829"/>
                    <a:pt x="50" y="1840"/>
                    <a:pt x="50" y="1854"/>
                  </a:cubicBezTo>
                  <a:close/>
                  <a:moveTo>
                    <a:pt x="50" y="2204"/>
                  </a:moveTo>
                  <a:lnTo>
                    <a:pt x="50" y="2354"/>
                  </a:lnTo>
                  <a:cubicBezTo>
                    <a:pt x="50" y="2367"/>
                    <a:pt x="39" y="2379"/>
                    <a:pt x="25" y="2379"/>
                  </a:cubicBezTo>
                  <a:cubicBezTo>
                    <a:pt x="12" y="2379"/>
                    <a:pt x="0" y="2367"/>
                    <a:pt x="0" y="2354"/>
                  </a:cubicBezTo>
                  <a:lnTo>
                    <a:pt x="0" y="2204"/>
                  </a:lnTo>
                  <a:cubicBezTo>
                    <a:pt x="0" y="2190"/>
                    <a:pt x="12" y="2179"/>
                    <a:pt x="25" y="2179"/>
                  </a:cubicBezTo>
                  <a:cubicBezTo>
                    <a:pt x="39" y="2179"/>
                    <a:pt x="50" y="2190"/>
                    <a:pt x="50" y="2204"/>
                  </a:cubicBezTo>
                  <a:close/>
                  <a:moveTo>
                    <a:pt x="50" y="2554"/>
                  </a:moveTo>
                  <a:lnTo>
                    <a:pt x="50" y="2704"/>
                  </a:lnTo>
                  <a:cubicBezTo>
                    <a:pt x="50" y="2717"/>
                    <a:pt x="39" y="2729"/>
                    <a:pt x="25" y="2729"/>
                  </a:cubicBezTo>
                  <a:cubicBezTo>
                    <a:pt x="12" y="2729"/>
                    <a:pt x="0" y="2717"/>
                    <a:pt x="0" y="2704"/>
                  </a:cubicBezTo>
                  <a:lnTo>
                    <a:pt x="0" y="2554"/>
                  </a:lnTo>
                  <a:cubicBezTo>
                    <a:pt x="0" y="2540"/>
                    <a:pt x="12" y="2529"/>
                    <a:pt x="25" y="2529"/>
                  </a:cubicBezTo>
                  <a:cubicBezTo>
                    <a:pt x="39" y="2529"/>
                    <a:pt x="50" y="2540"/>
                    <a:pt x="50" y="2554"/>
                  </a:cubicBezTo>
                  <a:close/>
                  <a:moveTo>
                    <a:pt x="50" y="2904"/>
                  </a:moveTo>
                  <a:lnTo>
                    <a:pt x="50" y="3054"/>
                  </a:lnTo>
                  <a:cubicBezTo>
                    <a:pt x="50" y="3067"/>
                    <a:pt x="39" y="3079"/>
                    <a:pt x="25" y="3079"/>
                  </a:cubicBezTo>
                  <a:cubicBezTo>
                    <a:pt x="12" y="3079"/>
                    <a:pt x="0" y="3067"/>
                    <a:pt x="0" y="3054"/>
                  </a:cubicBezTo>
                  <a:lnTo>
                    <a:pt x="0" y="2904"/>
                  </a:lnTo>
                  <a:cubicBezTo>
                    <a:pt x="0" y="2890"/>
                    <a:pt x="12" y="2879"/>
                    <a:pt x="25" y="2879"/>
                  </a:cubicBezTo>
                  <a:cubicBezTo>
                    <a:pt x="39" y="2879"/>
                    <a:pt x="50" y="2890"/>
                    <a:pt x="50" y="2904"/>
                  </a:cubicBezTo>
                  <a:close/>
                  <a:moveTo>
                    <a:pt x="50" y="3254"/>
                  </a:moveTo>
                  <a:lnTo>
                    <a:pt x="50" y="3404"/>
                  </a:lnTo>
                  <a:cubicBezTo>
                    <a:pt x="50" y="3417"/>
                    <a:pt x="39" y="3429"/>
                    <a:pt x="25" y="3429"/>
                  </a:cubicBezTo>
                  <a:cubicBezTo>
                    <a:pt x="12" y="3429"/>
                    <a:pt x="0" y="3417"/>
                    <a:pt x="0" y="3404"/>
                  </a:cubicBezTo>
                  <a:lnTo>
                    <a:pt x="0" y="3254"/>
                  </a:lnTo>
                  <a:cubicBezTo>
                    <a:pt x="0" y="3240"/>
                    <a:pt x="12" y="3229"/>
                    <a:pt x="25" y="3229"/>
                  </a:cubicBezTo>
                  <a:cubicBezTo>
                    <a:pt x="39" y="3229"/>
                    <a:pt x="50" y="3240"/>
                    <a:pt x="50" y="3254"/>
                  </a:cubicBezTo>
                  <a:close/>
                  <a:moveTo>
                    <a:pt x="50" y="3604"/>
                  </a:moveTo>
                  <a:lnTo>
                    <a:pt x="50" y="3754"/>
                  </a:lnTo>
                  <a:cubicBezTo>
                    <a:pt x="50" y="3767"/>
                    <a:pt x="39" y="3779"/>
                    <a:pt x="25" y="3779"/>
                  </a:cubicBezTo>
                  <a:cubicBezTo>
                    <a:pt x="12" y="3779"/>
                    <a:pt x="0" y="3767"/>
                    <a:pt x="0" y="3754"/>
                  </a:cubicBezTo>
                  <a:lnTo>
                    <a:pt x="0" y="3604"/>
                  </a:lnTo>
                  <a:cubicBezTo>
                    <a:pt x="0" y="3590"/>
                    <a:pt x="12" y="3579"/>
                    <a:pt x="25" y="3579"/>
                  </a:cubicBezTo>
                  <a:cubicBezTo>
                    <a:pt x="39" y="3579"/>
                    <a:pt x="50" y="3590"/>
                    <a:pt x="50" y="3604"/>
                  </a:cubicBezTo>
                  <a:close/>
                  <a:moveTo>
                    <a:pt x="50" y="3954"/>
                  </a:moveTo>
                  <a:lnTo>
                    <a:pt x="50" y="4104"/>
                  </a:lnTo>
                  <a:cubicBezTo>
                    <a:pt x="50" y="4117"/>
                    <a:pt x="39" y="4129"/>
                    <a:pt x="25" y="4129"/>
                  </a:cubicBezTo>
                  <a:cubicBezTo>
                    <a:pt x="12" y="4129"/>
                    <a:pt x="0" y="4117"/>
                    <a:pt x="0" y="4104"/>
                  </a:cubicBezTo>
                  <a:lnTo>
                    <a:pt x="0" y="3954"/>
                  </a:lnTo>
                  <a:cubicBezTo>
                    <a:pt x="0" y="3940"/>
                    <a:pt x="12" y="3929"/>
                    <a:pt x="25" y="3929"/>
                  </a:cubicBezTo>
                  <a:cubicBezTo>
                    <a:pt x="39" y="3929"/>
                    <a:pt x="50" y="3940"/>
                    <a:pt x="50" y="3954"/>
                  </a:cubicBezTo>
                  <a:close/>
                  <a:moveTo>
                    <a:pt x="50" y="4304"/>
                  </a:moveTo>
                  <a:lnTo>
                    <a:pt x="50" y="4454"/>
                  </a:lnTo>
                  <a:cubicBezTo>
                    <a:pt x="50" y="4467"/>
                    <a:pt x="39" y="4479"/>
                    <a:pt x="25" y="4479"/>
                  </a:cubicBezTo>
                  <a:cubicBezTo>
                    <a:pt x="12" y="4479"/>
                    <a:pt x="0" y="4467"/>
                    <a:pt x="0" y="4454"/>
                  </a:cubicBezTo>
                  <a:lnTo>
                    <a:pt x="0" y="4304"/>
                  </a:lnTo>
                  <a:cubicBezTo>
                    <a:pt x="0" y="4290"/>
                    <a:pt x="12" y="4279"/>
                    <a:pt x="25" y="4279"/>
                  </a:cubicBezTo>
                  <a:cubicBezTo>
                    <a:pt x="39" y="4279"/>
                    <a:pt x="50" y="4290"/>
                    <a:pt x="50" y="4304"/>
                  </a:cubicBezTo>
                  <a:close/>
                  <a:moveTo>
                    <a:pt x="50" y="4654"/>
                  </a:moveTo>
                  <a:lnTo>
                    <a:pt x="50" y="4804"/>
                  </a:lnTo>
                  <a:cubicBezTo>
                    <a:pt x="50" y="4817"/>
                    <a:pt x="39" y="4829"/>
                    <a:pt x="25" y="4829"/>
                  </a:cubicBezTo>
                  <a:cubicBezTo>
                    <a:pt x="12" y="4829"/>
                    <a:pt x="0" y="4817"/>
                    <a:pt x="0" y="4804"/>
                  </a:cubicBezTo>
                  <a:lnTo>
                    <a:pt x="0" y="4654"/>
                  </a:lnTo>
                  <a:cubicBezTo>
                    <a:pt x="0" y="4640"/>
                    <a:pt x="12" y="4629"/>
                    <a:pt x="25" y="4629"/>
                  </a:cubicBezTo>
                  <a:cubicBezTo>
                    <a:pt x="39" y="4629"/>
                    <a:pt x="50" y="4640"/>
                    <a:pt x="50" y="4654"/>
                  </a:cubicBezTo>
                  <a:close/>
                  <a:moveTo>
                    <a:pt x="50" y="5004"/>
                  </a:moveTo>
                  <a:lnTo>
                    <a:pt x="50" y="5154"/>
                  </a:lnTo>
                  <a:cubicBezTo>
                    <a:pt x="50" y="5167"/>
                    <a:pt x="39" y="5179"/>
                    <a:pt x="25" y="5179"/>
                  </a:cubicBezTo>
                  <a:cubicBezTo>
                    <a:pt x="12" y="5179"/>
                    <a:pt x="0" y="5167"/>
                    <a:pt x="0" y="5154"/>
                  </a:cubicBezTo>
                  <a:lnTo>
                    <a:pt x="0" y="5004"/>
                  </a:lnTo>
                  <a:cubicBezTo>
                    <a:pt x="0" y="4990"/>
                    <a:pt x="12" y="4979"/>
                    <a:pt x="25" y="4979"/>
                  </a:cubicBezTo>
                  <a:cubicBezTo>
                    <a:pt x="39" y="4979"/>
                    <a:pt x="50" y="4990"/>
                    <a:pt x="50" y="5004"/>
                  </a:cubicBezTo>
                  <a:close/>
                  <a:moveTo>
                    <a:pt x="50" y="5354"/>
                  </a:moveTo>
                  <a:lnTo>
                    <a:pt x="50" y="5504"/>
                  </a:lnTo>
                  <a:cubicBezTo>
                    <a:pt x="50" y="5517"/>
                    <a:pt x="39" y="5529"/>
                    <a:pt x="25" y="5529"/>
                  </a:cubicBezTo>
                  <a:cubicBezTo>
                    <a:pt x="12" y="5529"/>
                    <a:pt x="0" y="5517"/>
                    <a:pt x="0" y="5504"/>
                  </a:cubicBezTo>
                  <a:lnTo>
                    <a:pt x="0" y="5354"/>
                  </a:lnTo>
                  <a:cubicBezTo>
                    <a:pt x="0" y="5340"/>
                    <a:pt x="12" y="5329"/>
                    <a:pt x="25" y="5329"/>
                  </a:cubicBezTo>
                  <a:cubicBezTo>
                    <a:pt x="39" y="5329"/>
                    <a:pt x="50" y="5340"/>
                    <a:pt x="50" y="5354"/>
                  </a:cubicBezTo>
                  <a:close/>
                  <a:moveTo>
                    <a:pt x="50" y="5704"/>
                  </a:moveTo>
                  <a:lnTo>
                    <a:pt x="50" y="5854"/>
                  </a:lnTo>
                  <a:cubicBezTo>
                    <a:pt x="50" y="5867"/>
                    <a:pt x="39" y="5879"/>
                    <a:pt x="25" y="5879"/>
                  </a:cubicBezTo>
                  <a:cubicBezTo>
                    <a:pt x="12" y="5879"/>
                    <a:pt x="0" y="5867"/>
                    <a:pt x="0" y="5854"/>
                  </a:cubicBezTo>
                  <a:lnTo>
                    <a:pt x="0" y="5704"/>
                  </a:lnTo>
                  <a:cubicBezTo>
                    <a:pt x="0" y="5690"/>
                    <a:pt x="12" y="5679"/>
                    <a:pt x="25" y="5679"/>
                  </a:cubicBezTo>
                  <a:cubicBezTo>
                    <a:pt x="39" y="5679"/>
                    <a:pt x="50" y="5690"/>
                    <a:pt x="50" y="5704"/>
                  </a:cubicBezTo>
                  <a:close/>
                  <a:moveTo>
                    <a:pt x="50" y="6054"/>
                  </a:moveTo>
                  <a:lnTo>
                    <a:pt x="50" y="6204"/>
                  </a:lnTo>
                  <a:cubicBezTo>
                    <a:pt x="50" y="6217"/>
                    <a:pt x="39" y="6229"/>
                    <a:pt x="25" y="6229"/>
                  </a:cubicBezTo>
                  <a:cubicBezTo>
                    <a:pt x="12" y="6229"/>
                    <a:pt x="0" y="6217"/>
                    <a:pt x="0" y="6204"/>
                  </a:cubicBezTo>
                  <a:lnTo>
                    <a:pt x="0" y="6054"/>
                  </a:lnTo>
                  <a:cubicBezTo>
                    <a:pt x="0" y="6040"/>
                    <a:pt x="12" y="6029"/>
                    <a:pt x="25" y="6029"/>
                  </a:cubicBezTo>
                  <a:cubicBezTo>
                    <a:pt x="39" y="6029"/>
                    <a:pt x="50" y="6040"/>
                    <a:pt x="50" y="6054"/>
                  </a:cubicBezTo>
                  <a:close/>
                  <a:moveTo>
                    <a:pt x="50" y="6404"/>
                  </a:moveTo>
                  <a:lnTo>
                    <a:pt x="50" y="6554"/>
                  </a:lnTo>
                  <a:cubicBezTo>
                    <a:pt x="50" y="6567"/>
                    <a:pt x="39" y="6579"/>
                    <a:pt x="25" y="6579"/>
                  </a:cubicBezTo>
                  <a:cubicBezTo>
                    <a:pt x="12" y="6579"/>
                    <a:pt x="0" y="6567"/>
                    <a:pt x="0" y="6554"/>
                  </a:cubicBezTo>
                  <a:lnTo>
                    <a:pt x="0" y="6404"/>
                  </a:lnTo>
                  <a:cubicBezTo>
                    <a:pt x="0" y="6390"/>
                    <a:pt x="12" y="6379"/>
                    <a:pt x="25" y="6379"/>
                  </a:cubicBezTo>
                  <a:cubicBezTo>
                    <a:pt x="39" y="6379"/>
                    <a:pt x="50" y="6390"/>
                    <a:pt x="50" y="6404"/>
                  </a:cubicBezTo>
                  <a:close/>
                  <a:moveTo>
                    <a:pt x="50" y="6754"/>
                  </a:moveTo>
                  <a:lnTo>
                    <a:pt x="50" y="6904"/>
                  </a:lnTo>
                  <a:cubicBezTo>
                    <a:pt x="50" y="6917"/>
                    <a:pt x="39" y="6929"/>
                    <a:pt x="25" y="6929"/>
                  </a:cubicBezTo>
                  <a:cubicBezTo>
                    <a:pt x="12" y="6929"/>
                    <a:pt x="0" y="6917"/>
                    <a:pt x="0" y="6904"/>
                  </a:cubicBezTo>
                  <a:lnTo>
                    <a:pt x="0" y="6754"/>
                  </a:lnTo>
                  <a:cubicBezTo>
                    <a:pt x="0" y="6740"/>
                    <a:pt x="12" y="6729"/>
                    <a:pt x="25" y="6729"/>
                  </a:cubicBezTo>
                  <a:cubicBezTo>
                    <a:pt x="39" y="6729"/>
                    <a:pt x="50" y="6740"/>
                    <a:pt x="50" y="6754"/>
                  </a:cubicBezTo>
                  <a:close/>
                  <a:moveTo>
                    <a:pt x="50" y="7104"/>
                  </a:moveTo>
                  <a:lnTo>
                    <a:pt x="50" y="7254"/>
                  </a:lnTo>
                  <a:cubicBezTo>
                    <a:pt x="50" y="7267"/>
                    <a:pt x="39" y="7279"/>
                    <a:pt x="25" y="7279"/>
                  </a:cubicBezTo>
                  <a:cubicBezTo>
                    <a:pt x="12" y="7279"/>
                    <a:pt x="0" y="7267"/>
                    <a:pt x="0" y="7254"/>
                  </a:cubicBezTo>
                  <a:lnTo>
                    <a:pt x="0" y="7104"/>
                  </a:lnTo>
                  <a:cubicBezTo>
                    <a:pt x="0" y="7090"/>
                    <a:pt x="12" y="7079"/>
                    <a:pt x="25" y="7079"/>
                  </a:cubicBezTo>
                  <a:cubicBezTo>
                    <a:pt x="39" y="7079"/>
                    <a:pt x="50" y="7090"/>
                    <a:pt x="50" y="7104"/>
                  </a:cubicBezTo>
                  <a:close/>
                  <a:moveTo>
                    <a:pt x="50" y="7454"/>
                  </a:moveTo>
                  <a:lnTo>
                    <a:pt x="50" y="7604"/>
                  </a:lnTo>
                  <a:cubicBezTo>
                    <a:pt x="50" y="7617"/>
                    <a:pt x="39" y="7629"/>
                    <a:pt x="25" y="7629"/>
                  </a:cubicBezTo>
                  <a:cubicBezTo>
                    <a:pt x="12" y="7629"/>
                    <a:pt x="0" y="7617"/>
                    <a:pt x="0" y="7604"/>
                  </a:cubicBezTo>
                  <a:lnTo>
                    <a:pt x="0" y="7454"/>
                  </a:lnTo>
                  <a:cubicBezTo>
                    <a:pt x="0" y="7440"/>
                    <a:pt x="12" y="7429"/>
                    <a:pt x="25" y="7429"/>
                  </a:cubicBezTo>
                  <a:cubicBezTo>
                    <a:pt x="39" y="7429"/>
                    <a:pt x="50" y="7440"/>
                    <a:pt x="50" y="7454"/>
                  </a:cubicBezTo>
                  <a:close/>
                  <a:moveTo>
                    <a:pt x="50" y="7804"/>
                  </a:moveTo>
                  <a:lnTo>
                    <a:pt x="50" y="7954"/>
                  </a:lnTo>
                  <a:cubicBezTo>
                    <a:pt x="50" y="7967"/>
                    <a:pt x="39" y="7979"/>
                    <a:pt x="25" y="7979"/>
                  </a:cubicBezTo>
                  <a:cubicBezTo>
                    <a:pt x="12" y="7979"/>
                    <a:pt x="0" y="7967"/>
                    <a:pt x="0" y="7954"/>
                  </a:cubicBezTo>
                  <a:lnTo>
                    <a:pt x="0" y="7804"/>
                  </a:lnTo>
                  <a:cubicBezTo>
                    <a:pt x="0" y="7790"/>
                    <a:pt x="12" y="7779"/>
                    <a:pt x="25" y="7779"/>
                  </a:cubicBezTo>
                  <a:cubicBezTo>
                    <a:pt x="39" y="7779"/>
                    <a:pt x="50" y="7790"/>
                    <a:pt x="50" y="7804"/>
                  </a:cubicBezTo>
                  <a:close/>
                  <a:moveTo>
                    <a:pt x="50" y="8154"/>
                  </a:moveTo>
                  <a:lnTo>
                    <a:pt x="50" y="8304"/>
                  </a:lnTo>
                  <a:cubicBezTo>
                    <a:pt x="50" y="8317"/>
                    <a:pt x="39" y="8329"/>
                    <a:pt x="25" y="8329"/>
                  </a:cubicBezTo>
                  <a:cubicBezTo>
                    <a:pt x="12" y="8329"/>
                    <a:pt x="0" y="8317"/>
                    <a:pt x="0" y="8304"/>
                  </a:cubicBezTo>
                  <a:lnTo>
                    <a:pt x="0" y="8154"/>
                  </a:lnTo>
                  <a:cubicBezTo>
                    <a:pt x="0" y="8140"/>
                    <a:pt x="12" y="8129"/>
                    <a:pt x="25" y="8129"/>
                  </a:cubicBezTo>
                  <a:cubicBezTo>
                    <a:pt x="39" y="8129"/>
                    <a:pt x="50" y="8140"/>
                    <a:pt x="50" y="8154"/>
                  </a:cubicBezTo>
                  <a:close/>
                  <a:moveTo>
                    <a:pt x="50" y="8504"/>
                  </a:moveTo>
                  <a:lnTo>
                    <a:pt x="50" y="8654"/>
                  </a:lnTo>
                  <a:cubicBezTo>
                    <a:pt x="50" y="8667"/>
                    <a:pt x="39" y="8679"/>
                    <a:pt x="25" y="8679"/>
                  </a:cubicBezTo>
                  <a:cubicBezTo>
                    <a:pt x="12" y="8679"/>
                    <a:pt x="0" y="8667"/>
                    <a:pt x="0" y="8654"/>
                  </a:cubicBezTo>
                  <a:lnTo>
                    <a:pt x="0" y="8504"/>
                  </a:lnTo>
                  <a:cubicBezTo>
                    <a:pt x="0" y="8490"/>
                    <a:pt x="12" y="8479"/>
                    <a:pt x="25" y="8479"/>
                  </a:cubicBezTo>
                  <a:cubicBezTo>
                    <a:pt x="39" y="8479"/>
                    <a:pt x="50" y="8490"/>
                    <a:pt x="50" y="8504"/>
                  </a:cubicBezTo>
                  <a:close/>
                  <a:moveTo>
                    <a:pt x="50" y="8854"/>
                  </a:moveTo>
                  <a:lnTo>
                    <a:pt x="50" y="9004"/>
                  </a:lnTo>
                  <a:cubicBezTo>
                    <a:pt x="50" y="9017"/>
                    <a:pt x="39" y="9029"/>
                    <a:pt x="25" y="9029"/>
                  </a:cubicBezTo>
                  <a:cubicBezTo>
                    <a:pt x="12" y="9029"/>
                    <a:pt x="0" y="9017"/>
                    <a:pt x="0" y="9004"/>
                  </a:cubicBezTo>
                  <a:lnTo>
                    <a:pt x="0" y="8854"/>
                  </a:lnTo>
                  <a:cubicBezTo>
                    <a:pt x="0" y="8840"/>
                    <a:pt x="12" y="8829"/>
                    <a:pt x="25" y="8829"/>
                  </a:cubicBezTo>
                  <a:cubicBezTo>
                    <a:pt x="39" y="8829"/>
                    <a:pt x="50" y="8840"/>
                    <a:pt x="50" y="8854"/>
                  </a:cubicBezTo>
                  <a:close/>
                  <a:moveTo>
                    <a:pt x="50" y="9204"/>
                  </a:moveTo>
                  <a:lnTo>
                    <a:pt x="50" y="9354"/>
                  </a:lnTo>
                  <a:cubicBezTo>
                    <a:pt x="50" y="9367"/>
                    <a:pt x="39" y="9379"/>
                    <a:pt x="25" y="9379"/>
                  </a:cubicBezTo>
                  <a:cubicBezTo>
                    <a:pt x="12" y="9379"/>
                    <a:pt x="0" y="9367"/>
                    <a:pt x="0" y="9354"/>
                  </a:cubicBezTo>
                  <a:lnTo>
                    <a:pt x="0" y="9204"/>
                  </a:lnTo>
                  <a:cubicBezTo>
                    <a:pt x="0" y="9190"/>
                    <a:pt x="12" y="9179"/>
                    <a:pt x="25" y="9179"/>
                  </a:cubicBezTo>
                  <a:cubicBezTo>
                    <a:pt x="39" y="9179"/>
                    <a:pt x="50" y="9190"/>
                    <a:pt x="50" y="9204"/>
                  </a:cubicBezTo>
                  <a:close/>
                  <a:moveTo>
                    <a:pt x="50" y="9554"/>
                  </a:moveTo>
                  <a:lnTo>
                    <a:pt x="50" y="9704"/>
                  </a:lnTo>
                  <a:cubicBezTo>
                    <a:pt x="50" y="9717"/>
                    <a:pt x="39" y="9729"/>
                    <a:pt x="25" y="9729"/>
                  </a:cubicBezTo>
                  <a:cubicBezTo>
                    <a:pt x="12" y="9729"/>
                    <a:pt x="0" y="9717"/>
                    <a:pt x="0" y="9704"/>
                  </a:cubicBezTo>
                  <a:lnTo>
                    <a:pt x="0" y="9554"/>
                  </a:lnTo>
                  <a:cubicBezTo>
                    <a:pt x="0" y="9540"/>
                    <a:pt x="12" y="9529"/>
                    <a:pt x="25" y="9529"/>
                  </a:cubicBezTo>
                  <a:cubicBezTo>
                    <a:pt x="39" y="9529"/>
                    <a:pt x="50" y="9540"/>
                    <a:pt x="50" y="9554"/>
                  </a:cubicBezTo>
                  <a:close/>
                  <a:moveTo>
                    <a:pt x="50" y="9904"/>
                  </a:moveTo>
                  <a:lnTo>
                    <a:pt x="50" y="10054"/>
                  </a:lnTo>
                  <a:cubicBezTo>
                    <a:pt x="50" y="10067"/>
                    <a:pt x="39" y="10079"/>
                    <a:pt x="25" y="10079"/>
                  </a:cubicBezTo>
                  <a:cubicBezTo>
                    <a:pt x="12" y="10079"/>
                    <a:pt x="0" y="10067"/>
                    <a:pt x="0" y="10054"/>
                  </a:cubicBezTo>
                  <a:lnTo>
                    <a:pt x="0" y="9904"/>
                  </a:lnTo>
                  <a:cubicBezTo>
                    <a:pt x="0" y="9890"/>
                    <a:pt x="12" y="9879"/>
                    <a:pt x="25" y="9879"/>
                  </a:cubicBezTo>
                  <a:cubicBezTo>
                    <a:pt x="39" y="9879"/>
                    <a:pt x="50" y="9890"/>
                    <a:pt x="50" y="9904"/>
                  </a:cubicBezTo>
                  <a:close/>
                  <a:moveTo>
                    <a:pt x="50" y="10254"/>
                  </a:moveTo>
                  <a:lnTo>
                    <a:pt x="50" y="10404"/>
                  </a:lnTo>
                  <a:cubicBezTo>
                    <a:pt x="50" y="10417"/>
                    <a:pt x="39" y="10429"/>
                    <a:pt x="25" y="10429"/>
                  </a:cubicBezTo>
                  <a:cubicBezTo>
                    <a:pt x="12" y="10429"/>
                    <a:pt x="0" y="10417"/>
                    <a:pt x="0" y="10404"/>
                  </a:cubicBezTo>
                  <a:lnTo>
                    <a:pt x="0" y="10254"/>
                  </a:lnTo>
                  <a:cubicBezTo>
                    <a:pt x="0" y="10240"/>
                    <a:pt x="12" y="10229"/>
                    <a:pt x="25" y="10229"/>
                  </a:cubicBezTo>
                  <a:cubicBezTo>
                    <a:pt x="39" y="10229"/>
                    <a:pt x="50" y="10240"/>
                    <a:pt x="50" y="10254"/>
                  </a:cubicBezTo>
                  <a:close/>
                  <a:moveTo>
                    <a:pt x="50" y="10604"/>
                  </a:moveTo>
                  <a:lnTo>
                    <a:pt x="50" y="10754"/>
                  </a:lnTo>
                  <a:cubicBezTo>
                    <a:pt x="50" y="10767"/>
                    <a:pt x="39" y="10779"/>
                    <a:pt x="25" y="10779"/>
                  </a:cubicBezTo>
                  <a:cubicBezTo>
                    <a:pt x="12" y="10779"/>
                    <a:pt x="0" y="10767"/>
                    <a:pt x="0" y="10754"/>
                  </a:cubicBezTo>
                  <a:lnTo>
                    <a:pt x="0" y="10604"/>
                  </a:lnTo>
                  <a:cubicBezTo>
                    <a:pt x="0" y="10590"/>
                    <a:pt x="12" y="10579"/>
                    <a:pt x="25" y="10579"/>
                  </a:cubicBezTo>
                  <a:cubicBezTo>
                    <a:pt x="39" y="10579"/>
                    <a:pt x="50" y="10590"/>
                    <a:pt x="50" y="10604"/>
                  </a:cubicBezTo>
                  <a:close/>
                  <a:moveTo>
                    <a:pt x="50" y="10954"/>
                  </a:moveTo>
                  <a:lnTo>
                    <a:pt x="50" y="11104"/>
                  </a:lnTo>
                  <a:cubicBezTo>
                    <a:pt x="50" y="11117"/>
                    <a:pt x="39" y="11129"/>
                    <a:pt x="25" y="11129"/>
                  </a:cubicBezTo>
                  <a:cubicBezTo>
                    <a:pt x="12" y="11129"/>
                    <a:pt x="0" y="11117"/>
                    <a:pt x="0" y="11104"/>
                  </a:cubicBezTo>
                  <a:lnTo>
                    <a:pt x="0" y="10954"/>
                  </a:lnTo>
                  <a:cubicBezTo>
                    <a:pt x="0" y="10940"/>
                    <a:pt x="12" y="10929"/>
                    <a:pt x="25" y="10929"/>
                  </a:cubicBezTo>
                  <a:cubicBezTo>
                    <a:pt x="39" y="10929"/>
                    <a:pt x="50" y="10940"/>
                    <a:pt x="50" y="10954"/>
                  </a:cubicBezTo>
                  <a:close/>
                  <a:moveTo>
                    <a:pt x="50" y="11304"/>
                  </a:moveTo>
                  <a:lnTo>
                    <a:pt x="50" y="11426"/>
                  </a:lnTo>
                  <a:lnTo>
                    <a:pt x="51" y="11453"/>
                  </a:lnTo>
                  <a:cubicBezTo>
                    <a:pt x="52" y="11467"/>
                    <a:pt x="41" y="11478"/>
                    <a:pt x="27" y="11479"/>
                  </a:cubicBezTo>
                  <a:cubicBezTo>
                    <a:pt x="13" y="11479"/>
                    <a:pt x="2" y="11468"/>
                    <a:pt x="1" y="11454"/>
                  </a:cubicBezTo>
                  <a:lnTo>
                    <a:pt x="0" y="11426"/>
                  </a:lnTo>
                  <a:lnTo>
                    <a:pt x="0" y="11304"/>
                  </a:lnTo>
                  <a:cubicBezTo>
                    <a:pt x="0" y="11290"/>
                    <a:pt x="12" y="11279"/>
                    <a:pt x="25" y="11279"/>
                  </a:cubicBezTo>
                  <a:cubicBezTo>
                    <a:pt x="39" y="11279"/>
                    <a:pt x="50" y="11290"/>
                    <a:pt x="50" y="11304"/>
                  </a:cubicBezTo>
                  <a:close/>
                  <a:moveTo>
                    <a:pt x="68" y="11648"/>
                  </a:moveTo>
                  <a:lnTo>
                    <a:pt x="80" y="11714"/>
                  </a:lnTo>
                  <a:lnTo>
                    <a:pt x="95" y="11783"/>
                  </a:lnTo>
                  <a:lnTo>
                    <a:pt x="98" y="11792"/>
                  </a:lnTo>
                  <a:cubicBezTo>
                    <a:pt x="102" y="11806"/>
                    <a:pt x="94" y="11820"/>
                    <a:pt x="81" y="11823"/>
                  </a:cubicBezTo>
                  <a:cubicBezTo>
                    <a:pt x="68" y="11827"/>
                    <a:pt x="54" y="11819"/>
                    <a:pt x="50" y="11806"/>
                  </a:cubicBezTo>
                  <a:lnTo>
                    <a:pt x="47" y="11794"/>
                  </a:lnTo>
                  <a:lnTo>
                    <a:pt x="30" y="11723"/>
                  </a:lnTo>
                  <a:lnTo>
                    <a:pt x="18" y="11657"/>
                  </a:lnTo>
                  <a:cubicBezTo>
                    <a:pt x="16" y="11644"/>
                    <a:pt x="25" y="11631"/>
                    <a:pt x="39" y="11628"/>
                  </a:cubicBezTo>
                  <a:cubicBezTo>
                    <a:pt x="52" y="11626"/>
                    <a:pt x="65" y="11635"/>
                    <a:pt x="68" y="11648"/>
                  </a:cubicBezTo>
                  <a:close/>
                  <a:moveTo>
                    <a:pt x="162" y="11979"/>
                  </a:moveTo>
                  <a:lnTo>
                    <a:pt x="163" y="11981"/>
                  </a:lnTo>
                  <a:lnTo>
                    <a:pt x="191" y="12044"/>
                  </a:lnTo>
                  <a:lnTo>
                    <a:pt x="223" y="12106"/>
                  </a:lnTo>
                  <a:lnTo>
                    <a:pt x="226" y="12110"/>
                  </a:lnTo>
                  <a:cubicBezTo>
                    <a:pt x="233" y="12122"/>
                    <a:pt x="229" y="12137"/>
                    <a:pt x="217" y="12145"/>
                  </a:cubicBezTo>
                  <a:cubicBezTo>
                    <a:pt x="205" y="12152"/>
                    <a:pt x="190" y="12148"/>
                    <a:pt x="183" y="12136"/>
                  </a:cubicBezTo>
                  <a:lnTo>
                    <a:pt x="178" y="12128"/>
                  </a:lnTo>
                  <a:lnTo>
                    <a:pt x="146" y="12065"/>
                  </a:lnTo>
                  <a:lnTo>
                    <a:pt x="116" y="12000"/>
                  </a:lnTo>
                  <a:lnTo>
                    <a:pt x="115" y="11998"/>
                  </a:lnTo>
                  <a:cubicBezTo>
                    <a:pt x="110" y="11985"/>
                    <a:pt x="117" y="11970"/>
                    <a:pt x="130" y="11965"/>
                  </a:cubicBezTo>
                  <a:cubicBezTo>
                    <a:pt x="142" y="11960"/>
                    <a:pt x="157" y="11966"/>
                    <a:pt x="162" y="11979"/>
                  </a:cubicBezTo>
                  <a:close/>
                  <a:moveTo>
                    <a:pt x="333" y="12276"/>
                  </a:moveTo>
                  <a:lnTo>
                    <a:pt x="376" y="12333"/>
                  </a:lnTo>
                  <a:lnTo>
                    <a:pt x="428" y="12389"/>
                  </a:lnTo>
                  <a:cubicBezTo>
                    <a:pt x="437" y="12399"/>
                    <a:pt x="436" y="12415"/>
                    <a:pt x="426" y="12424"/>
                  </a:cubicBezTo>
                  <a:cubicBezTo>
                    <a:pt x="416" y="12434"/>
                    <a:pt x="400" y="12433"/>
                    <a:pt x="391" y="12423"/>
                  </a:cubicBezTo>
                  <a:lnTo>
                    <a:pt x="336" y="12363"/>
                  </a:lnTo>
                  <a:lnTo>
                    <a:pt x="293" y="12306"/>
                  </a:lnTo>
                  <a:cubicBezTo>
                    <a:pt x="285" y="12294"/>
                    <a:pt x="287" y="12279"/>
                    <a:pt x="298" y="12271"/>
                  </a:cubicBezTo>
                  <a:cubicBezTo>
                    <a:pt x="310" y="12262"/>
                    <a:pt x="325" y="12265"/>
                    <a:pt x="333" y="12276"/>
                  </a:cubicBezTo>
                  <a:close/>
                  <a:moveTo>
                    <a:pt x="568" y="12524"/>
                  </a:moveTo>
                  <a:lnTo>
                    <a:pt x="679" y="12607"/>
                  </a:lnTo>
                  <a:lnTo>
                    <a:pt x="687" y="12612"/>
                  </a:lnTo>
                  <a:cubicBezTo>
                    <a:pt x="699" y="12619"/>
                    <a:pt x="702" y="12634"/>
                    <a:pt x="695" y="12646"/>
                  </a:cubicBezTo>
                  <a:cubicBezTo>
                    <a:pt x="688" y="12658"/>
                    <a:pt x="673" y="12662"/>
                    <a:pt x="661" y="12655"/>
                  </a:cubicBezTo>
                  <a:lnTo>
                    <a:pt x="649" y="12647"/>
                  </a:lnTo>
                  <a:lnTo>
                    <a:pt x="538" y="12564"/>
                  </a:lnTo>
                  <a:cubicBezTo>
                    <a:pt x="527" y="12556"/>
                    <a:pt x="525" y="12540"/>
                    <a:pt x="533" y="12529"/>
                  </a:cubicBezTo>
                  <a:cubicBezTo>
                    <a:pt x="542" y="12518"/>
                    <a:pt x="557" y="12516"/>
                    <a:pt x="568" y="12524"/>
                  </a:cubicBezTo>
                  <a:close/>
                  <a:moveTo>
                    <a:pt x="858" y="12710"/>
                  </a:moveTo>
                  <a:lnTo>
                    <a:pt x="921" y="12738"/>
                  </a:lnTo>
                  <a:lnTo>
                    <a:pt x="986" y="12764"/>
                  </a:lnTo>
                  <a:lnTo>
                    <a:pt x="994" y="12767"/>
                  </a:lnTo>
                  <a:cubicBezTo>
                    <a:pt x="1007" y="12771"/>
                    <a:pt x="1014" y="12785"/>
                    <a:pt x="1009" y="12798"/>
                  </a:cubicBezTo>
                  <a:cubicBezTo>
                    <a:pt x="1005" y="12811"/>
                    <a:pt x="991" y="12818"/>
                    <a:pt x="978" y="12814"/>
                  </a:cubicBezTo>
                  <a:lnTo>
                    <a:pt x="967" y="12810"/>
                  </a:lnTo>
                  <a:lnTo>
                    <a:pt x="900" y="12784"/>
                  </a:lnTo>
                  <a:lnTo>
                    <a:pt x="837" y="12755"/>
                  </a:lnTo>
                  <a:cubicBezTo>
                    <a:pt x="825" y="12749"/>
                    <a:pt x="819" y="12735"/>
                    <a:pt x="825" y="12722"/>
                  </a:cubicBezTo>
                  <a:cubicBezTo>
                    <a:pt x="830" y="12710"/>
                    <a:pt x="845" y="12704"/>
                    <a:pt x="858" y="12710"/>
                  </a:cubicBezTo>
                  <a:close/>
                  <a:moveTo>
                    <a:pt x="1184" y="12820"/>
                  </a:moveTo>
                  <a:lnTo>
                    <a:pt x="1188" y="12821"/>
                  </a:lnTo>
                  <a:lnTo>
                    <a:pt x="1258" y="12834"/>
                  </a:lnTo>
                  <a:lnTo>
                    <a:pt x="1329" y="12843"/>
                  </a:lnTo>
                  <a:cubicBezTo>
                    <a:pt x="1343" y="12844"/>
                    <a:pt x="1353" y="12857"/>
                    <a:pt x="1351" y="12871"/>
                  </a:cubicBezTo>
                  <a:cubicBezTo>
                    <a:pt x="1349" y="12884"/>
                    <a:pt x="1337" y="12894"/>
                    <a:pt x="1323" y="12892"/>
                  </a:cubicBezTo>
                  <a:lnTo>
                    <a:pt x="1249" y="12883"/>
                  </a:lnTo>
                  <a:lnTo>
                    <a:pt x="1177" y="12870"/>
                  </a:lnTo>
                  <a:lnTo>
                    <a:pt x="1173" y="12869"/>
                  </a:lnTo>
                  <a:cubicBezTo>
                    <a:pt x="1159" y="12866"/>
                    <a:pt x="1151" y="12852"/>
                    <a:pt x="1154" y="12839"/>
                  </a:cubicBezTo>
                  <a:cubicBezTo>
                    <a:pt x="1157" y="12825"/>
                    <a:pt x="1170" y="12817"/>
                    <a:pt x="1184" y="12820"/>
                  </a:cubicBezTo>
                  <a:close/>
                  <a:moveTo>
                    <a:pt x="1526" y="12850"/>
                  </a:moveTo>
                  <a:lnTo>
                    <a:pt x="1676" y="12850"/>
                  </a:lnTo>
                  <a:cubicBezTo>
                    <a:pt x="1690" y="12850"/>
                    <a:pt x="1701" y="12861"/>
                    <a:pt x="1701" y="12875"/>
                  </a:cubicBezTo>
                  <a:cubicBezTo>
                    <a:pt x="1701" y="12889"/>
                    <a:pt x="1690" y="12900"/>
                    <a:pt x="1676" y="12900"/>
                  </a:cubicBezTo>
                  <a:lnTo>
                    <a:pt x="1526" y="12900"/>
                  </a:lnTo>
                  <a:cubicBezTo>
                    <a:pt x="1512" y="12900"/>
                    <a:pt x="1501" y="12889"/>
                    <a:pt x="1501" y="12875"/>
                  </a:cubicBezTo>
                  <a:cubicBezTo>
                    <a:pt x="1501" y="12861"/>
                    <a:pt x="1512" y="12850"/>
                    <a:pt x="1526" y="12850"/>
                  </a:cubicBezTo>
                  <a:close/>
                  <a:moveTo>
                    <a:pt x="1876" y="12850"/>
                  </a:moveTo>
                  <a:lnTo>
                    <a:pt x="2026" y="12850"/>
                  </a:lnTo>
                  <a:cubicBezTo>
                    <a:pt x="2040" y="12850"/>
                    <a:pt x="2051" y="12861"/>
                    <a:pt x="2051" y="12875"/>
                  </a:cubicBezTo>
                  <a:cubicBezTo>
                    <a:pt x="2051" y="12889"/>
                    <a:pt x="2040" y="12900"/>
                    <a:pt x="2026" y="12900"/>
                  </a:cubicBezTo>
                  <a:lnTo>
                    <a:pt x="1876" y="12900"/>
                  </a:lnTo>
                  <a:cubicBezTo>
                    <a:pt x="1862" y="12900"/>
                    <a:pt x="1851" y="12889"/>
                    <a:pt x="1851" y="12875"/>
                  </a:cubicBezTo>
                  <a:cubicBezTo>
                    <a:pt x="1851" y="12861"/>
                    <a:pt x="1862" y="12850"/>
                    <a:pt x="1876" y="12850"/>
                  </a:cubicBezTo>
                  <a:close/>
                  <a:moveTo>
                    <a:pt x="2226" y="12850"/>
                  </a:moveTo>
                  <a:lnTo>
                    <a:pt x="2376" y="12850"/>
                  </a:lnTo>
                  <a:cubicBezTo>
                    <a:pt x="2390" y="12850"/>
                    <a:pt x="2401" y="12861"/>
                    <a:pt x="2401" y="12875"/>
                  </a:cubicBezTo>
                  <a:cubicBezTo>
                    <a:pt x="2401" y="12889"/>
                    <a:pt x="2390" y="12900"/>
                    <a:pt x="2376" y="12900"/>
                  </a:cubicBezTo>
                  <a:lnTo>
                    <a:pt x="2226" y="12900"/>
                  </a:lnTo>
                  <a:cubicBezTo>
                    <a:pt x="2212" y="12900"/>
                    <a:pt x="2201" y="12889"/>
                    <a:pt x="2201" y="12875"/>
                  </a:cubicBezTo>
                  <a:cubicBezTo>
                    <a:pt x="2201" y="12861"/>
                    <a:pt x="2212" y="12850"/>
                    <a:pt x="2226" y="12850"/>
                  </a:cubicBezTo>
                  <a:close/>
                  <a:moveTo>
                    <a:pt x="2576" y="12850"/>
                  </a:moveTo>
                  <a:lnTo>
                    <a:pt x="2726" y="12850"/>
                  </a:lnTo>
                  <a:cubicBezTo>
                    <a:pt x="2740" y="12850"/>
                    <a:pt x="2751" y="12861"/>
                    <a:pt x="2751" y="12875"/>
                  </a:cubicBezTo>
                  <a:cubicBezTo>
                    <a:pt x="2751" y="12889"/>
                    <a:pt x="2740" y="12900"/>
                    <a:pt x="2726" y="12900"/>
                  </a:cubicBezTo>
                  <a:lnTo>
                    <a:pt x="2576" y="12900"/>
                  </a:lnTo>
                  <a:cubicBezTo>
                    <a:pt x="2562" y="12900"/>
                    <a:pt x="2551" y="12889"/>
                    <a:pt x="2551" y="12875"/>
                  </a:cubicBezTo>
                  <a:cubicBezTo>
                    <a:pt x="2551" y="12861"/>
                    <a:pt x="2562" y="12850"/>
                    <a:pt x="2576" y="12850"/>
                  </a:cubicBezTo>
                  <a:close/>
                  <a:moveTo>
                    <a:pt x="2926" y="12850"/>
                  </a:moveTo>
                  <a:lnTo>
                    <a:pt x="3076" y="12850"/>
                  </a:lnTo>
                  <a:cubicBezTo>
                    <a:pt x="3090" y="12850"/>
                    <a:pt x="3101" y="12861"/>
                    <a:pt x="3101" y="12875"/>
                  </a:cubicBezTo>
                  <a:cubicBezTo>
                    <a:pt x="3101" y="12889"/>
                    <a:pt x="3090" y="12900"/>
                    <a:pt x="3076" y="12900"/>
                  </a:cubicBezTo>
                  <a:lnTo>
                    <a:pt x="2926" y="12900"/>
                  </a:lnTo>
                  <a:cubicBezTo>
                    <a:pt x="2912" y="12900"/>
                    <a:pt x="2901" y="12889"/>
                    <a:pt x="2901" y="12875"/>
                  </a:cubicBezTo>
                  <a:cubicBezTo>
                    <a:pt x="2901" y="12861"/>
                    <a:pt x="2912" y="12850"/>
                    <a:pt x="2926" y="12850"/>
                  </a:cubicBezTo>
                  <a:close/>
                  <a:moveTo>
                    <a:pt x="3276" y="12850"/>
                  </a:moveTo>
                  <a:lnTo>
                    <a:pt x="3426" y="12850"/>
                  </a:lnTo>
                  <a:cubicBezTo>
                    <a:pt x="3440" y="12850"/>
                    <a:pt x="3451" y="12861"/>
                    <a:pt x="3451" y="12875"/>
                  </a:cubicBezTo>
                  <a:cubicBezTo>
                    <a:pt x="3451" y="12889"/>
                    <a:pt x="3440" y="12900"/>
                    <a:pt x="3426" y="12900"/>
                  </a:cubicBezTo>
                  <a:lnTo>
                    <a:pt x="3276" y="12900"/>
                  </a:lnTo>
                  <a:cubicBezTo>
                    <a:pt x="3262" y="12900"/>
                    <a:pt x="3251" y="12889"/>
                    <a:pt x="3251" y="12875"/>
                  </a:cubicBezTo>
                  <a:cubicBezTo>
                    <a:pt x="3251" y="12861"/>
                    <a:pt x="3262" y="12850"/>
                    <a:pt x="3276" y="12850"/>
                  </a:cubicBezTo>
                  <a:close/>
                  <a:moveTo>
                    <a:pt x="3626" y="12850"/>
                  </a:moveTo>
                  <a:lnTo>
                    <a:pt x="3776" y="12850"/>
                  </a:lnTo>
                  <a:cubicBezTo>
                    <a:pt x="3790" y="12850"/>
                    <a:pt x="3801" y="12861"/>
                    <a:pt x="3801" y="12875"/>
                  </a:cubicBezTo>
                  <a:cubicBezTo>
                    <a:pt x="3801" y="12889"/>
                    <a:pt x="3790" y="12900"/>
                    <a:pt x="3776" y="12900"/>
                  </a:cubicBezTo>
                  <a:lnTo>
                    <a:pt x="3626" y="12900"/>
                  </a:lnTo>
                  <a:cubicBezTo>
                    <a:pt x="3612" y="12900"/>
                    <a:pt x="3601" y="12889"/>
                    <a:pt x="3601" y="12875"/>
                  </a:cubicBezTo>
                  <a:cubicBezTo>
                    <a:pt x="3601" y="12861"/>
                    <a:pt x="3612" y="12850"/>
                    <a:pt x="3626" y="12850"/>
                  </a:cubicBezTo>
                  <a:close/>
                  <a:moveTo>
                    <a:pt x="3976" y="12850"/>
                  </a:moveTo>
                  <a:lnTo>
                    <a:pt x="4126" y="12850"/>
                  </a:lnTo>
                  <a:cubicBezTo>
                    <a:pt x="4140" y="12850"/>
                    <a:pt x="4151" y="12861"/>
                    <a:pt x="4151" y="12875"/>
                  </a:cubicBezTo>
                  <a:cubicBezTo>
                    <a:pt x="4151" y="12889"/>
                    <a:pt x="4140" y="12900"/>
                    <a:pt x="4126" y="12900"/>
                  </a:cubicBezTo>
                  <a:lnTo>
                    <a:pt x="3976" y="12900"/>
                  </a:lnTo>
                  <a:cubicBezTo>
                    <a:pt x="3962" y="12900"/>
                    <a:pt x="3951" y="12889"/>
                    <a:pt x="3951" y="12875"/>
                  </a:cubicBezTo>
                  <a:cubicBezTo>
                    <a:pt x="3951" y="12861"/>
                    <a:pt x="3962" y="12850"/>
                    <a:pt x="3976" y="12850"/>
                  </a:cubicBezTo>
                  <a:close/>
                  <a:moveTo>
                    <a:pt x="4326" y="12850"/>
                  </a:moveTo>
                  <a:lnTo>
                    <a:pt x="4476" y="12850"/>
                  </a:lnTo>
                  <a:cubicBezTo>
                    <a:pt x="4490" y="12850"/>
                    <a:pt x="4501" y="12861"/>
                    <a:pt x="4501" y="12875"/>
                  </a:cubicBezTo>
                  <a:cubicBezTo>
                    <a:pt x="4501" y="12889"/>
                    <a:pt x="4490" y="12900"/>
                    <a:pt x="4476" y="12900"/>
                  </a:cubicBezTo>
                  <a:lnTo>
                    <a:pt x="4326" y="12900"/>
                  </a:lnTo>
                  <a:cubicBezTo>
                    <a:pt x="4312" y="12900"/>
                    <a:pt x="4301" y="12889"/>
                    <a:pt x="4301" y="12875"/>
                  </a:cubicBezTo>
                  <a:cubicBezTo>
                    <a:pt x="4301" y="12861"/>
                    <a:pt x="4312" y="12850"/>
                    <a:pt x="4326" y="12850"/>
                  </a:cubicBezTo>
                  <a:close/>
                  <a:moveTo>
                    <a:pt x="4676" y="12850"/>
                  </a:moveTo>
                  <a:lnTo>
                    <a:pt x="4826" y="12850"/>
                  </a:lnTo>
                  <a:cubicBezTo>
                    <a:pt x="4840" y="12850"/>
                    <a:pt x="4851" y="12861"/>
                    <a:pt x="4851" y="12875"/>
                  </a:cubicBezTo>
                  <a:cubicBezTo>
                    <a:pt x="4851" y="12889"/>
                    <a:pt x="4840" y="12900"/>
                    <a:pt x="4826" y="12900"/>
                  </a:cubicBezTo>
                  <a:lnTo>
                    <a:pt x="4676" y="12900"/>
                  </a:lnTo>
                  <a:cubicBezTo>
                    <a:pt x="4662" y="12900"/>
                    <a:pt x="4651" y="12889"/>
                    <a:pt x="4651" y="12875"/>
                  </a:cubicBezTo>
                  <a:cubicBezTo>
                    <a:pt x="4651" y="12861"/>
                    <a:pt x="4662" y="12850"/>
                    <a:pt x="4676" y="12850"/>
                  </a:cubicBezTo>
                  <a:close/>
                  <a:moveTo>
                    <a:pt x="5026" y="12850"/>
                  </a:moveTo>
                  <a:lnTo>
                    <a:pt x="5176" y="12850"/>
                  </a:lnTo>
                  <a:cubicBezTo>
                    <a:pt x="5190" y="12850"/>
                    <a:pt x="5201" y="12861"/>
                    <a:pt x="5201" y="12875"/>
                  </a:cubicBezTo>
                  <a:cubicBezTo>
                    <a:pt x="5201" y="12889"/>
                    <a:pt x="5190" y="12900"/>
                    <a:pt x="5176" y="12900"/>
                  </a:cubicBezTo>
                  <a:lnTo>
                    <a:pt x="5026" y="12900"/>
                  </a:lnTo>
                  <a:cubicBezTo>
                    <a:pt x="5012" y="12900"/>
                    <a:pt x="5001" y="12889"/>
                    <a:pt x="5001" y="12875"/>
                  </a:cubicBezTo>
                  <a:cubicBezTo>
                    <a:pt x="5001" y="12861"/>
                    <a:pt x="5012" y="12850"/>
                    <a:pt x="5026" y="12850"/>
                  </a:cubicBezTo>
                  <a:close/>
                  <a:moveTo>
                    <a:pt x="5376" y="12850"/>
                  </a:moveTo>
                  <a:lnTo>
                    <a:pt x="5526" y="12850"/>
                  </a:lnTo>
                  <a:cubicBezTo>
                    <a:pt x="5540" y="12850"/>
                    <a:pt x="5551" y="12861"/>
                    <a:pt x="5551" y="12875"/>
                  </a:cubicBezTo>
                  <a:cubicBezTo>
                    <a:pt x="5551" y="12889"/>
                    <a:pt x="5540" y="12900"/>
                    <a:pt x="5526" y="12900"/>
                  </a:cubicBezTo>
                  <a:lnTo>
                    <a:pt x="5376" y="12900"/>
                  </a:lnTo>
                  <a:cubicBezTo>
                    <a:pt x="5362" y="12900"/>
                    <a:pt x="5351" y="12889"/>
                    <a:pt x="5351" y="12875"/>
                  </a:cubicBezTo>
                  <a:cubicBezTo>
                    <a:pt x="5351" y="12861"/>
                    <a:pt x="5362" y="12850"/>
                    <a:pt x="5376" y="12850"/>
                  </a:cubicBezTo>
                  <a:close/>
                  <a:moveTo>
                    <a:pt x="5726" y="12850"/>
                  </a:moveTo>
                  <a:lnTo>
                    <a:pt x="5876" y="12850"/>
                  </a:lnTo>
                  <a:cubicBezTo>
                    <a:pt x="5890" y="12850"/>
                    <a:pt x="5901" y="12861"/>
                    <a:pt x="5901" y="12875"/>
                  </a:cubicBezTo>
                  <a:cubicBezTo>
                    <a:pt x="5901" y="12889"/>
                    <a:pt x="5890" y="12900"/>
                    <a:pt x="5876" y="12900"/>
                  </a:cubicBezTo>
                  <a:lnTo>
                    <a:pt x="5726" y="12900"/>
                  </a:lnTo>
                  <a:cubicBezTo>
                    <a:pt x="5712" y="12900"/>
                    <a:pt x="5701" y="12889"/>
                    <a:pt x="5701" y="12875"/>
                  </a:cubicBezTo>
                  <a:cubicBezTo>
                    <a:pt x="5701" y="12861"/>
                    <a:pt x="5712" y="12850"/>
                    <a:pt x="5726" y="12850"/>
                  </a:cubicBezTo>
                  <a:close/>
                  <a:moveTo>
                    <a:pt x="6076" y="12850"/>
                  </a:moveTo>
                  <a:lnTo>
                    <a:pt x="6226" y="12850"/>
                  </a:lnTo>
                  <a:cubicBezTo>
                    <a:pt x="6240" y="12850"/>
                    <a:pt x="6251" y="12861"/>
                    <a:pt x="6251" y="12875"/>
                  </a:cubicBezTo>
                  <a:cubicBezTo>
                    <a:pt x="6251" y="12889"/>
                    <a:pt x="6240" y="12900"/>
                    <a:pt x="6226" y="12900"/>
                  </a:cubicBezTo>
                  <a:lnTo>
                    <a:pt x="6076" y="12900"/>
                  </a:lnTo>
                  <a:cubicBezTo>
                    <a:pt x="6062" y="12900"/>
                    <a:pt x="6051" y="12889"/>
                    <a:pt x="6051" y="12875"/>
                  </a:cubicBezTo>
                  <a:cubicBezTo>
                    <a:pt x="6051" y="12861"/>
                    <a:pt x="6062" y="12850"/>
                    <a:pt x="6076" y="12850"/>
                  </a:cubicBezTo>
                  <a:close/>
                  <a:moveTo>
                    <a:pt x="6426" y="12850"/>
                  </a:moveTo>
                  <a:lnTo>
                    <a:pt x="6576" y="12850"/>
                  </a:lnTo>
                  <a:cubicBezTo>
                    <a:pt x="6590" y="12850"/>
                    <a:pt x="6601" y="12861"/>
                    <a:pt x="6601" y="12875"/>
                  </a:cubicBezTo>
                  <a:cubicBezTo>
                    <a:pt x="6601" y="12889"/>
                    <a:pt x="6590" y="12900"/>
                    <a:pt x="6576" y="12900"/>
                  </a:cubicBezTo>
                  <a:lnTo>
                    <a:pt x="6426" y="12900"/>
                  </a:lnTo>
                  <a:cubicBezTo>
                    <a:pt x="6412" y="12900"/>
                    <a:pt x="6401" y="12889"/>
                    <a:pt x="6401" y="12875"/>
                  </a:cubicBezTo>
                  <a:cubicBezTo>
                    <a:pt x="6401" y="12861"/>
                    <a:pt x="6412" y="12850"/>
                    <a:pt x="6426" y="12850"/>
                  </a:cubicBezTo>
                  <a:close/>
                  <a:moveTo>
                    <a:pt x="6776" y="12850"/>
                  </a:moveTo>
                  <a:lnTo>
                    <a:pt x="6926" y="12850"/>
                  </a:lnTo>
                  <a:cubicBezTo>
                    <a:pt x="6940" y="12850"/>
                    <a:pt x="6951" y="12861"/>
                    <a:pt x="6951" y="12875"/>
                  </a:cubicBezTo>
                  <a:cubicBezTo>
                    <a:pt x="6951" y="12889"/>
                    <a:pt x="6940" y="12900"/>
                    <a:pt x="6926" y="12900"/>
                  </a:cubicBezTo>
                  <a:lnTo>
                    <a:pt x="6776" y="12900"/>
                  </a:lnTo>
                  <a:cubicBezTo>
                    <a:pt x="6762" y="12900"/>
                    <a:pt x="6751" y="12889"/>
                    <a:pt x="6751" y="12875"/>
                  </a:cubicBezTo>
                  <a:cubicBezTo>
                    <a:pt x="6751" y="12861"/>
                    <a:pt x="6762" y="12850"/>
                    <a:pt x="6776" y="12850"/>
                  </a:cubicBezTo>
                  <a:close/>
                  <a:moveTo>
                    <a:pt x="7126" y="12850"/>
                  </a:moveTo>
                  <a:lnTo>
                    <a:pt x="7269" y="12850"/>
                  </a:lnTo>
                  <a:lnTo>
                    <a:pt x="7275" y="12850"/>
                  </a:lnTo>
                  <a:cubicBezTo>
                    <a:pt x="7289" y="12849"/>
                    <a:pt x="7301" y="12860"/>
                    <a:pt x="7301" y="12874"/>
                  </a:cubicBezTo>
                  <a:cubicBezTo>
                    <a:pt x="7301" y="12888"/>
                    <a:pt x="7291" y="12899"/>
                    <a:pt x="7277" y="12900"/>
                  </a:cubicBezTo>
                  <a:lnTo>
                    <a:pt x="7269" y="12900"/>
                  </a:lnTo>
                  <a:lnTo>
                    <a:pt x="7126" y="12900"/>
                  </a:lnTo>
                  <a:cubicBezTo>
                    <a:pt x="7112" y="12900"/>
                    <a:pt x="7101" y="12889"/>
                    <a:pt x="7101" y="12875"/>
                  </a:cubicBezTo>
                  <a:cubicBezTo>
                    <a:pt x="7101" y="12861"/>
                    <a:pt x="7112" y="12850"/>
                    <a:pt x="7126" y="12850"/>
                  </a:cubicBezTo>
                  <a:close/>
                  <a:moveTo>
                    <a:pt x="7472" y="12835"/>
                  </a:moveTo>
                  <a:lnTo>
                    <a:pt x="7486" y="12834"/>
                  </a:lnTo>
                  <a:lnTo>
                    <a:pt x="7556" y="12821"/>
                  </a:lnTo>
                  <a:lnTo>
                    <a:pt x="7617" y="12807"/>
                  </a:lnTo>
                  <a:cubicBezTo>
                    <a:pt x="7630" y="12804"/>
                    <a:pt x="7644" y="12812"/>
                    <a:pt x="7647" y="12826"/>
                  </a:cubicBezTo>
                  <a:cubicBezTo>
                    <a:pt x="7650" y="12839"/>
                    <a:pt x="7642" y="12853"/>
                    <a:pt x="7628" y="12856"/>
                  </a:cubicBezTo>
                  <a:lnTo>
                    <a:pt x="7565" y="12870"/>
                  </a:lnTo>
                  <a:lnTo>
                    <a:pt x="7493" y="12883"/>
                  </a:lnTo>
                  <a:lnTo>
                    <a:pt x="7478" y="12885"/>
                  </a:lnTo>
                  <a:cubicBezTo>
                    <a:pt x="7465" y="12887"/>
                    <a:pt x="7452" y="12877"/>
                    <a:pt x="7451" y="12863"/>
                  </a:cubicBezTo>
                  <a:cubicBezTo>
                    <a:pt x="7449" y="12850"/>
                    <a:pt x="7459" y="12837"/>
                    <a:pt x="7472" y="12835"/>
                  </a:cubicBezTo>
                  <a:close/>
                  <a:moveTo>
                    <a:pt x="7803" y="12746"/>
                  </a:moveTo>
                  <a:lnTo>
                    <a:pt x="7823" y="12738"/>
                  </a:lnTo>
                  <a:lnTo>
                    <a:pt x="7887" y="12709"/>
                  </a:lnTo>
                  <a:lnTo>
                    <a:pt x="7937" y="12683"/>
                  </a:lnTo>
                  <a:cubicBezTo>
                    <a:pt x="7949" y="12677"/>
                    <a:pt x="7964" y="12682"/>
                    <a:pt x="7970" y="12694"/>
                  </a:cubicBezTo>
                  <a:cubicBezTo>
                    <a:pt x="7977" y="12706"/>
                    <a:pt x="7972" y="12721"/>
                    <a:pt x="7960" y="12728"/>
                  </a:cubicBezTo>
                  <a:lnTo>
                    <a:pt x="7907" y="12755"/>
                  </a:lnTo>
                  <a:lnTo>
                    <a:pt x="7842" y="12784"/>
                  </a:lnTo>
                  <a:lnTo>
                    <a:pt x="7822" y="12792"/>
                  </a:lnTo>
                  <a:cubicBezTo>
                    <a:pt x="7809" y="12797"/>
                    <a:pt x="7794" y="12791"/>
                    <a:pt x="7789" y="12778"/>
                  </a:cubicBezTo>
                  <a:cubicBezTo>
                    <a:pt x="7784" y="12765"/>
                    <a:pt x="7790" y="12751"/>
                    <a:pt x="7803" y="12746"/>
                  </a:cubicBezTo>
                  <a:close/>
                  <a:moveTo>
                    <a:pt x="8102" y="12579"/>
                  </a:moveTo>
                  <a:lnTo>
                    <a:pt x="8175" y="12524"/>
                  </a:lnTo>
                  <a:lnTo>
                    <a:pt x="8217" y="12486"/>
                  </a:lnTo>
                  <a:cubicBezTo>
                    <a:pt x="8227" y="12477"/>
                    <a:pt x="8243" y="12477"/>
                    <a:pt x="8252" y="12488"/>
                  </a:cubicBezTo>
                  <a:cubicBezTo>
                    <a:pt x="8261" y="12498"/>
                    <a:pt x="8261" y="12514"/>
                    <a:pt x="8250" y="12523"/>
                  </a:cubicBezTo>
                  <a:lnTo>
                    <a:pt x="8205" y="12564"/>
                  </a:lnTo>
                  <a:lnTo>
                    <a:pt x="8132" y="12619"/>
                  </a:lnTo>
                  <a:cubicBezTo>
                    <a:pt x="8121" y="12627"/>
                    <a:pt x="8105" y="12625"/>
                    <a:pt x="8097" y="12614"/>
                  </a:cubicBezTo>
                  <a:cubicBezTo>
                    <a:pt x="8089" y="12603"/>
                    <a:pt x="8091" y="12587"/>
                    <a:pt x="8102" y="12579"/>
                  </a:cubicBezTo>
                  <a:close/>
                  <a:moveTo>
                    <a:pt x="8355" y="12345"/>
                  </a:moveTo>
                  <a:lnTo>
                    <a:pt x="8368" y="12331"/>
                  </a:lnTo>
                  <a:lnTo>
                    <a:pt x="8445" y="12228"/>
                  </a:lnTo>
                  <a:cubicBezTo>
                    <a:pt x="8453" y="12217"/>
                    <a:pt x="8469" y="12215"/>
                    <a:pt x="8480" y="12223"/>
                  </a:cubicBezTo>
                  <a:cubicBezTo>
                    <a:pt x="8491" y="12231"/>
                    <a:pt x="8493" y="12247"/>
                    <a:pt x="8485" y="12258"/>
                  </a:cubicBezTo>
                  <a:lnTo>
                    <a:pt x="8405" y="12365"/>
                  </a:lnTo>
                  <a:lnTo>
                    <a:pt x="8392" y="12379"/>
                  </a:lnTo>
                  <a:cubicBezTo>
                    <a:pt x="8383" y="12389"/>
                    <a:pt x="8367" y="12390"/>
                    <a:pt x="8357" y="12381"/>
                  </a:cubicBezTo>
                  <a:cubicBezTo>
                    <a:pt x="8347" y="12371"/>
                    <a:pt x="8346" y="12355"/>
                    <a:pt x="8355" y="12345"/>
                  </a:cubicBezTo>
                  <a:close/>
                  <a:moveTo>
                    <a:pt x="8544" y="12059"/>
                  </a:moveTo>
                  <a:lnTo>
                    <a:pt x="8552" y="12043"/>
                  </a:lnTo>
                  <a:lnTo>
                    <a:pt x="8581" y="11980"/>
                  </a:lnTo>
                  <a:lnTo>
                    <a:pt x="8603" y="11924"/>
                  </a:lnTo>
                  <a:cubicBezTo>
                    <a:pt x="8608" y="11911"/>
                    <a:pt x="8622" y="11905"/>
                    <a:pt x="8635" y="11910"/>
                  </a:cubicBezTo>
                  <a:cubicBezTo>
                    <a:pt x="8648" y="11915"/>
                    <a:pt x="8654" y="11930"/>
                    <a:pt x="8649" y="11943"/>
                  </a:cubicBezTo>
                  <a:lnTo>
                    <a:pt x="8626" y="12001"/>
                  </a:lnTo>
                  <a:lnTo>
                    <a:pt x="8597" y="12066"/>
                  </a:lnTo>
                  <a:lnTo>
                    <a:pt x="8588" y="12082"/>
                  </a:lnTo>
                  <a:cubicBezTo>
                    <a:pt x="8582" y="12094"/>
                    <a:pt x="8567" y="12099"/>
                    <a:pt x="8555" y="12093"/>
                  </a:cubicBezTo>
                  <a:cubicBezTo>
                    <a:pt x="8542" y="12087"/>
                    <a:pt x="8538" y="12072"/>
                    <a:pt x="8544" y="12059"/>
                  </a:cubicBezTo>
                  <a:close/>
                  <a:moveTo>
                    <a:pt x="8658" y="11736"/>
                  </a:moveTo>
                  <a:lnTo>
                    <a:pt x="8664" y="11713"/>
                  </a:lnTo>
                  <a:lnTo>
                    <a:pt x="8676" y="11643"/>
                  </a:lnTo>
                  <a:lnTo>
                    <a:pt x="8683" y="11591"/>
                  </a:lnTo>
                  <a:cubicBezTo>
                    <a:pt x="8684" y="11577"/>
                    <a:pt x="8697" y="11567"/>
                    <a:pt x="8711" y="11569"/>
                  </a:cubicBezTo>
                  <a:cubicBezTo>
                    <a:pt x="8724" y="11571"/>
                    <a:pt x="8734" y="11583"/>
                    <a:pt x="8732" y="11597"/>
                  </a:cubicBezTo>
                  <a:lnTo>
                    <a:pt x="8725" y="11651"/>
                  </a:lnTo>
                  <a:lnTo>
                    <a:pt x="8712" y="11724"/>
                  </a:lnTo>
                  <a:lnTo>
                    <a:pt x="8707" y="11747"/>
                  </a:lnTo>
                  <a:cubicBezTo>
                    <a:pt x="8704" y="11761"/>
                    <a:pt x="8691" y="11769"/>
                    <a:pt x="8677" y="11766"/>
                  </a:cubicBezTo>
                  <a:cubicBezTo>
                    <a:pt x="8664" y="11763"/>
                    <a:pt x="8655" y="11750"/>
                    <a:pt x="8658" y="11736"/>
                  </a:cubicBezTo>
                  <a:close/>
                  <a:moveTo>
                    <a:pt x="8692" y="11394"/>
                  </a:moveTo>
                  <a:lnTo>
                    <a:pt x="8692" y="11244"/>
                  </a:lnTo>
                  <a:cubicBezTo>
                    <a:pt x="8692" y="11230"/>
                    <a:pt x="8704" y="11219"/>
                    <a:pt x="8717" y="11219"/>
                  </a:cubicBezTo>
                  <a:cubicBezTo>
                    <a:pt x="8731" y="11219"/>
                    <a:pt x="8742" y="11230"/>
                    <a:pt x="8742" y="11244"/>
                  </a:cubicBezTo>
                  <a:lnTo>
                    <a:pt x="8742" y="11394"/>
                  </a:lnTo>
                  <a:cubicBezTo>
                    <a:pt x="8742" y="11408"/>
                    <a:pt x="8731" y="11419"/>
                    <a:pt x="8717" y="11419"/>
                  </a:cubicBezTo>
                  <a:cubicBezTo>
                    <a:pt x="8704" y="11419"/>
                    <a:pt x="8692" y="11408"/>
                    <a:pt x="8692" y="11394"/>
                  </a:cubicBezTo>
                  <a:close/>
                  <a:moveTo>
                    <a:pt x="8692" y="11044"/>
                  </a:moveTo>
                  <a:lnTo>
                    <a:pt x="8692" y="10894"/>
                  </a:lnTo>
                  <a:cubicBezTo>
                    <a:pt x="8692" y="10880"/>
                    <a:pt x="8704" y="10869"/>
                    <a:pt x="8717" y="10869"/>
                  </a:cubicBezTo>
                  <a:cubicBezTo>
                    <a:pt x="8731" y="10869"/>
                    <a:pt x="8742" y="10880"/>
                    <a:pt x="8742" y="10894"/>
                  </a:cubicBezTo>
                  <a:lnTo>
                    <a:pt x="8742" y="11044"/>
                  </a:lnTo>
                  <a:cubicBezTo>
                    <a:pt x="8742" y="11058"/>
                    <a:pt x="8731" y="11069"/>
                    <a:pt x="8717" y="11069"/>
                  </a:cubicBezTo>
                  <a:cubicBezTo>
                    <a:pt x="8704" y="11069"/>
                    <a:pt x="8692" y="11058"/>
                    <a:pt x="8692" y="11044"/>
                  </a:cubicBezTo>
                  <a:close/>
                  <a:moveTo>
                    <a:pt x="8692" y="10694"/>
                  </a:moveTo>
                  <a:lnTo>
                    <a:pt x="8692" y="10544"/>
                  </a:lnTo>
                  <a:cubicBezTo>
                    <a:pt x="8692" y="10530"/>
                    <a:pt x="8704" y="10519"/>
                    <a:pt x="8717" y="10519"/>
                  </a:cubicBezTo>
                  <a:cubicBezTo>
                    <a:pt x="8731" y="10519"/>
                    <a:pt x="8742" y="10530"/>
                    <a:pt x="8742" y="10544"/>
                  </a:cubicBezTo>
                  <a:lnTo>
                    <a:pt x="8742" y="10694"/>
                  </a:lnTo>
                  <a:cubicBezTo>
                    <a:pt x="8742" y="10708"/>
                    <a:pt x="8731" y="10719"/>
                    <a:pt x="8717" y="10719"/>
                  </a:cubicBezTo>
                  <a:cubicBezTo>
                    <a:pt x="8704" y="10719"/>
                    <a:pt x="8692" y="10708"/>
                    <a:pt x="8692" y="10694"/>
                  </a:cubicBezTo>
                  <a:close/>
                  <a:moveTo>
                    <a:pt x="8692" y="10344"/>
                  </a:moveTo>
                  <a:lnTo>
                    <a:pt x="8692" y="10194"/>
                  </a:lnTo>
                  <a:cubicBezTo>
                    <a:pt x="8692" y="10180"/>
                    <a:pt x="8704" y="10169"/>
                    <a:pt x="8717" y="10169"/>
                  </a:cubicBezTo>
                  <a:cubicBezTo>
                    <a:pt x="8731" y="10169"/>
                    <a:pt x="8742" y="10180"/>
                    <a:pt x="8742" y="10194"/>
                  </a:cubicBezTo>
                  <a:lnTo>
                    <a:pt x="8742" y="10344"/>
                  </a:lnTo>
                  <a:cubicBezTo>
                    <a:pt x="8742" y="10358"/>
                    <a:pt x="8731" y="10369"/>
                    <a:pt x="8717" y="10369"/>
                  </a:cubicBezTo>
                  <a:cubicBezTo>
                    <a:pt x="8704" y="10369"/>
                    <a:pt x="8692" y="10358"/>
                    <a:pt x="8692" y="10344"/>
                  </a:cubicBezTo>
                  <a:close/>
                  <a:moveTo>
                    <a:pt x="8692" y="9994"/>
                  </a:moveTo>
                  <a:lnTo>
                    <a:pt x="8692" y="9844"/>
                  </a:lnTo>
                  <a:cubicBezTo>
                    <a:pt x="8692" y="9830"/>
                    <a:pt x="8704" y="9819"/>
                    <a:pt x="8717" y="9819"/>
                  </a:cubicBezTo>
                  <a:cubicBezTo>
                    <a:pt x="8731" y="9819"/>
                    <a:pt x="8742" y="9830"/>
                    <a:pt x="8742" y="9844"/>
                  </a:cubicBezTo>
                  <a:lnTo>
                    <a:pt x="8742" y="9994"/>
                  </a:lnTo>
                  <a:cubicBezTo>
                    <a:pt x="8742" y="10008"/>
                    <a:pt x="8731" y="10019"/>
                    <a:pt x="8717" y="10019"/>
                  </a:cubicBezTo>
                  <a:cubicBezTo>
                    <a:pt x="8704" y="10019"/>
                    <a:pt x="8692" y="10008"/>
                    <a:pt x="8692" y="9994"/>
                  </a:cubicBezTo>
                  <a:close/>
                  <a:moveTo>
                    <a:pt x="8692" y="9644"/>
                  </a:moveTo>
                  <a:lnTo>
                    <a:pt x="8692" y="9494"/>
                  </a:lnTo>
                  <a:cubicBezTo>
                    <a:pt x="8692" y="9480"/>
                    <a:pt x="8704" y="9469"/>
                    <a:pt x="8717" y="9469"/>
                  </a:cubicBezTo>
                  <a:cubicBezTo>
                    <a:pt x="8731" y="9469"/>
                    <a:pt x="8742" y="9480"/>
                    <a:pt x="8742" y="9494"/>
                  </a:cubicBezTo>
                  <a:lnTo>
                    <a:pt x="8742" y="9644"/>
                  </a:lnTo>
                  <a:cubicBezTo>
                    <a:pt x="8742" y="9658"/>
                    <a:pt x="8731" y="9669"/>
                    <a:pt x="8717" y="9669"/>
                  </a:cubicBezTo>
                  <a:cubicBezTo>
                    <a:pt x="8704" y="9669"/>
                    <a:pt x="8692" y="9658"/>
                    <a:pt x="8692" y="9644"/>
                  </a:cubicBezTo>
                  <a:close/>
                  <a:moveTo>
                    <a:pt x="8692" y="9294"/>
                  </a:moveTo>
                  <a:lnTo>
                    <a:pt x="8692" y="9144"/>
                  </a:lnTo>
                  <a:cubicBezTo>
                    <a:pt x="8692" y="9130"/>
                    <a:pt x="8704" y="9119"/>
                    <a:pt x="8717" y="9119"/>
                  </a:cubicBezTo>
                  <a:cubicBezTo>
                    <a:pt x="8731" y="9119"/>
                    <a:pt x="8742" y="9130"/>
                    <a:pt x="8742" y="9144"/>
                  </a:cubicBezTo>
                  <a:lnTo>
                    <a:pt x="8742" y="9294"/>
                  </a:lnTo>
                  <a:cubicBezTo>
                    <a:pt x="8742" y="9308"/>
                    <a:pt x="8731" y="9319"/>
                    <a:pt x="8717" y="9319"/>
                  </a:cubicBezTo>
                  <a:cubicBezTo>
                    <a:pt x="8704" y="9319"/>
                    <a:pt x="8692" y="9308"/>
                    <a:pt x="8692" y="9294"/>
                  </a:cubicBezTo>
                  <a:close/>
                  <a:moveTo>
                    <a:pt x="8692" y="8944"/>
                  </a:moveTo>
                  <a:lnTo>
                    <a:pt x="8692" y="8794"/>
                  </a:lnTo>
                  <a:cubicBezTo>
                    <a:pt x="8692" y="8780"/>
                    <a:pt x="8704" y="8769"/>
                    <a:pt x="8717" y="8769"/>
                  </a:cubicBezTo>
                  <a:cubicBezTo>
                    <a:pt x="8731" y="8769"/>
                    <a:pt x="8742" y="8780"/>
                    <a:pt x="8742" y="8794"/>
                  </a:cubicBezTo>
                  <a:lnTo>
                    <a:pt x="8742" y="8944"/>
                  </a:lnTo>
                  <a:cubicBezTo>
                    <a:pt x="8742" y="8958"/>
                    <a:pt x="8731" y="8969"/>
                    <a:pt x="8717" y="8969"/>
                  </a:cubicBezTo>
                  <a:cubicBezTo>
                    <a:pt x="8704" y="8969"/>
                    <a:pt x="8692" y="8958"/>
                    <a:pt x="8692" y="8944"/>
                  </a:cubicBezTo>
                  <a:close/>
                  <a:moveTo>
                    <a:pt x="8692" y="8594"/>
                  </a:moveTo>
                  <a:lnTo>
                    <a:pt x="8692" y="8444"/>
                  </a:lnTo>
                  <a:cubicBezTo>
                    <a:pt x="8692" y="8430"/>
                    <a:pt x="8704" y="8419"/>
                    <a:pt x="8717" y="8419"/>
                  </a:cubicBezTo>
                  <a:cubicBezTo>
                    <a:pt x="8731" y="8419"/>
                    <a:pt x="8742" y="8430"/>
                    <a:pt x="8742" y="8444"/>
                  </a:cubicBezTo>
                  <a:lnTo>
                    <a:pt x="8742" y="8594"/>
                  </a:lnTo>
                  <a:cubicBezTo>
                    <a:pt x="8742" y="8608"/>
                    <a:pt x="8731" y="8619"/>
                    <a:pt x="8717" y="8619"/>
                  </a:cubicBezTo>
                  <a:cubicBezTo>
                    <a:pt x="8704" y="8619"/>
                    <a:pt x="8692" y="8608"/>
                    <a:pt x="8692" y="8594"/>
                  </a:cubicBezTo>
                  <a:close/>
                  <a:moveTo>
                    <a:pt x="8692" y="8244"/>
                  </a:moveTo>
                  <a:lnTo>
                    <a:pt x="8692" y="8094"/>
                  </a:lnTo>
                  <a:cubicBezTo>
                    <a:pt x="8692" y="8080"/>
                    <a:pt x="8704" y="8069"/>
                    <a:pt x="8717" y="8069"/>
                  </a:cubicBezTo>
                  <a:cubicBezTo>
                    <a:pt x="8731" y="8069"/>
                    <a:pt x="8742" y="8080"/>
                    <a:pt x="8742" y="8094"/>
                  </a:cubicBezTo>
                  <a:lnTo>
                    <a:pt x="8742" y="8244"/>
                  </a:lnTo>
                  <a:cubicBezTo>
                    <a:pt x="8742" y="8258"/>
                    <a:pt x="8731" y="8269"/>
                    <a:pt x="8717" y="8269"/>
                  </a:cubicBezTo>
                  <a:cubicBezTo>
                    <a:pt x="8704" y="8269"/>
                    <a:pt x="8692" y="8258"/>
                    <a:pt x="8692" y="8244"/>
                  </a:cubicBezTo>
                  <a:close/>
                  <a:moveTo>
                    <a:pt x="8692" y="7894"/>
                  </a:moveTo>
                  <a:lnTo>
                    <a:pt x="8692" y="7744"/>
                  </a:lnTo>
                  <a:cubicBezTo>
                    <a:pt x="8692" y="7730"/>
                    <a:pt x="8704" y="7719"/>
                    <a:pt x="8717" y="7719"/>
                  </a:cubicBezTo>
                  <a:cubicBezTo>
                    <a:pt x="8731" y="7719"/>
                    <a:pt x="8742" y="7730"/>
                    <a:pt x="8742" y="7744"/>
                  </a:cubicBezTo>
                  <a:lnTo>
                    <a:pt x="8742" y="7894"/>
                  </a:lnTo>
                  <a:cubicBezTo>
                    <a:pt x="8742" y="7908"/>
                    <a:pt x="8731" y="7919"/>
                    <a:pt x="8717" y="7919"/>
                  </a:cubicBezTo>
                  <a:cubicBezTo>
                    <a:pt x="8704" y="7919"/>
                    <a:pt x="8692" y="7908"/>
                    <a:pt x="8692" y="7894"/>
                  </a:cubicBezTo>
                  <a:close/>
                  <a:moveTo>
                    <a:pt x="8692" y="7544"/>
                  </a:moveTo>
                  <a:lnTo>
                    <a:pt x="8692" y="7394"/>
                  </a:lnTo>
                  <a:cubicBezTo>
                    <a:pt x="8692" y="7380"/>
                    <a:pt x="8704" y="7369"/>
                    <a:pt x="8717" y="7369"/>
                  </a:cubicBezTo>
                  <a:cubicBezTo>
                    <a:pt x="8731" y="7369"/>
                    <a:pt x="8742" y="7380"/>
                    <a:pt x="8742" y="7394"/>
                  </a:cubicBezTo>
                  <a:lnTo>
                    <a:pt x="8742" y="7544"/>
                  </a:lnTo>
                  <a:cubicBezTo>
                    <a:pt x="8742" y="7558"/>
                    <a:pt x="8731" y="7569"/>
                    <a:pt x="8717" y="7569"/>
                  </a:cubicBezTo>
                  <a:cubicBezTo>
                    <a:pt x="8704" y="7569"/>
                    <a:pt x="8692" y="7558"/>
                    <a:pt x="8692" y="7544"/>
                  </a:cubicBezTo>
                  <a:close/>
                  <a:moveTo>
                    <a:pt x="8692" y="7194"/>
                  </a:moveTo>
                  <a:lnTo>
                    <a:pt x="8692" y="7044"/>
                  </a:lnTo>
                  <a:cubicBezTo>
                    <a:pt x="8692" y="7030"/>
                    <a:pt x="8704" y="7019"/>
                    <a:pt x="8717" y="7019"/>
                  </a:cubicBezTo>
                  <a:cubicBezTo>
                    <a:pt x="8731" y="7019"/>
                    <a:pt x="8742" y="7030"/>
                    <a:pt x="8742" y="7044"/>
                  </a:cubicBezTo>
                  <a:lnTo>
                    <a:pt x="8742" y="7194"/>
                  </a:lnTo>
                  <a:cubicBezTo>
                    <a:pt x="8742" y="7208"/>
                    <a:pt x="8731" y="7219"/>
                    <a:pt x="8717" y="7219"/>
                  </a:cubicBezTo>
                  <a:cubicBezTo>
                    <a:pt x="8704" y="7219"/>
                    <a:pt x="8692" y="7208"/>
                    <a:pt x="8692" y="7194"/>
                  </a:cubicBezTo>
                  <a:close/>
                  <a:moveTo>
                    <a:pt x="8692" y="6844"/>
                  </a:moveTo>
                  <a:lnTo>
                    <a:pt x="8692" y="6694"/>
                  </a:lnTo>
                  <a:cubicBezTo>
                    <a:pt x="8692" y="6680"/>
                    <a:pt x="8704" y="6669"/>
                    <a:pt x="8717" y="6669"/>
                  </a:cubicBezTo>
                  <a:cubicBezTo>
                    <a:pt x="8731" y="6669"/>
                    <a:pt x="8742" y="6680"/>
                    <a:pt x="8742" y="6694"/>
                  </a:cubicBezTo>
                  <a:lnTo>
                    <a:pt x="8742" y="6844"/>
                  </a:lnTo>
                  <a:cubicBezTo>
                    <a:pt x="8742" y="6858"/>
                    <a:pt x="8731" y="6869"/>
                    <a:pt x="8717" y="6869"/>
                  </a:cubicBezTo>
                  <a:cubicBezTo>
                    <a:pt x="8704" y="6869"/>
                    <a:pt x="8692" y="6858"/>
                    <a:pt x="8692" y="6844"/>
                  </a:cubicBezTo>
                  <a:close/>
                  <a:moveTo>
                    <a:pt x="8692" y="6494"/>
                  </a:moveTo>
                  <a:lnTo>
                    <a:pt x="8692" y="6344"/>
                  </a:lnTo>
                  <a:cubicBezTo>
                    <a:pt x="8692" y="6330"/>
                    <a:pt x="8704" y="6319"/>
                    <a:pt x="8717" y="6319"/>
                  </a:cubicBezTo>
                  <a:cubicBezTo>
                    <a:pt x="8731" y="6319"/>
                    <a:pt x="8742" y="6330"/>
                    <a:pt x="8742" y="6344"/>
                  </a:cubicBezTo>
                  <a:lnTo>
                    <a:pt x="8742" y="6494"/>
                  </a:lnTo>
                  <a:cubicBezTo>
                    <a:pt x="8742" y="6508"/>
                    <a:pt x="8731" y="6519"/>
                    <a:pt x="8717" y="6519"/>
                  </a:cubicBezTo>
                  <a:cubicBezTo>
                    <a:pt x="8704" y="6519"/>
                    <a:pt x="8692" y="6508"/>
                    <a:pt x="8692" y="6494"/>
                  </a:cubicBezTo>
                  <a:close/>
                  <a:moveTo>
                    <a:pt x="8692" y="6144"/>
                  </a:moveTo>
                  <a:lnTo>
                    <a:pt x="8692" y="5994"/>
                  </a:lnTo>
                  <a:cubicBezTo>
                    <a:pt x="8692" y="5980"/>
                    <a:pt x="8704" y="5969"/>
                    <a:pt x="8717" y="5969"/>
                  </a:cubicBezTo>
                  <a:cubicBezTo>
                    <a:pt x="8731" y="5969"/>
                    <a:pt x="8742" y="5980"/>
                    <a:pt x="8742" y="5994"/>
                  </a:cubicBezTo>
                  <a:lnTo>
                    <a:pt x="8742" y="6144"/>
                  </a:lnTo>
                  <a:cubicBezTo>
                    <a:pt x="8742" y="6158"/>
                    <a:pt x="8731" y="6169"/>
                    <a:pt x="8717" y="6169"/>
                  </a:cubicBezTo>
                  <a:cubicBezTo>
                    <a:pt x="8704" y="6169"/>
                    <a:pt x="8692" y="6158"/>
                    <a:pt x="8692" y="6144"/>
                  </a:cubicBezTo>
                  <a:close/>
                  <a:moveTo>
                    <a:pt x="8692" y="5794"/>
                  </a:moveTo>
                  <a:lnTo>
                    <a:pt x="8692" y="5644"/>
                  </a:lnTo>
                  <a:cubicBezTo>
                    <a:pt x="8692" y="5630"/>
                    <a:pt x="8704" y="5619"/>
                    <a:pt x="8717" y="5619"/>
                  </a:cubicBezTo>
                  <a:cubicBezTo>
                    <a:pt x="8731" y="5619"/>
                    <a:pt x="8742" y="5630"/>
                    <a:pt x="8742" y="5644"/>
                  </a:cubicBezTo>
                  <a:lnTo>
                    <a:pt x="8742" y="5794"/>
                  </a:lnTo>
                  <a:cubicBezTo>
                    <a:pt x="8742" y="5808"/>
                    <a:pt x="8731" y="5819"/>
                    <a:pt x="8717" y="5819"/>
                  </a:cubicBezTo>
                  <a:cubicBezTo>
                    <a:pt x="8704" y="5819"/>
                    <a:pt x="8692" y="5808"/>
                    <a:pt x="8692" y="5794"/>
                  </a:cubicBezTo>
                  <a:close/>
                  <a:moveTo>
                    <a:pt x="8692" y="5444"/>
                  </a:moveTo>
                  <a:lnTo>
                    <a:pt x="8692" y="5294"/>
                  </a:lnTo>
                  <a:cubicBezTo>
                    <a:pt x="8692" y="5280"/>
                    <a:pt x="8704" y="5269"/>
                    <a:pt x="8717" y="5269"/>
                  </a:cubicBezTo>
                  <a:cubicBezTo>
                    <a:pt x="8731" y="5269"/>
                    <a:pt x="8742" y="5280"/>
                    <a:pt x="8742" y="5294"/>
                  </a:cubicBezTo>
                  <a:lnTo>
                    <a:pt x="8742" y="5444"/>
                  </a:lnTo>
                  <a:cubicBezTo>
                    <a:pt x="8742" y="5458"/>
                    <a:pt x="8731" y="5469"/>
                    <a:pt x="8717" y="5469"/>
                  </a:cubicBezTo>
                  <a:cubicBezTo>
                    <a:pt x="8704" y="5469"/>
                    <a:pt x="8692" y="5458"/>
                    <a:pt x="8692" y="5444"/>
                  </a:cubicBezTo>
                  <a:close/>
                  <a:moveTo>
                    <a:pt x="8692" y="5094"/>
                  </a:moveTo>
                  <a:lnTo>
                    <a:pt x="8692" y="4944"/>
                  </a:lnTo>
                  <a:cubicBezTo>
                    <a:pt x="8692" y="4930"/>
                    <a:pt x="8704" y="4919"/>
                    <a:pt x="8717" y="4919"/>
                  </a:cubicBezTo>
                  <a:cubicBezTo>
                    <a:pt x="8731" y="4919"/>
                    <a:pt x="8742" y="4930"/>
                    <a:pt x="8742" y="4944"/>
                  </a:cubicBezTo>
                  <a:lnTo>
                    <a:pt x="8742" y="5094"/>
                  </a:lnTo>
                  <a:cubicBezTo>
                    <a:pt x="8742" y="5108"/>
                    <a:pt x="8731" y="5119"/>
                    <a:pt x="8717" y="5119"/>
                  </a:cubicBezTo>
                  <a:cubicBezTo>
                    <a:pt x="8704" y="5119"/>
                    <a:pt x="8692" y="5108"/>
                    <a:pt x="8692" y="5094"/>
                  </a:cubicBezTo>
                  <a:close/>
                  <a:moveTo>
                    <a:pt x="8692" y="4744"/>
                  </a:moveTo>
                  <a:lnTo>
                    <a:pt x="8692" y="4594"/>
                  </a:lnTo>
                  <a:cubicBezTo>
                    <a:pt x="8692" y="4580"/>
                    <a:pt x="8704" y="4569"/>
                    <a:pt x="8717" y="4569"/>
                  </a:cubicBezTo>
                  <a:cubicBezTo>
                    <a:pt x="8731" y="4569"/>
                    <a:pt x="8742" y="4580"/>
                    <a:pt x="8742" y="4594"/>
                  </a:cubicBezTo>
                  <a:lnTo>
                    <a:pt x="8742" y="4744"/>
                  </a:lnTo>
                  <a:cubicBezTo>
                    <a:pt x="8742" y="4758"/>
                    <a:pt x="8731" y="4769"/>
                    <a:pt x="8717" y="4769"/>
                  </a:cubicBezTo>
                  <a:cubicBezTo>
                    <a:pt x="8704" y="4769"/>
                    <a:pt x="8692" y="4758"/>
                    <a:pt x="8692" y="4744"/>
                  </a:cubicBezTo>
                  <a:close/>
                  <a:moveTo>
                    <a:pt x="8692" y="4394"/>
                  </a:moveTo>
                  <a:lnTo>
                    <a:pt x="8692" y="4244"/>
                  </a:lnTo>
                  <a:cubicBezTo>
                    <a:pt x="8692" y="4230"/>
                    <a:pt x="8704" y="4219"/>
                    <a:pt x="8717" y="4219"/>
                  </a:cubicBezTo>
                  <a:cubicBezTo>
                    <a:pt x="8731" y="4219"/>
                    <a:pt x="8742" y="4230"/>
                    <a:pt x="8742" y="4244"/>
                  </a:cubicBezTo>
                  <a:lnTo>
                    <a:pt x="8742" y="4394"/>
                  </a:lnTo>
                  <a:cubicBezTo>
                    <a:pt x="8742" y="4408"/>
                    <a:pt x="8731" y="4419"/>
                    <a:pt x="8717" y="4419"/>
                  </a:cubicBezTo>
                  <a:cubicBezTo>
                    <a:pt x="8704" y="4419"/>
                    <a:pt x="8692" y="4408"/>
                    <a:pt x="8692" y="4394"/>
                  </a:cubicBezTo>
                  <a:close/>
                  <a:moveTo>
                    <a:pt x="8692" y="4044"/>
                  </a:moveTo>
                  <a:lnTo>
                    <a:pt x="8692" y="3894"/>
                  </a:lnTo>
                  <a:cubicBezTo>
                    <a:pt x="8692" y="3880"/>
                    <a:pt x="8704" y="3869"/>
                    <a:pt x="8717" y="3869"/>
                  </a:cubicBezTo>
                  <a:cubicBezTo>
                    <a:pt x="8731" y="3869"/>
                    <a:pt x="8742" y="3880"/>
                    <a:pt x="8742" y="3894"/>
                  </a:cubicBezTo>
                  <a:lnTo>
                    <a:pt x="8742" y="4044"/>
                  </a:lnTo>
                  <a:cubicBezTo>
                    <a:pt x="8742" y="4058"/>
                    <a:pt x="8731" y="4069"/>
                    <a:pt x="8717" y="4069"/>
                  </a:cubicBezTo>
                  <a:cubicBezTo>
                    <a:pt x="8704" y="4069"/>
                    <a:pt x="8692" y="4058"/>
                    <a:pt x="8692" y="4044"/>
                  </a:cubicBezTo>
                  <a:close/>
                  <a:moveTo>
                    <a:pt x="8692" y="3694"/>
                  </a:moveTo>
                  <a:lnTo>
                    <a:pt x="8692" y="3544"/>
                  </a:lnTo>
                  <a:cubicBezTo>
                    <a:pt x="8692" y="3530"/>
                    <a:pt x="8704" y="3519"/>
                    <a:pt x="8717" y="3519"/>
                  </a:cubicBezTo>
                  <a:cubicBezTo>
                    <a:pt x="8731" y="3519"/>
                    <a:pt x="8742" y="3530"/>
                    <a:pt x="8742" y="3544"/>
                  </a:cubicBezTo>
                  <a:lnTo>
                    <a:pt x="8742" y="3694"/>
                  </a:lnTo>
                  <a:cubicBezTo>
                    <a:pt x="8742" y="3708"/>
                    <a:pt x="8731" y="3719"/>
                    <a:pt x="8717" y="3719"/>
                  </a:cubicBezTo>
                  <a:cubicBezTo>
                    <a:pt x="8704" y="3719"/>
                    <a:pt x="8692" y="3708"/>
                    <a:pt x="8692" y="3694"/>
                  </a:cubicBezTo>
                  <a:close/>
                  <a:moveTo>
                    <a:pt x="8692" y="3344"/>
                  </a:moveTo>
                  <a:lnTo>
                    <a:pt x="8692" y="3194"/>
                  </a:lnTo>
                  <a:cubicBezTo>
                    <a:pt x="8692" y="3180"/>
                    <a:pt x="8704" y="3169"/>
                    <a:pt x="8717" y="3169"/>
                  </a:cubicBezTo>
                  <a:cubicBezTo>
                    <a:pt x="8731" y="3169"/>
                    <a:pt x="8742" y="3180"/>
                    <a:pt x="8742" y="3194"/>
                  </a:cubicBezTo>
                  <a:lnTo>
                    <a:pt x="8742" y="3344"/>
                  </a:lnTo>
                  <a:cubicBezTo>
                    <a:pt x="8742" y="3358"/>
                    <a:pt x="8731" y="3369"/>
                    <a:pt x="8717" y="3369"/>
                  </a:cubicBezTo>
                  <a:cubicBezTo>
                    <a:pt x="8704" y="3369"/>
                    <a:pt x="8692" y="3358"/>
                    <a:pt x="8692" y="3344"/>
                  </a:cubicBezTo>
                  <a:close/>
                  <a:moveTo>
                    <a:pt x="8692" y="2994"/>
                  </a:moveTo>
                  <a:lnTo>
                    <a:pt x="8692" y="2844"/>
                  </a:lnTo>
                  <a:cubicBezTo>
                    <a:pt x="8692" y="2830"/>
                    <a:pt x="8704" y="2819"/>
                    <a:pt x="8717" y="2819"/>
                  </a:cubicBezTo>
                  <a:cubicBezTo>
                    <a:pt x="8731" y="2819"/>
                    <a:pt x="8742" y="2830"/>
                    <a:pt x="8742" y="2844"/>
                  </a:cubicBezTo>
                  <a:lnTo>
                    <a:pt x="8742" y="2994"/>
                  </a:lnTo>
                  <a:cubicBezTo>
                    <a:pt x="8742" y="3008"/>
                    <a:pt x="8731" y="3019"/>
                    <a:pt x="8717" y="3019"/>
                  </a:cubicBezTo>
                  <a:cubicBezTo>
                    <a:pt x="8704" y="3019"/>
                    <a:pt x="8692" y="3008"/>
                    <a:pt x="8692" y="2994"/>
                  </a:cubicBezTo>
                  <a:close/>
                  <a:moveTo>
                    <a:pt x="8692" y="2644"/>
                  </a:moveTo>
                  <a:lnTo>
                    <a:pt x="8692" y="2494"/>
                  </a:lnTo>
                  <a:cubicBezTo>
                    <a:pt x="8692" y="2480"/>
                    <a:pt x="8704" y="2469"/>
                    <a:pt x="8717" y="2469"/>
                  </a:cubicBezTo>
                  <a:cubicBezTo>
                    <a:pt x="8731" y="2469"/>
                    <a:pt x="8742" y="2480"/>
                    <a:pt x="8742" y="2494"/>
                  </a:cubicBezTo>
                  <a:lnTo>
                    <a:pt x="8742" y="2644"/>
                  </a:lnTo>
                  <a:cubicBezTo>
                    <a:pt x="8742" y="2658"/>
                    <a:pt x="8731" y="2669"/>
                    <a:pt x="8717" y="2669"/>
                  </a:cubicBezTo>
                  <a:cubicBezTo>
                    <a:pt x="8704" y="2669"/>
                    <a:pt x="8692" y="2658"/>
                    <a:pt x="8692" y="2644"/>
                  </a:cubicBezTo>
                  <a:close/>
                  <a:moveTo>
                    <a:pt x="8692" y="2294"/>
                  </a:moveTo>
                  <a:lnTo>
                    <a:pt x="8692" y="2144"/>
                  </a:lnTo>
                  <a:cubicBezTo>
                    <a:pt x="8692" y="2130"/>
                    <a:pt x="8704" y="2119"/>
                    <a:pt x="8717" y="2119"/>
                  </a:cubicBezTo>
                  <a:cubicBezTo>
                    <a:pt x="8731" y="2119"/>
                    <a:pt x="8742" y="2130"/>
                    <a:pt x="8742" y="2144"/>
                  </a:cubicBezTo>
                  <a:lnTo>
                    <a:pt x="8742" y="2294"/>
                  </a:lnTo>
                  <a:cubicBezTo>
                    <a:pt x="8742" y="2308"/>
                    <a:pt x="8731" y="2319"/>
                    <a:pt x="8717" y="2319"/>
                  </a:cubicBezTo>
                  <a:cubicBezTo>
                    <a:pt x="8704" y="2319"/>
                    <a:pt x="8692" y="2308"/>
                    <a:pt x="8692" y="2294"/>
                  </a:cubicBezTo>
                  <a:close/>
                  <a:moveTo>
                    <a:pt x="8692" y="1944"/>
                  </a:moveTo>
                  <a:lnTo>
                    <a:pt x="8692" y="1794"/>
                  </a:lnTo>
                  <a:cubicBezTo>
                    <a:pt x="8692" y="1780"/>
                    <a:pt x="8704" y="1769"/>
                    <a:pt x="8717" y="1769"/>
                  </a:cubicBezTo>
                  <a:cubicBezTo>
                    <a:pt x="8731" y="1769"/>
                    <a:pt x="8742" y="1780"/>
                    <a:pt x="8742" y="1794"/>
                  </a:cubicBezTo>
                  <a:lnTo>
                    <a:pt x="8742" y="1944"/>
                  </a:lnTo>
                  <a:cubicBezTo>
                    <a:pt x="8742" y="1958"/>
                    <a:pt x="8731" y="1969"/>
                    <a:pt x="8717" y="1969"/>
                  </a:cubicBezTo>
                  <a:cubicBezTo>
                    <a:pt x="8704" y="1969"/>
                    <a:pt x="8692" y="1958"/>
                    <a:pt x="8692" y="1944"/>
                  </a:cubicBezTo>
                  <a:close/>
                  <a:moveTo>
                    <a:pt x="8692" y="1594"/>
                  </a:moveTo>
                  <a:lnTo>
                    <a:pt x="8692" y="1473"/>
                  </a:lnTo>
                  <a:lnTo>
                    <a:pt x="8692" y="1445"/>
                  </a:lnTo>
                  <a:cubicBezTo>
                    <a:pt x="8691" y="1431"/>
                    <a:pt x="8702" y="1420"/>
                    <a:pt x="8716" y="1419"/>
                  </a:cubicBezTo>
                  <a:cubicBezTo>
                    <a:pt x="8730" y="1419"/>
                    <a:pt x="8741" y="1430"/>
                    <a:pt x="8742" y="1444"/>
                  </a:cubicBezTo>
                  <a:lnTo>
                    <a:pt x="8742" y="1473"/>
                  </a:lnTo>
                  <a:lnTo>
                    <a:pt x="8742" y="1594"/>
                  </a:lnTo>
                  <a:cubicBezTo>
                    <a:pt x="8742" y="1608"/>
                    <a:pt x="8731" y="1619"/>
                    <a:pt x="8717" y="1619"/>
                  </a:cubicBezTo>
                  <a:cubicBezTo>
                    <a:pt x="8704" y="1619"/>
                    <a:pt x="8692" y="1608"/>
                    <a:pt x="8692" y="1594"/>
                  </a:cubicBezTo>
                  <a:close/>
                  <a:moveTo>
                    <a:pt x="8675" y="1250"/>
                  </a:moveTo>
                  <a:lnTo>
                    <a:pt x="8663" y="1186"/>
                  </a:lnTo>
                  <a:lnTo>
                    <a:pt x="8648" y="1117"/>
                  </a:lnTo>
                  <a:lnTo>
                    <a:pt x="8644" y="1105"/>
                  </a:lnTo>
                  <a:cubicBezTo>
                    <a:pt x="8640" y="1092"/>
                    <a:pt x="8648" y="1078"/>
                    <a:pt x="8661" y="1075"/>
                  </a:cubicBezTo>
                  <a:cubicBezTo>
                    <a:pt x="8675" y="1071"/>
                    <a:pt x="8689" y="1078"/>
                    <a:pt x="8692" y="1092"/>
                  </a:cubicBezTo>
                  <a:lnTo>
                    <a:pt x="8696" y="1106"/>
                  </a:lnTo>
                  <a:lnTo>
                    <a:pt x="8713" y="1177"/>
                  </a:lnTo>
                  <a:lnTo>
                    <a:pt x="8724" y="1241"/>
                  </a:lnTo>
                  <a:cubicBezTo>
                    <a:pt x="8727" y="1254"/>
                    <a:pt x="8718" y="1267"/>
                    <a:pt x="8704" y="1270"/>
                  </a:cubicBezTo>
                  <a:cubicBezTo>
                    <a:pt x="8690" y="1272"/>
                    <a:pt x="8677" y="1263"/>
                    <a:pt x="8675" y="1250"/>
                  </a:cubicBezTo>
                  <a:close/>
                  <a:moveTo>
                    <a:pt x="8580" y="918"/>
                  </a:moveTo>
                  <a:lnTo>
                    <a:pt x="8580" y="918"/>
                  </a:lnTo>
                  <a:lnTo>
                    <a:pt x="8552" y="856"/>
                  </a:lnTo>
                  <a:lnTo>
                    <a:pt x="8520" y="794"/>
                  </a:lnTo>
                  <a:lnTo>
                    <a:pt x="8516" y="788"/>
                  </a:lnTo>
                  <a:cubicBezTo>
                    <a:pt x="8509" y="776"/>
                    <a:pt x="8513" y="761"/>
                    <a:pt x="8525" y="754"/>
                  </a:cubicBezTo>
                  <a:cubicBezTo>
                    <a:pt x="8536" y="746"/>
                    <a:pt x="8552" y="750"/>
                    <a:pt x="8559" y="762"/>
                  </a:cubicBezTo>
                  <a:lnTo>
                    <a:pt x="8565" y="772"/>
                  </a:lnTo>
                  <a:lnTo>
                    <a:pt x="8597" y="835"/>
                  </a:lnTo>
                  <a:lnTo>
                    <a:pt x="8627" y="901"/>
                  </a:lnTo>
                  <a:cubicBezTo>
                    <a:pt x="8632" y="914"/>
                    <a:pt x="8625" y="928"/>
                    <a:pt x="8612" y="933"/>
                  </a:cubicBezTo>
                  <a:cubicBezTo>
                    <a:pt x="8599" y="938"/>
                    <a:pt x="8585" y="931"/>
                    <a:pt x="8580" y="918"/>
                  </a:cubicBezTo>
                  <a:close/>
                  <a:moveTo>
                    <a:pt x="8408" y="623"/>
                  </a:moveTo>
                  <a:lnTo>
                    <a:pt x="8366" y="567"/>
                  </a:lnTo>
                  <a:lnTo>
                    <a:pt x="8314" y="509"/>
                  </a:lnTo>
                  <a:cubicBezTo>
                    <a:pt x="8305" y="499"/>
                    <a:pt x="8305" y="483"/>
                    <a:pt x="8316" y="474"/>
                  </a:cubicBezTo>
                  <a:cubicBezTo>
                    <a:pt x="8326" y="465"/>
                    <a:pt x="8342" y="465"/>
                    <a:pt x="8351" y="476"/>
                  </a:cubicBezTo>
                  <a:lnTo>
                    <a:pt x="8406" y="537"/>
                  </a:lnTo>
                  <a:lnTo>
                    <a:pt x="8448" y="593"/>
                  </a:lnTo>
                  <a:cubicBezTo>
                    <a:pt x="8456" y="604"/>
                    <a:pt x="8454" y="619"/>
                    <a:pt x="8443" y="628"/>
                  </a:cubicBezTo>
                  <a:cubicBezTo>
                    <a:pt x="8432" y="636"/>
                    <a:pt x="8416" y="634"/>
                    <a:pt x="8408" y="623"/>
                  </a:cubicBezTo>
                  <a:close/>
                  <a:moveTo>
                    <a:pt x="8173" y="374"/>
                  </a:moveTo>
                  <a:lnTo>
                    <a:pt x="8063" y="292"/>
                  </a:lnTo>
                  <a:lnTo>
                    <a:pt x="8054" y="287"/>
                  </a:lnTo>
                  <a:cubicBezTo>
                    <a:pt x="8042" y="280"/>
                    <a:pt x="8039" y="264"/>
                    <a:pt x="8046" y="253"/>
                  </a:cubicBezTo>
                  <a:cubicBezTo>
                    <a:pt x="8053" y="241"/>
                    <a:pt x="8068" y="237"/>
                    <a:pt x="8080" y="244"/>
                  </a:cubicBezTo>
                  <a:lnTo>
                    <a:pt x="8093" y="252"/>
                  </a:lnTo>
                  <a:lnTo>
                    <a:pt x="8203" y="334"/>
                  </a:lnTo>
                  <a:cubicBezTo>
                    <a:pt x="8214" y="343"/>
                    <a:pt x="8216" y="358"/>
                    <a:pt x="8208" y="369"/>
                  </a:cubicBezTo>
                  <a:cubicBezTo>
                    <a:pt x="8200" y="380"/>
                    <a:pt x="8184" y="383"/>
                    <a:pt x="8173" y="374"/>
                  </a:cubicBezTo>
                  <a:close/>
                  <a:moveTo>
                    <a:pt x="7883" y="189"/>
                  </a:moveTo>
                  <a:lnTo>
                    <a:pt x="7822" y="162"/>
                  </a:lnTo>
                  <a:lnTo>
                    <a:pt x="7758" y="136"/>
                  </a:lnTo>
                  <a:lnTo>
                    <a:pt x="7747" y="133"/>
                  </a:lnTo>
                  <a:cubicBezTo>
                    <a:pt x="7734" y="128"/>
                    <a:pt x="7727" y="114"/>
                    <a:pt x="7731" y="101"/>
                  </a:cubicBezTo>
                  <a:cubicBezTo>
                    <a:pt x="7736" y="88"/>
                    <a:pt x="7750" y="81"/>
                    <a:pt x="7763" y="85"/>
                  </a:cubicBezTo>
                  <a:lnTo>
                    <a:pt x="7776" y="90"/>
                  </a:lnTo>
                  <a:lnTo>
                    <a:pt x="7843" y="116"/>
                  </a:lnTo>
                  <a:lnTo>
                    <a:pt x="7904" y="144"/>
                  </a:lnTo>
                  <a:cubicBezTo>
                    <a:pt x="7916" y="150"/>
                    <a:pt x="7922" y="164"/>
                    <a:pt x="7916" y="177"/>
                  </a:cubicBezTo>
                  <a:cubicBezTo>
                    <a:pt x="7911" y="190"/>
                    <a:pt x="7896" y="195"/>
                    <a:pt x="7883" y="189"/>
                  </a:cubicBezTo>
                  <a:close/>
                  <a:moveTo>
                    <a:pt x="7557" y="79"/>
                  </a:moveTo>
                  <a:lnTo>
                    <a:pt x="7555" y="79"/>
                  </a:lnTo>
                  <a:lnTo>
                    <a:pt x="7485" y="66"/>
                  </a:lnTo>
                  <a:lnTo>
                    <a:pt x="7414" y="57"/>
                  </a:lnTo>
                  <a:lnTo>
                    <a:pt x="7413" y="57"/>
                  </a:lnTo>
                  <a:cubicBezTo>
                    <a:pt x="7399" y="56"/>
                    <a:pt x="7389" y="44"/>
                    <a:pt x="7390" y="30"/>
                  </a:cubicBezTo>
                  <a:cubicBezTo>
                    <a:pt x="7391" y="17"/>
                    <a:pt x="7403" y="6"/>
                    <a:pt x="7416" y="7"/>
                  </a:cubicBezTo>
                  <a:lnTo>
                    <a:pt x="7420" y="8"/>
                  </a:lnTo>
                  <a:lnTo>
                    <a:pt x="7494" y="17"/>
                  </a:lnTo>
                  <a:lnTo>
                    <a:pt x="7566" y="30"/>
                  </a:lnTo>
                  <a:lnTo>
                    <a:pt x="7568" y="31"/>
                  </a:lnTo>
                  <a:cubicBezTo>
                    <a:pt x="7582" y="34"/>
                    <a:pt x="7590" y="47"/>
                    <a:pt x="7587" y="61"/>
                  </a:cubicBezTo>
                  <a:cubicBezTo>
                    <a:pt x="7584" y="74"/>
                    <a:pt x="7571" y="82"/>
                    <a:pt x="7557" y="79"/>
                  </a:cubicBez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180"/>
            <p:cNvSpPr/>
            <p:nvPr/>
          </p:nvSpPr>
          <p:spPr>
            <a:xfrm>
              <a:off x="3144960" y="4253760"/>
              <a:ext cx="875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A/JA cross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Rectangle 181"/>
            <p:cNvSpPr/>
            <p:nvPr/>
          </p:nvSpPr>
          <p:spPr>
            <a:xfrm>
              <a:off x="4014000" y="4253760"/>
              <a:ext cx="314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alk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182"/>
            <p:cNvSpPr/>
            <p:nvPr/>
          </p:nvSpPr>
          <p:spPr>
            <a:xfrm>
              <a:off x="4757040" y="4579560"/>
              <a:ext cx="1000440" cy="26568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183"/>
            <p:cNvSpPr/>
            <p:nvPr/>
          </p:nvSpPr>
          <p:spPr>
            <a:xfrm>
              <a:off x="4967640" y="4631040"/>
              <a:ext cx="680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Arial"/>
                </a:rPr>
                <a:t>CYP81D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02" name="Group 186"/>
            <p:cNvGrpSpPr/>
            <p:nvPr/>
          </p:nvGrpSpPr>
          <p:grpSpPr>
            <a:xfrm>
              <a:off x="5821560" y="4579560"/>
              <a:ext cx="501120" cy="273600"/>
              <a:chOff x="5821560" y="4579560"/>
              <a:chExt cx="501120" cy="273600"/>
            </a:xfrm>
          </p:grpSpPr>
          <p:sp>
            <p:nvSpPr>
              <p:cNvPr id="203" name="Rectangle 184"/>
              <p:cNvSpPr/>
              <p:nvPr/>
            </p:nvSpPr>
            <p:spPr>
              <a:xfrm>
                <a:off x="5821560" y="4579560"/>
                <a:ext cx="501120" cy="273600"/>
              </a:xfrm>
              <a:prstGeom prst="rect">
                <a:avLst/>
              </a:prstGeom>
              <a:solidFill>
                <a:srgbClr val="33339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Rectangle 185"/>
              <p:cNvSpPr/>
              <p:nvPr/>
            </p:nvSpPr>
            <p:spPr>
              <a:xfrm>
                <a:off x="5821560" y="4579560"/>
                <a:ext cx="501120" cy="273600"/>
              </a:xfrm>
              <a:prstGeom prst="rect">
                <a:avLst/>
              </a:prstGeom>
              <a:noFill/>
              <a:ln cap="rnd"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5" name="Rectangle 187"/>
            <p:cNvSpPr/>
            <p:nvPr/>
          </p:nvSpPr>
          <p:spPr>
            <a:xfrm>
              <a:off x="5960880" y="4634280"/>
              <a:ext cx="3070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Arial"/>
                </a:rPr>
                <a:t>BG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188"/>
            <p:cNvSpPr/>
            <p:nvPr/>
          </p:nvSpPr>
          <p:spPr>
            <a:xfrm>
              <a:off x="4757040" y="4892760"/>
              <a:ext cx="1188360" cy="26568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189"/>
            <p:cNvSpPr/>
            <p:nvPr/>
          </p:nvSpPr>
          <p:spPr>
            <a:xfrm>
              <a:off x="4901040" y="4944600"/>
              <a:ext cx="476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Arial"/>
                </a:rPr>
                <a:t>Jacal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190"/>
            <p:cNvSpPr/>
            <p:nvPr/>
          </p:nvSpPr>
          <p:spPr>
            <a:xfrm>
              <a:off x="5394600" y="49946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At3g164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Freeform 191"/>
            <p:cNvSpPr/>
            <p:nvPr/>
          </p:nvSpPr>
          <p:spPr>
            <a:xfrm>
              <a:off x="6071040" y="2322720"/>
              <a:ext cx="646560" cy="2676240"/>
            </a:xfrm>
            <a:custGeom>
              <a:avLst/>
              <a:gdLst>
                <a:gd name="textAreaLeft" fmla="*/ 0 w 646560"/>
                <a:gd name="textAreaRight" fmla="*/ 646920 w 646560"/>
                <a:gd name="textAreaTop" fmla="*/ 0 h 2676240"/>
                <a:gd name="textAreaBottom" fmla="*/ 2676240 h 2676240"/>
              </a:gdLst>
              <a:ahLst/>
              <a:rect l="textAreaLeft" t="textAreaTop" r="textAreaRight" b="textAreaBottom"/>
              <a:pathLst>
                <a:path w="413" h="1709">
                  <a:moveTo>
                    <a:pt x="0" y="0"/>
                  </a:moveTo>
                  <a:lnTo>
                    <a:pt x="43" y="0"/>
                  </a:lnTo>
                  <a:lnTo>
                    <a:pt x="43" y="11"/>
                  </a:lnTo>
                  <a:lnTo>
                    <a:pt x="0" y="11"/>
                  </a:lnTo>
                  <a:lnTo>
                    <a:pt x="0" y="0"/>
                  </a:lnTo>
                  <a:close/>
                  <a:moveTo>
                    <a:pt x="75" y="0"/>
                  </a:moveTo>
                  <a:lnTo>
                    <a:pt x="117" y="0"/>
                  </a:lnTo>
                  <a:lnTo>
                    <a:pt x="117" y="11"/>
                  </a:lnTo>
                  <a:lnTo>
                    <a:pt x="75" y="11"/>
                  </a:lnTo>
                  <a:lnTo>
                    <a:pt x="75" y="0"/>
                  </a:lnTo>
                  <a:close/>
                  <a:moveTo>
                    <a:pt x="149" y="0"/>
                  </a:moveTo>
                  <a:lnTo>
                    <a:pt x="191" y="0"/>
                  </a:lnTo>
                  <a:lnTo>
                    <a:pt x="191" y="11"/>
                  </a:lnTo>
                  <a:lnTo>
                    <a:pt x="149" y="11"/>
                  </a:lnTo>
                  <a:lnTo>
                    <a:pt x="149" y="0"/>
                  </a:lnTo>
                  <a:close/>
                  <a:moveTo>
                    <a:pt x="223" y="0"/>
                  </a:moveTo>
                  <a:lnTo>
                    <a:pt x="265" y="0"/>
                  </a:lnTo>
                  <a:lnTo>
                    <a:pt x="265" y="11"/>
                  </a:lnTo>
                  <a:lnTo>
                    <a:pt x="223" y="11"/>
                  </a:lnTo>
                  <a:lnTo>
                    <a:pt x="223" y="0"/>
                  </a:lnTo>
                  <a:close/>
                  <a:moveTo>
                    <a:pt x="297" y="0"/>
                  </a:moveTo>
                  <a:lnTo>
                    <a:pt x="339" y="0"/>
                  </a:lnTo>
                  <a:lnTo>
                    <a:pt x="339" y="11"/>
                  </a:lnTo>
                  <a:lnTo>
                    <a:pt x="297" y="11"/>
                  </a:lnTo>
                  <a:lnTo>
                    <a:pt x="297" y="0"/>
                  </a:lnTo>
                  <a:close/>
                  <a:moveTo>
                    <a:pt x="371" y="0"/>
                  </a:moveTo>
                  <a:lnTo>
                    <a:pt x="413" y="0"/>
                  </a:lnTo>
                  <a:lnTo>
                    <a:pt x="413" y="11"/>
                  </a:lnTo>
                  <a:lnTo>
                    <a:pt x="402" y="11"/>
                  </a:lnTo>
                  <a:lnTo>
                    <a:pt x="402" y="5"/>
                  </a:lnTo>
                  <a:lnTo>
                    <a:pt x="407" y="11"/>
                  </a:lnTo>
                  <a:lnTo>
                    <a:pt x="371" y="11"/>
                  </a:lnTo>
                  <a:lnTo>
                    <a:pt x="371" y="0"/>
                  </a:lnTo>
                  <a:close/>
                  <a:moveTo>
                    <a:pt x="413" y="43"/>
                  </a:moveTo>
                  <a:lnTo>
                    <a:pt x="413" y="85"/>
                  </a:lnTo>
                  <a:lnTo>
                    <a:pt x="402" y="85"/>
                  </a:lnTo>
                  <a:lnTo>
                    <a:pt x="402" y="43"/>
                  </a:lnTo>
                  <a:lnTo>
                    <a:pt x="413" y="43"/>
                  </a:lnTo>
                  <a:close/>
                  <a:moveTo>
                    <a:pt x="413" y="117"/>
                  </a:moveTo>
                  <a:lnTo>
                    <a:pt x="413" y="160"/>
                  </a:lnTo>
                  <a:lnTo>
                    <a:pt x="402" y="160"/>
                  </a:lnTo>
                  <a:lnTo>
                    <a:pt x="402" y="117"/>
                  </a:lnTo>
                  <a:lnTo>
                    <a:pt x="413" y="117"/>
                  </a:lnTo>
                  <a:close/>
                  <a:moveTo>
                    <a:pt x="413" y="191"/>
                  </a:moveTo>
                  <a:lnTo>
                    <a:pt x="413" y="234"/>
                  </a:lnTo>
                  <a:lnTo>
                    <a:pt x="402" y="234"/>
                  </a:lnTo>
                  <a:lnTo>
                    <a:pt x="402" y="191"/>
                  </a:lnTo>
                  <a:lnTo>
                    <a:pt x="413" y="191"/>
                  </a:lnTo>
                  <a:close/>
                  <a:moveTo>
                    <a:pt x="413" y="265"/>
                  </a:moveTo>
                  <a:lnTo>
                    <a:pt x="413" y="308"/>
                  </a:lnTo>
                  <a:lnTo>
                    <a:pt x="402" y="308"/>
                  </a:lnTo>
                  <a:lnTo>
                    <a:pt x="402" y="265"/>
                  </a:lnTo>
                  <a:lnTo>
                    <a:pt x="413" y="265"/>
                  </a:lnTo>
                  <a:close/>
                  <a:moveTo>
                    <a:pt x="413" y="339"/>
                  </a:moveTo>
                  <a:lnTo>
                    <a:pt x="413" y="382"/>
                  </a:lnTo>
                  <a:lnTo>
                    <a:pt x="402" y="382"/>
                  </a:lnTo>
                  <a:lnTo>
                    <a:pt x="402" y="339"/>
                  </a:lnTo>
                  <a:lnTo>
                    <a:pt x="413" y="339"/>
                  </a:lnTo>
                  <a:close/>
                  <a:moveTo>
                    <a:pt x="413" y="414"/>
                  </a:moveTo>
                  <a:lnTo>
                    <a:pt x="413" y="456"/>
                  </a:lnTo>
                  <a:lnTo>
                    <a:pt x="402" y="456"/>
                  </a:lnTo>
                  <a:lnTo>
                    <a:pt x="402" y="414"/>
                  </a:lnTo>
                  <a:lnTo>
                    <a:pt x="413" y="414"/>
                  </a:lnTo>
                  <a:close/>
                  <a:moveTo>
                    <a:pt x="413" y="488"/>
                  </a:moveTo>
                  <a:lnTo>
                    <a:pt x="413" y="530"/>
                  </a:lnTo>
                  <a:lnTo>
                    <a:pt x="402" y="530"/>
                  </a:lnTo>
                  <a:lnTo>
                    <a:pt x="402" y="488"/>
                  </a:lnTo>
                  <a:lnTo>
                    <a:pt x="413" y="488"/>
                  </a:lnTo>
                  <a:close/>
                  <a:moveTo>
                    <a:pt x="413" y="562"/>
                  </a:moveTo>
                  <a:lnTo>
                    <a:pt x="413" y="604"/>
                  </a:lnTo>
                  <a:lnTo>
                    <a:pt x="402" y="604"/>
                  </a:lnTo>
                  <a:lnTo>
                    <a:pt x="402" y="562"/>
                  </a:lnTo>
                  <a:lnTo>
                    <a:pt x="413" y="562"/>
                  </a:lnTo>
                  <a:close/>
                  <a:moveTo>
                    <a:pt x="413" y="636"/>
                  </a:moveTo>
                  <a:lnTo>
                    <a:pt x="413" y="678"/>
                  </a:lnTo>
                  <a:lnTo>
                    <a:pt x="402" y="678"/>
                  </a:lnTo>
                  <a:lnTo>
                    <a:pt x="402" y="636"/>
                  </a:lnTo>
                  <a:lnTo>
                    <a:pt x="413" y="636"/>
                  </a:lnTo>
                  <a:close/>
                  <a:moveTo>
                    <a:pt x="413" y="710"/>
                  </a:moveTo>
                  <a:lnTo>
                    <a:pt x="413" y="752"/>
                  </a:lnTo>
                  <a:lnTo>
                    <a:pt x="402" y="752"/>
                  </a:lnTo>
                  <a:lnTo>
                    <a:pt x="402" y="710"/>
                  </a:lnTo>
                  <a:lnTo>
                    <a:pt x="413" y="710"/>
                  </a:lnTo>
                  <a:close/>
                  <a:moveTo>
                    <a:pt x="413" y="784"/>
                  </a:moveTo>
                  <a:lnTo>
                    <a:pt x="413" y="826"/>
                  </a:lnTo>
                  <a:lnTo>
                    <a:pt x="402" y="826"/>
                  </a:lnTo>
                  <a:lnTo>
                    <a:pt x="402" y="784"/>
                  </a:lnTo>
                  <a:lnTo>
                    <a:pt x="413" y="784"/>
                  </a:lnTo>
                  <a:close/>
                  <a:moveTo>
                    <a:pt x="413" y="858"/>
                  </a:moveTo>
                  <a:lnTo>
                    <a:pt x="413" y="901"/>
                  </a:lnTo>
                  <a:lnTo>
                    <a:pt x="402" y="901"/>
                  </a:lnTo>
                  <a:lnTo>
                    <a:pt x="402" y="858"/>
                  </a:lnTo>
                  <a:lnTo>
                    <a:pt x="413" y="858"/>
                  </a:lnTo>
                  <a:close/>
                  <a:moveTo>
                    <a:pt x="413" y="932"/>
                  </a:moveTo>
                  <a:lnTo>
                    <a:pt x="413" y="975"/>
                  </a:lnTo>
                  <a:lnTo>
                    <a:pt x="402" y="975"/>
                  </a:lnTo>
                  <a:lnTo>
                    <a:pt x="402" y="932"/>
                  </a:lnTo>
                  <a:lnTo>
                    <a:pt x="413" y="932"/>
                  </a:lnTo>
                  <a:close/>
                  <a:moveTo>
                    <a:pt x="413" y="1006"/>
                  </a:moveTo>
                  <a:lnTo>
                    <a:pt x="413" y="1049"/>
                  </a:lnTo>
                  <a:lnTo>
                    <a:pt x="402" y="1049"/>
                  </a:lnTo>
                  <a:lnTo>
                    <a:pt x="402" y="1006"/>
                  </a:lnTo>
                  <a:lnTo>
                    <a:pt x="413" y="1006"/>
                  </a:lnTo>
                  <a:close/>
                  <a:moveTo>
                    <a:pt x="413" y="1080"/>
                  </a:moveTo>
                  <a:lnTo>
                    <a:pt x="413" y="1123"/>
                  </a:lnTo>
                  <a:lnTo>
                    <a:pt x="402" y="1123"/>
                  </a:lnTo>
                  <a:lnTo>
                    <a:pt x="402" y="1080"/>
                  </a:lnTo>
                  <a:lnTo>
                    <a:pt x="413" y="1080"/>
                  </a:lnTo>
                  <a:close/>
                  <a:moveTo>
                    <a:pt x="413" y="1155"/>
                  </a:moveTo>
                  <a:lnTo>
                    <a:pt x="413" y="1197"/>
                  </a:lnTo>
                  <a:lnTo>
                    <a:pt x="402" y="1197"/>
                  </a:lnTo>
                  <a:lnTo>
                    <a:pt x="402" y="1155"/>
                  </a:lnTo>
                  <a:lnTo>
                    <a:pt x="413" y="1155"/>
                  </a:lnTo>
                  <a:close/>
                  <a:moveTo>
                    <a:pt x="413" y="1229"/>
                  </a:moveTo>
                  <a:lnTo>
                    <a:pt x="413" y="1271"/>
                  </a:lnTo>
                  <a:lnTo>
                    <a:pt x="402" y="1271"/>
                  </a:lnTo>
                  <a:lnTo>
                    <a:pt x="402" y="1229"/>
                  </a:lnTo>
                  <a:lnTo>
                    <a:pt x="413" y="1229"/>
                  </a:lnTo>
                  <a:close/>
                  <a:moveTo>
                    <a:pt x="413" y="1303"/>
                  </a:moveTo>
                  <a:lnTo>
                    <a:pt x="413" y="1345"/>
                  </a:lnTo>
                  <a:lnTo>
                    <a:pt x="402" y="1345"/>
                  </a:lnTo>
                  <a:lnTo>
                    <a:pt x="402" y="1303"/>
                  </a:lnTo>
                  <a:lnTo>
                    <a:pt x="413" y="1303"/>
                  </a:lnTo>
                  <a:close/>
                  <a:moveTo>
                    <a:pt x="413" y="1377"/>
                  </a:moveTo>
                  <a:lnTo>
                    <a:pt x="413" y="1419"/>
                  </a:lnTo>
                  <a:lnTo>
                    <a:pt x="402" y="1419"/>
                  </a:lnTo>
                  <a:lnTo>
                    <a:pt x="402" y="1377"/>
                  </a:lnTo>
                  <a:lnTo>
                    <a:pt x="413" y="1377"/>
                  </a:lnTo>
                  <a:close/>
                  <a:moveTo>
                    <a:pt x="413" y="1451"/>
                  </a:moveTo>
                  <a:lnTo>
                    <a:pt x="413" y="1493"/>
                  </a:lnTo>
                  <a:lnTo>
                    <a:pt x="402" y="1493"/>
                  </a:lnTo>
                  <a:lnTo>
                    <a:pt x="402" y="1451"/>
                  </a:lnTo>
                  <a:lnTo>
                    <a:pt x="413" y="1451"/>
                  </a:lnTo>
                  <a:close/>
                  <a:moveTo>
                    <a:pt x="413" y="1525"/>
                  </a:moveTo>
                  <a:lnTo>
                    <a:pt x="413" y="1567"/>
                  </a:lnTo>
                  <a:lnTo>
                    <a:pt x="402" y="1567"/>
                  </a:lnTo>
                  <a:lnTo>
                    <a:pt x="402" y="1525"/>
                  </a:lnTo>
                  <a:lnTo>
                    <a:pt x="413" y="1525"/>
                  </a:lnTo>
                  <a:close/>
                  <a:moveTo>
                    <a:pt x="413" y="1599"/>
                  </a:moveTo>
                  <a:lnTo>
                    <a:pt x="413" y="1641"/>
                  </a:lnTo>
                  <a:lnTo>
                    <a:pt x="402" y="1641"/>
                  </a:lnTo>
                  <a:lnTo>
                    <a:pt x="402" y="1599"/>
                  </a:lnTo>
                  <a:lnTo>
                    <a:pt x="413" y="1599"/>
                  </a:lnTo>
                  <a:close/>
                  <a:moveTo>
                    <a:pt x="413" y="1673"/>
                  </a:moveTo>
                  <a:lnTo>
                    <a:pt x="413" y="1693"/>
                  </a:lnTo>
                  <a:lnTo>
                    <a:pt x="379" y="1693"/>
                  </a:lnTo>
                  <a:lnTo>
                    <a:pt x="379" y="1682"/>
                  </a:lnTo>
                  <a:lnTo>
                    <a:pt x="407" y="1682"/>
                  </a:lnTo>
                  <a:lnTo>
                    <a:pt x="402" y="1687"/>
                  </a:lnTo>
                  <a:lnTo>
                    <a:pt x="402" y="1673"/>
                  </a:lnTo>
                  <a:lnTo>
                    <a:pt x="413" y="1673"/>
                  </a:lnTo>
                  <a:close/>
                  <a:moveTo>
                    <a:pt x="347" y="1693"/>
                  </a:moveTo>
                  <a:lnTo>
                    <a:pt x="316" y="1693"/>
                  </a:lnTo>
                  <a:lnTo>
                    <a:pt x="316" y="1682"/>
                  </a:lnTo>
                  <a:lnTo>
                    <a:pt x="347" y="1682"/>
                  </a:lnTo>
                  <a:lnTo>
                    <a:pt x="347" y="1693"/>
                  </a:lnTo>
                  <a:close/>
                  <a:moveTo>
                    <a:pt x="323" y="1709"/>
                  </a:moveTo>
                  <a:lnTo>
                    <a:pt x="281" y="1687"/>
                  </a:lnTo>
                  <a:lnTo>
                    <a:pt x="323" y="1666"/>
                  </a:lnTo>
                  <a:lnTo>
                    <a:pt x="323" y="1709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Freeform 192"/>
            <p:cNvSpPr/>
            <p:nvPr/>
          </p:nvSpPr>
          <p:spPr>
            <a:xfrm>
              <a:off x="6260400" y="4432320"/>
              <a:ext cx="250560" cy="1064880"/>
            </a:xfrm>
            <a:custGeom>
              <a:avLst/>
              <a:gdLst>
                <a:gd name="textAreaLeft" fmla="*/ 0 w 250560"/>
                <a:gd name="textAreaRight" fmla="*/ 250920 w 250560"/>
                <a:gd name="textAreaTop" fmla="*/ 0 h 1064880"/>
                <a:gd name="textAreaBottom" fmla="*/ 1065240 h 1064880"/>
              </a:gdLst>
              <a:ahLst/>
              <a:rect l="textAreaLeft" t="textAreaTop" r="textAreaRight" b="textAreaBottom"/>
              <a:pathLst>
                <a:path w="754" h="3213">
                  <a:moveTo>
                    <a:pt x="0" y="0"/>
                  </a:moveTo>
                  <a:cubicBezTo>
                    <a:pt x="208" y="0"/>
                    <a:pt x="377" y="120"/>
                    <a:pt x="377" y="268"/>
                  </a:cubicBezTo>
                  <a:lnTo>
                    <a:pt x="377" y="1339"/>
                  </a:lnTo>
                  <a:cubicBezTo>
                    <a:pt x="377" y="1487"/>
                    <a:pt x="546" y="1607"/>
                    <a:pt x="754" y="1607"/>
                  </a:cubicBezTo>
                  <a:cubicBezTo>
                    <a:pt x="546" y="1607"/>
                    <a:pt x="377" y="1726"/>
                    <a:pt x="377" y="1874"/>
                  </a:cubicBezTo>
                  <a:lnTo>
                    <a:pt x="377" y="2945"/>
                  </a:lnTo>
                  <a:cubicBezTo>
                    <a:pt x="377" y="3093"/>
                    <a:pt x="208" y="3213"/>
                    <a:pt x="0" y="3213"/>
                  </a:cubicBezTo>
                </a:path>
              </a:pathLst>
            </a:custGeom>
            <a:noFill/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11" name="Group 195"/>
            <p:cNvGrpSpPr/>
            <p:nvPr/>
          </p:nvGrpSpPr>
          <p:grpSpPr>
            <a:xfrm>
              <a:off x="4757040" y="5207760"/>
              <a:ext cx="937800" cy="272160"/>
              <a:chOff x="4757040" y="5207760"/>
              <a:chExt cx="937800" cy="272160"/>
            </a:xfrm>
          </p:grpSpPr>
          <p:sp>
            <p:nvSpPr>
              <p:cNvPr id="212" name="Rectangle 193"/>
              <p:cNvSpPr/>
              <p:nvPr/>
            </p:nvSpPr>
            <p:spPr>
              <a:xfrm>
                <a:off x="4757040" y="5207760"/>
                <a:ext cx="937800" cy="2721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Rectangle 194"/>
              <p:cNvSpPr/>
              <p:nvPr/>
            </p:nvSpPr>
            <p:spPr>
              <a:xfrm>
                <a:off x="4757040" y="5207760"/>
                <a:ext cx="937800" cy="272160"/>
              </a:xfrm>
              <a:prstGeom prst="rect">
                <a:avLst/>
              </a:prstGeom>
              <a:noFill/>
              <a:ln cap="rnd"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14" name="Rectangle 196"/>
            <p:cNvSpPr/>
            <p:nvPr/>
          </p:nvSpPr>
          <p:spPr>
            <a:xfrm>
              <a:off x="4916880" y="5262120"/>
              <a:ext cx="732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rginase 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15" name="Group 199"/>
            <p:cNvGrpSpPr/>
            <p:nvPr/>
          </p:nvGrpSpPr>
          <p:grpSpPr>
            <a:xfrm>
              <a:off x="5727960" y="1860840"/>
              <a:ext cx="1222920" cy="313200"/>
              <a:chOff x="5727960" y="1860840"/>
              <a:chExt cx="1222920" cy="313200"/>
            </a:xfrm>
          </p:grpSpPr>
          <p:sp>
            <p:nvSpPr>
              <p:cNvPr id="216" name="Freeform 197"/>
              <p:cNvSpPr/>
              <p:nvPr/>
            </p:nvSpPr>
            <p:spPr>
              <a:xfrm>
                <a:off x="5727960" y="1860840"/>
                <a:ext cx="1222920" cy="313200"/>
              </a:xfrm>
              <a:custGeom>
                <a:avLst/>
                <a:gdLst>
                  <a:gd name="textAreaLeft" fmla="*/ 0 w 1222920"/>
                  <a:gd name="textAreaRight" fmla="*/ 1222920 w 1222920"/>
                  <a:gd name="textAreaTop" fmla="*/ 0 h 313200"/>
                  <a:gd name="textAreaBottom" fmla="*/ 313560 h 313200"/>
                </a:gdLst>
                <a:ahLst/>
                <a:rect l="textAreaLeft" t="textAreaTop" r="textAreaRight" b="textAreaBottom"/>
                <a:pathLst>
                  <a:path w="781" h="200">
                    <a:moveTo>
                      <a:pt x="781" y="0"/>
                    </a:moveTo>
                    <a:lnTo>
                      <a:pt x="0" y="74"/>
                    </a:lnTo>
                    <a:lnTo>
                      <a:pt x="0" y="126"/>
                    </a:lnTo>
                    <a:lnTo>
                      <a:pt x="781" y="200"/>
                    </a:lnTo>
                    <a:lnTo>
                      <a:pt x="781" y="0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Freeform 198"/>
              <p:cNvSpPr/>
              <p:nvPr/>
            </p:nvSpPr>
            <p:spPr>
              <a:xfrm>
                <a:off x="5727960" y="1860840"/>
                <a:ext cx="1222920" cy="313200"/>
              </a:xfrm>
              <a:custGeom>
                <a:avLst/>
                <a:gdLst>
                  <a:gd name="textAreaLeft" fmla="*/ 0 w 1222920"/>
                  <a:gd name="textAreaRight" fmla="*/ 1222920 w 1222920"/>
                  <a:gd name="textAreaTop" fmla="*/ 0 h 313200"/>
                  <a:gd name="textAreaBottom" fmla="*/ 313560 h 313200"/>
                </a:gdLst>
                <a:ahLst/>
                <a:rect l="textAreaLeft" t="textAreaTop" r="textAreaRight" b="textAreaBottom"/>
                <a:pathLst>
                  <a:path w="781" h="200">
                    <a:moveTo>
                      <a:pt x="781" y="0"/>
                    </a:moveTo>
                    <a:lnTo>
                      <a:pt x="0" y="74"/>
                    </a:lnTo>
                    <a:lnTo>
                      <a:pt x="0" y="126"/>
                    </a:lnTo>
                    <a:lnTo>
                      <a:pt x="781" y="200"/>
                    </a:lnTo>
                    <a:lnTo>
                      <a:pt x="781" y="0"/>
                    </a:lnTo>
                    <a:close/>
                  </a:path>
                </a:pathLst>
              </a:custGeom>
              <a:noFill/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18" name="Line 177"/>
          <p:cNvSpPr/>
          <p:nvPr/>
        </p:nvSpPr>
        <p:spPr>
          <a:xfrm>
            <a:off x="3132000" y="3375000"/>
            <a:ext cx="317520" cy="1440"/>
          </a:xfrm>
          <a:prstGeom prst="line">
            <a:avLst/>
          </a:prstGeom>
          <a:ln cap="rnd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Rectangle 173"/>
          <p:cNvSpPr/>
          <p:nvPr/>
        </p:nvSpPr>
        <p:spPr>
          <a:xfrm>
            <a:off x="250920" y="6363360"/>
            <a:ext cx="8642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Mélanie Jubault, Christine Lariagon, Ludivine Taconnat, Jean-Pierre Renou, Antoine Gravot, Régine Delourme, Maria J. Manzanares-Dauleux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Gene expression profiling of partial resistance and susceptibility responses to clubroot in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Arabidopsis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Functional and integrative genomics.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6-27T12:36:21Z</dcterms:created>
  <dc:creator>agravot</dc:creator>
  <dc:description/>
  <dc:language>en-US</dc:language>
  <cp:lastModifiedBy>jubault</cp:lastModifiedBy>
  <dcterms:modified xsi:type="dcterms:W3CDTF">2012-07-18T08:54:34Z</dcterms:modified>
  <cp:revision>12</cp:revision>
  <dc:subject/>
  <dc:title>Diapositive 1</dc:title>
</cp:coreProperties>
</file>